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0"/>
  </p:notesMasterIdLst>
  <p:sldIdLst>
    <p:sldId id="260" r:id="rId5"/>
    <p:sldId id="261" r:id="rId6"/>
    <p:sldId id="256" r:id="rId7"/>
    <p:sldId id="257" r:id="rId8"/>
    <p:sldId id="258" r:id="rId9"/>
  </p:sldIdLst>
  <p:sldSz cx="14631988" cy="11888788"/>
  <p:notesSz cx="6858000" cy="9144000"/>
  <p:defaultTextStyle>
    <a:defPPr>
      <a:defRPr lang="zh-CN"/>
    </a:defPPr>
    <a:lvl1pPr marL="0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1pPr>
    <a:lvl2pPr marL="757718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2pPr>
    <a:lvl3pPr marL="1515435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3pPr>
    <a:lvl4pPr marL="2273153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4pPr>
    <a:lvl5pPr marL="3030870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5pPr>
    <a:lvl6pPr marL="3788588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6pPr>
    <a:lvl7pPr marL="4546305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7pPr>
    <a:lvl8pPr marL="5304023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8pPr>
    <a:lvl9pPr marL="6061740" algn="l" defTabSz="1515435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45">
          <p15:clr>
            <a:srgbClr val="A4A3A4"/>
          </p15:clr>
        </p15:guide>
        <p15:guide id="2" pos="46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271740-8EF4-439D-8E75-E7BA982123DF}" v="1" dt="2022-09-15T04:29:40.6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23" autoAdjust="0"/>
    <p:restoredTop sz="95781" autoAdjust="0"/>
  </p:normalViewPr>
  <p:slideViewPr>
    <p:cSldViewPr snapToGrid="0">
      <p:cViewPr varScale="1">
        <p:scale>
          <a:sx n="64" d="100"/>
          <a:sy n="64" d="100"/>
        </p:scale>
        <p:origin x="2082" y="90"/>
      </p:cViewPr>
      <p:guideLst>
        <p:guide orient="horz" pos="3745"/>
        <p:guide pos="460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橋本 直子" userId="e9a29ba3-6a2b-4b8a-96ab-a7284db46b1a" providerId="ADAL" clId="{5B271740-8EF4-439D-8E75-E7BA982123DF}"/>
    <pc:docChg chg="undo redo custSel addSld delSld modSld">
      <pc:chgData name="橋本 直子" userId="e9a29ba3-6a2b-4b8a-96ab-a7284db46b1a" providerId="ADAL" clId="{5B271740-8EF4-439D-8E75-E7BA982123DF}" dt="2022-09-15T06:34:34.274" v="1476" actId="20577"/>
      <pc:docMkLst>
        <pc:docMk/>
      </pc:docMkLst>
      <pc:sldChg chg="modSp mod">
        <pc:chgData name="橋本 直子" userId="e9a29ba3-6a2b-4b8a-96ab-a7284db46b1a" providerId="ADAL" clId="{5B271740-8EF4-439D-8E75-E7BA982123DF}" dt="2022-09-15T06:34:23.074" v="1474" actId="20577"/>
        <pc:sldMkLst>
          <pc:docMk/>
          <pc:sldMk cId="1133299143" sldId="256"/>
        </pc:sldMkLst>
        <pc:spChg chg="mod">
          <ac:chgData name="橋本 直子" userId="e9a29ba3-6a2b-4b8a-96ab-a7284db46b1a" providerId="ADAL" clId="{5B271740-8EF4-439D-8E75-E7BA982123DF}" dt="2022-09-15T06:34:23.074" v="1474" actId="20577"/>
          <ac:spMkLst>
            <pc:docMk/>
            <pc:sldMk cId="1133299143" sldId="256"/>
            <ac:spMk id="193" creationId="{597D6364-54CB-983C-168D-B906B9C74AAB}"/>
          </ac:spMkLst>
        </pc:spChg>
      </pc:sldChg>
      <pc:sldChg chg="modSp mod">
        <pc:chgData name="橋本 直子" userId="e9a29ba3-6a2b-4b8a-96ab-a7284db46b1a" providerId="ADAL" clId="{5B271740-8EF4-439D-8E75-E7BA982123DF}" dt="2022-09-15T06:34:34.274" v="1476" actId="20577"/>
        <pc:sldMkLst>
          <pc:docMk/>
          <pc:sldMk cId="2925470655" sldId="257"/>
        </pc:sldMkLst>
        <pc:spChg chg="mod">
          <ac:chgData name="橋本 直子" userId="e9a29ba3-6a2b-4b8a-96ab-a7284db46b1a" providerId="ADAL" clId="{5B271740-8EF4-439D-8E75-E7BA982123DF}" dt="2022-09-15T06:34:34.274" v="1476" actId="20577"/>
          <ac:spMkLst>
            <pc:docMk/>
            <pc:sldMk cId="2925470655" sldId="257"/>
            <ac:spMk id="139" creationId="{A577D607-7408-8882-D1B6-63D0CA4D0F21}"/>
          </ac:spMkLst>
        </pc:spChg>
      </pc:sldChg>
      <pc:sldChg chg="delSp del mod">
        <pc:chgData name="橋本 直子" userId="e9a29ba3-6a2b-4b8a-96ab-a7284db46b1a" providerId="ADAL" clId="{5B271740-8EF4-439D-8E75-E7BA982123DF}" dt="2022-09-15T05:07:57.680" v="1396" actId="47"/>
        <pc:sldMkLst>
          <pc:docMk/>
          <pc:sldMk cId="2067283993" sldId="259"/>
        </pc:sldMkLst>
        <pc:picChg chg="del">
          <ac:chgData name="橋本 直子" userId="e9a29ba3-6a2b-4b8a-96ab-a7284db46b1a" providerId="ADAL" clId="{5B271740-8EF4-439D-8E75-E7BA982123DF}" dt="2022-09-15T05:00:47.748" v="1184" actId="478"/>
          <ac:picMkLst>
            <pc:docMk/>
            <pc:sldMk cId="2067283993" sldId="259"/>
            <ac:picMk id="5" creationId="{4EB2B6AF-812F-6EDE-1425-BDD6CCBFCAE2}"/>
          </ac:picMkLst>
        </pc:picChg>
        <pc:picChg chg="del">
          <ac:chgData name="橋本 直子" userId="e9a29ba3-6a2b-4b8a-96ab-a7284db46b1a" providerId="ADAL" clId="{5B271740-8EF4-439D-8E75-E7BA982123DF}" dt="2022-09-15T05:00:49.571" v="1185" actId="478"/>
          <ac:picMkLst>
            <pc:docMk/>
            <pc:sldMk cId="2067283993" sldId="259"/>
            <ac:picMk id="67" creationId="{70828B4D-10F2-4908-5B6D-E193F6D64198}"/>
          </ac:picMkLst>
        </pc:picChg>
        <pc:picChg chg="del">
          <ac:chgData name="橋本 直子" userId="e9a29ba3-6a2b-4b8a-96ab-a7284db46b1a" providerId="ADAL" clId="{5B271740-8EF4-439D-8E75-E7BA982123DF}" dt="2022-09-15T05:00:51.067" v="1186" actId="478"/>
          <ac:picMkLst>
            <pc:docMk/>
            <pc:sldMk cId="2067283993" sldId="259"/>
            <ac:picMk id="68" creationId="{27987C49-2E09-3DEA-F235-6059FEF46CFF}"/>
          </ac:picMkLst>
        </pc:picChg>
      </pc:sldChg>
      <pc:sldChg chg="addSp delSp modSp add mod">
        <pc:chgData name="橋本 直子" userId="e9a29ba3-6a2b-4b8a-96ab-a7284db46b1a" providerId="ADAL" clId="{5B271740-8EF4-439D-8E75-E7BA982123DF}" dt="2022-09-15T05:09:47.777" v="1466" actId="1038"/>
        <pc:sldMkLst>
          <pc:docMk/>
          <pc:sldMk cId="3495233793" sldId="260"/>
        </pc:sldMkLst>
        <pc:spChg chg="mod">
          <ac:chgData name="橋本 直子" userId="e9a29ba3-6a2b-4b8a-96ab-a7284db46b1a" providerId="ADAL" clId="{5B271740-8EF4-439D-8E75-E7BA982123DF}" dt="2022-09-15T05:00:20.448" v="1183" actId="113"/>
          <ac:spMkLst>
            <pc:docMk/>
            <pc:sldMk cId="3495233793" sldId="260"/>
            <ac:spMk id="2" creationId="{7B0BE460-3387-C86F-BC8B-564BB9EB9132}"/>
          </ac:spMkLst>
        </pc:spChg>
        <pc:spChg chg="mod">
          <ac:chgData name="橋本 直子" userId="e9a29ba3-6a2b-4b8a-96ab-a7284db46b1a" providerId="ADAL" clId="{5B271740-8EF4-439D-8E75-E7BA982123DF}" dt="2022-09-15T05:09:43.550" v="1439" actId="1035"/>
          <ac:spMkLst>
            <pc:docMk/>
            <pc:sldMk cId="3495233793" sldId="260"/>
            <ac:spMk id="4" creationId="{BCD26290-54A5-4CFA-20CE-FB2E86F6E8B6}"/>
          </ac:spMkLst>
        </pc:spChg>
        <pc:spChg chg="mod topLvl">
          <ac:chgData name="橋本 直子" userId="e9a29ba3-6a2b-4b8a-96ab-a7284db46b1a" providerId="ADAL" clId="{5B271740-8EF4-439D-8E75-E7BA982123DF}" dt="2022-09-15T05:02:38.413" v="1203" actId="1036"/>
          <ac:spMkLst>
            <pc:docMk/>
            <pc:sldMk cId="3495233793" sldId="260"/>
            <ac:spMk id="7" creationId="{70446546-539E-E155-0650-7B7FA34256D0}"/>
          </ac:spMkLst>
        </pc:spChg>
        <pc:spChg chg="mod topLvl">
          <ac:chgData name="橋本 直子" userId="e9a29ba3-6a2b-4b8a-96ab-a7284db46b1a" providerId="ADAL" clId="{5B271740-8EF4-439D-8E75-E7BA982123DF}" dt="2022-09-15T05:02:38.413" v="1203" actId="1036"/>
          <ac:spMkLst>
            <pc:docMk/>
            <pc:sldMk cId="3495233793" sldId="260"/>
            <ac:spMk id="8" creationId="{B6E3FC1A-A235-0160-EDCF-D01EEE17BA4D}"/>
          </ac:spMkLst>
        </pc:spChg>
        <pc:spChg chg="mod topLvl">
          <ac:chgData name="橋本 直子" userId="e9a29ba3-6a2b-4b8a-96ab-a7284db46b1a" providerId="ADAL" clId="{5B271740-8EF4-439D-8E75-E7BA982123DF}" dt="2022-09-15T05:02:38.413" v="1203" actId="1036"/>
          <ac:spMkLst>
            <pc:docMk/>
            <pc:sldMk cId="3495233793" sldId="260"/>
            <ac:spMk id="9" creationId="{18149853-AAE6-C7A6-010B-275F945DC060}"/>
          </ac:spMkLst>
        </pc:spChg>
        <pc:spChg chg="mod topLvl">
          <ac:chgData name="橋本 直子" userId="e9a29ba3-6a2b-4b8a-96ab-a7284db46b1a" providerId="ADAL" clId="{5B271740-8EF4-439D-8E75-E7BA982123DF}" dt="2022-09-15T05:02:38.413" v="1203" actId="1036"/>
          <ac:spMkLst>
            <pc:docMk/>
            <pc:sldMk cId="3495233793" sldId="260"/>
            <ac:spMk id="10" creationId="{70B9C8A9-EB02-CE34-747E-1C390D8246D0}"/>
          </ac:spMkLst>
        </pc:spChg>
        <pc:spChg chg="mod topLvl">
          <ac:chgData name="橋本 直子" userId="e9a29ba3-6a2b-4b8a-96ab-a7284db46b1a" providerId="ADAL" clId="{5B271740-8EF4-439D-8E75-E7BA982123DF}" dt="2022-09-15T05:02:38.413" v="1203" actId="1036"/>
          <ac:spMkLst>
            <pc:docMk/>
            <pc:sldMk cId="3495233793" sldId="260"/>
            <ac:spMk id="11" creationId="{1B3B144F-5088-40C1-79B3-868C32113D67}"/>
          </ac:spMkLst>
        </pc:spChg>
        <pc:spChg chg="mod topLvl">
          <ac:chgData name="橋本 直子" userId="e9a29ba3-6a2b-4b8a-96ab-a7284db46b1a" providerId="ADAL" clId="{5B271740-8EF4-439D-8E75-E7BA982123DF}" dt="2022-09-15T05:02:38.413" v="1203" actId="1036"/>
          <ac:spMkLst>
            <pc:docMk/>
            <pc:sldMk cId="3495233793" sldId="260"/>
            <ac:spMk id="12" creationId="{63114C56-6E52-59FF-292C-D92661A6BB00}"/>
          </ac:spMkLst>
        </pc:spChg>
        <pc:spChg chg="mod topLvl">
          <ac:chgData name="橋本 直子" userId="e9a29ba3-6a2b-4b8a-96ab-a7284db46b1a" providerId="ADAL" clId="{5B271740-8EF4-439D-8E75-E7BA982123DF}" dt="2022-09-15T05:00:06.821" v="1180" actId="165"/>
          <ac:spMkLst>
            <pc:docMk/>
            <pc:sldMk cId="3495233793" sldId="260"/>
            <ac:spMk id="13" creationId="{195DE089-6421-D4C4-CFEB-9E1C8170E665}"/>
          </ac:spMkLst>
        </pc:spChg>
        <pc:spChg chg="mod topLvl">
          <ac:chgData name="橋本 直子" userId="e9a29ba3-6a2b-4b8a-96ab-a7284db46b1a" providerId="ADAL" clId="{5B271740-8EF4-439D-8E75-E7BA982123DF}" dt="2022-09-15T05:00:06.821" v="1180" actId="165"/>
          <ac:spMkLst>
            <pc:docMk/>
            <pc:sldMk cId="3495233793" sldId="260"/>
            <ac:spMk id="14" creationId="{C19EB168-02D7-0A14-60CA-800073D1A9C9}"/>
          </ac:spMkLst>
        </pc:spChg>
        <pc:spChg chg="mod topLvl">
          <ac:chgData name="橋本 直子" userId="e9a29ba3-6a2b-4b8a-96ab-a7284db46b1a" providerId="ADAL" clId="{5B271740-8EF4-439D-8E75-E7BA982123DF}" dt="2022-09-15T05:08:13.946" v="1397" actId="113"/>
          <ac:spMkLst>
            <pc:docMk/>
            <pc:sldMk cId="3495233793" sldId="260"/>
            <ac:spMk id="17" creationId="{EF175BEC-7BC9-2DC9-6FD2-40A369A02565}"/>
          </ac:spMkLst>
        </pc:spChg>
        <pc:spChg chg="mod topLvl">
          <ac:chgData name="橋本 直子" userId="e9a29ba3-6a2b-4b8a-96ab-a7284db46b1a" providerId="ADAL" clId="{5B271740-8EF4-439D-8E75-E7BA982123DF}" dt="2022-09-15T05:08:13.946" v="1397" actId="113"/>
          <ac:spMkLst>
            <pc:docMk/>
            <pc:sldMk cId="3495233793" sldId="260"/>
            <ac:spMk id="18" creationId="{CE417A98-5A53-C834-4045-CA39FF105DAD}"/>
          </ac:spMkLst>
        </pc:spChg>
        <pc:spChg chg="mod topLvl">
          <ac:chgData name="橋本 直子" userId="e9a29ba3-6a2b-4b8a-96ab-a7284db46b1a" providerId="ADAL" clId="{5B271740-8EF4-439D-8E75-E7BA982123DF}" dt="2022-09-15T05:08:13.946" v="1397" actId="113"/>
          <ac:spMkLst>
            <pc:docMk/>
            <pc:sldMk cId="3495233793" sldId="260"/>
            <ac:spMk id="19" creationId="{F146F42A-A645-D6FE-0B7E-F5CFB46926CB}"/>
          </ac:spMkLst>
        </pc:spChg>
        <pc:spChg chg="mod topLvl">
          <ac:chgData name="橋本 直子" userId="e9a29ba3-6a2b-4b8a-96ab-a7284db46b1a" providerId="ADAL" clId="{5B271740-8EF4-439D-8E75-E7BA982123DF}" dt="2022-09-15T05:08:13.946" v="1397" actId="113"/>
          <ac:spMkLst>
            <pc:docMk/>
            <pc:sldMk cId="3495233793" sldId="260"/>
            <ac:spMk id="20" creationId="{46A3D8F3-B0FE-8BFA-C40E-9B0C9B4E4A7D}"/>
          </ac:spMkLst>
        </pc:spChg>
        <pc:spChg chg="mod topLvl">
          <ac:chgData name="橋本 直子" userId="e9a29ba3-6a2b-4b8a-96ab-a7284db46b1a" providerId="ADAL" clId="{5B271740-8EF4-439D-8E75-E7BA982123DF}" dt="2022-09-15T05:08:13.946" v="1397" actId="113"/>
          <ac:spMkLst>
            <pc:docMk/>
            <pc:sldMk cId="3495233793" sldId="260"/>
            <ac:spMk id="21" creationId="{3F01FC84-F0B0-ABF2-1304-F908C660F3D3}"/>
          </ac:spMkLst>
        </pc:spChg>
        <pc:spChg chg="mod topLvl">
          <ac:chgData name="橋本 直子" userId="e9a29ba3-6a2b-4b8a-96ab-a7284db46b1a" providerId="ADAL" clId="{5B271740-8EF4-439D-8E75-E7BA982123DF}" dt="2022-09-15T05:08:13.946" v="1397" actId="113"/>
          <ac:spMkLst>
            <pc:docMk/>
            <pc:sldMk cId="3495233793" sldId="260"/>
            <ac:spMk id="22" creationId="{1A6680E3-6BB4-6B0A-DD6B-76DA18C9374F}"/>
          </ac:spMkLst>
        </pc:spChg>
        <pc:spChg chg="mod ord topLvl">
          <ac:chgData name="橋本 直子" userId="e9a29ba3-6a2b-4b8a-96ab-a7284db46b1a" providerId="ADAL" clId="{5B271740-8EF4-439D-8E75-E7BA982123DF}" dt="2022-09-15T04:59:53.011" v="1178" actId="1038"/>
          <ac:spMkLst>
            <pc:docMk/>
            <pc:sldMk cId="3495233793" sldId="260"/>
            <ac:spMk id="23" creationId="{E6554225-A0E9-CBB2-6DF7-7027E3D80132}"/>
          </ac:spMkLst>
        </pc:spChg>
        <pc:spChg chg="mod ord topLvl">
          <ac:chgData name="橋本 直子" userId="e9a29ba3-6a2b-4b8a-96ab-a7284db46b1a" providerId="ADAL" clId="{5B271740-8EF4-439D-8E75-E7BA982123DF}" dt="2022-09-15T04:59:53.011" v="1178" actId="1038"/>
          <ac:spMkLst>
            <pc:docMk/>
            <pc:sldMk cId="3495233793" sldId="260"/>
            <ac:spMk id="24" creationId="{8AB531D1-45B0-AEAF-5C20-F793FC09A2ED}"/>
          </ac:spMkLst>
        </pc:spChg>
        <pc:spChg chg="mod">
          <ac:chgData name="橋本 直子" userId="e9a29ba3-6a2b-4b8a-96ab-a7284db46b1a" providerId="ADAL" clId="{5B271740-8EF4-439D-8E75-E7BA982123DF}" dt="2022-09-15T05:08:19.246" v="1398" actId="113"/>
          <ac:spMkLst>
            <pc:docMk/>
            <pc:sldMk cId="3495233793" sldId="260"/>
            <ac:spMk id="27" creationId="{99F2ADD2-5268-526A-2278-7D85B04C7C40}"/>
          </ac:spMkLst>
        </pc:spChg>
        <pc:spChg chg="mod">
          <ac:chgData name="橋本 直子" userId="e9a29ba3-6a2b-4b8a-96ab-a7284db46b1a" providerId="ADAL" clId="{5B271740-8EF4-439D-8E75-E7BA982123DF}" dt="2022-09-15T05:08:19.246" v="1398" actId="113"/>
          <ac:spMkLst>
            <pc:docMk/>
            <pc:sldMk cId="3495233793" sldId="260"/>
            <ac:spMk id="28" creationId="{240956DD-EDBD-5AEE-AB9C-B530FFECB013}"/>
          </ac:spMkLst>
        </pc:spChg>
        <pc:spChg chg="mod">
          <ac:chgData name="橋本 直子" userId="e9a29ba3-6a2b-4b8a-96ab-a7284db46b1a" providerId="ADAL" clId="{5B271740-8EF4-439D-8E75-E7BA982123DF}" dt="2022-09-15T05:08:19.246" v="1398" actId="113"/>
          <ac:spMkLst>
            <pc:docMk/>
            <pc:sldMk cId="3495233793" sldId="260"/>
            <ac:spMk id="29" creationId="{9E88B782-28B7-A681-D0E0-1E6DA2EE9B3F}"/>
          </ac:spMkLst>
        </pc:spChg>
        <pc:spChg chg="mod">
          <ac:chgData name="橋本 直子" userId="e9a29ba3-6a2b-4b8a-96ab-a7284db46b1a" providerId="ADAL" clId="{5B271740-8EF4-439D-8E75-E7BA982123DF}" dt="2022-09-15T05:08:19.246" v="1398" actId="113"/>
          <ac:spMkLst>
            <pc:docMk/>
            <pc:sldMk cId="3495233793" sldId="260"/>
            <ac:spMk id="30" creationId="{5FB6C2FA-0880-892D-1F11-871614543CE0}"/>
          </ac:spMkLst>
        </pc:spChg>
        <pc:spChg chg="mod">
          <ac:chgData name="橋本 直子" userId="e9a29ba3-6a2b-4b8a-96ab-a7284db46b1a" providerId="ADAL" clId="{5B271740-8EF4-439D-8E75-E7BA982123DF}" dt="2022-09-15T05:08:19.246" v="1398" actId="113"/>
          <ac:spMkLst>
            <pc:docMk/>
            <pc:sldMk cId="3495233793" sldId="260"/>
            <ac:spMk id="31" creationId="{41DBE450-BA95-3098-4628-0479C300E5B6}"/>
          </ac:spMkLst>
        </pc:spChg>
        <pc:spChg chg="mod">
          <ac:chgData name="橋本 直子" userId="e9a29ba3-6a2b-4b8a-96ab-a7284db46b1a" providerId="ADAL" clId="{5B271740-8EF4-439D-8E75-E7BA982123DF}" dt="2022-09-15T05:08:19.246" v="1398" actId="113"/>
          <ac:spMkLst>
            <pc:docMk/>
            <pc:sldMk cId="3495233793" sldId="260"/>
            <ac:spMk id="32" creationId="{615CE363-2102-A482-05C3-18EE0B44A8CE}"/>
          </ac:spMkLst>
        </pc:spChg>
        <pc:spChg chg="mod ord">
          <ac:chgData name="橋本 直子" userId="e9a29ba3-6a2b-4b8a-96ab-a7284db46b1a" providerId="ADAL" clId="{5B271740-8EF4-439D-8E75-E7BA982123DF}" dt="2022-09-15T04:59:53.011" v="1178" actId="1038"/>
          <ac:spMkLst>
            <pc:docMk/>
            <pc:sldMk cId="3495233793" sldId="260"/>
            <ac:spMk id="33" creationId="{35DCFD60-FE57-8ACE-4A2E-3FB282B39A44}"/>
          </ac:spMkLst>
        </pc:spChg>
        <pc:spChg chg="mod ord">
          <ac:chgData name="橋本 直子" userId="e9a29ba3-6a2b-4b8a-96ab-a7284db46b1a" providerId="ADAL" clId="{5B271740-8EF4-439D-8E75-E7BA982123DF}" dt="2022-09-15T04:59:53.011" v="1178" actId="1038"/>
          <ac:spMkLst>
            <pc:docMk/>
            <pc:sldMk cId="3495233793" sldId="260"/>
            <ac:spMk id="34" creationId="{CA7AAF26-3D77-74B0-2361-54DFA0EA3F42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35" creationId="{41218426-28B8-AB32-3284-72F4467DB560}"/>
          </ac:spMkLst>
        </pc:spChg>
        <pc:spChg chg="mod topLvl">
          <ac:chgData name="橋本 直子" userId="e9a29ba3-6a2b-4b8a-96ab-a7284db46b1a" providerId="ADAL" clId="{5B271740-8EF4-439D-8E75-E7BA982123DF}" dt="2022-09-15T04:31:15.790" v="12" actId="1076"/>
          <ac:spMkLst>
            <pc:docMk/>
            <pc:sldMk cId="3495233793" sldId="260"/>
            <ac:spMk id="38" creationId="{15619EDB-9825-56A0-5504-7E9FDA13FFB5}"/>
          </ac:spMkLst>
        </pc:spChg>
        <pc:spChg chg="mod topLvl">
          <ac:chgData name="橋本 直子" userId="e9a29ba3-6a2b-4b8a-96ab-a7284db46b1a" providerId="ADAL" clId="{5B271740-8EF4-439D-8E75-E7BA982123DF}" dt="2022-09-15T04:31:15.790" v="12" actId="1076"/>
          <ac:spMkLst>
            <pc:docMk/>
            <pc:sldMk cId="3495233793" sldId="260"/>
            <ac:spMk id="39" creationId="{D34BC908-C8AF-0B29-E6A0-5581FE308879}"/>
          </ac:spMkLst>
        </pc:spChg>
        <pc:spChg chg="mod topLvl">
          <ac:chgData name="橋本 直子" userId="e9a29ba3-6a2b-4b8a-96ab-a7284db46b1a" providerId="ADAL" clId="{5B271740-8EF4-439D-8E75-E7BA982123DF}" dt="2022-09-15T04:31:15.790" v="12" actId="1076"/>
          <ac:spMkLst>
            <pc:docMk/>
            <pc:sldMk cId="3495233793" sldId="260"/>
            <ac:spMk id="40" creationId="{5B0DBF33-CE00-FAD4-D5B9-A9195EE53827}"/>
          </ac:spMkLst>
        </pc:spChg>
        <pc:spChg chg="mod topLvl">
          <ac:chgData name="橋本 直子" userId="e9a29ba3-6a2b-4b8a-96ab-a7284db46b1a" providerId="ADAL" clId="{5B271740-8EF4-439D-8E75-E7BA982123DF}" dt="2022-09-15T04:31:15.790" v="12" actId="1076"/>
          <ac:spMkLst>
            <pc:docMk/>
            <pc:sldMk cId="3495233793" sldId="260"/>
            <ac:spMk id="41" creationId="{04CB4505-9C45-1065-8F14-EB9FFD739908}"/>
          </ac:spMkLst>
        </pc:spChg>
        <pc:spChg chg="mod topLvl">
          <ac:chgData name="橋本 直子" userId="e9a29ba3-6a2b-4b8a-96ab-a7284db46b1a" providerId="ADAL" clId="{5B271740-8EF4-439D-8E75-E7BA982123DF}" dt="2022-09-15T04:31:15.790" v="12" actId="1076"/>
          <ac:spMkLst>
            <pc:docMk/>
            <pc:sldMk cId="3495233793" sldId="260"/>
            <ac:spMk id="42" creationId="{0986FED0-5620-4B80-805D-9F7B03DD3F76}"/>
          </ac:spMkLst>
        </pc:spChg>
        <pc:spChg chg="mod topLvl">
          <ac:chgData name="橋本 直子" userId="e9a29ba3-6a2b-4b8a-96ab-a7284db46b1a" providerId="ADAL" clId="{5B271740-8EF4-439D-8E75-E7BA982123DF}" dt="2022-09-15T04:31:15.790" v="12" actId="1076"/>
          <ac:spMkLst>
            <pc:docMk/>
            <pc:sldMk cId="3495233793" sldId="260"/>
            <ac:spMk id="43" creationId="{ACBA84F5-27E6-CE38-06C8-1D18E14D165E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44" creationId="{54685CED-1430-B307-3396-54B27F6EB814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45" creationId="{CA4FF340-C8E1-A608-2354-19EAA183A4A2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48" creationId="{04022E3A-DB58-550D-FA78-861EF3BF1841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49" creationId="{4D7018A0-4251-E17B-0DC8-CFEAFF8ECF40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50" creationId="{480E8AB0-4425-9E17-F210-452A127B7071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51" creationId="{C59D6FCE-EB77-19C5-A8F5-BDD9D776C930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52" creationId="{6683F95C-EBF5-9AAF-F2F9-64278B1460C2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53" creationId="{34CBAA49-4FA2-3719-81A7-B848FF92F180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54" creationId="{13AE9F8F-BD1A-79DC-0752-3C6B250A191B}"/>
          </ac:spMkLst>
        </pc:spChg>
        <pc:spChg chg="mod ord topLvl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55" creationId="{D6C0A557-E168-094E-FA9D-B4B7E8378084}"/>
          </ac:spMkLst>
        </pc:spChg>
        <pc:spChg chg="mod topLvl">
          <ac:chgData name="橋本 直子" userId="e9a29ba3-6a2b-4b8a-96ab-a7284db46b1a" providerId="ADAL" clId="{5B271740-8EF4-439D-8E75-E7BA982123DF}" dt="2022-09-15T05:00:20.448" v="1183" actId="113"/>
          <ac:spMkLst>
            <pc:docMk/>
            <pc:sldMk cId="3495233793" sldId="260"/>
            <ac:spMk id="56" creationId="{EFB63411-1CEC-6AD5-9DF9-EA41C8FF4463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58" creationId="{5C652839-923F-4BEA-913D-F24311CC83D5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59" creationId="{F4E193F8-7C0C-24EB-D3B2-F76BAAB21763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60" creationId="{5DB1495D-131F-5668-4F5A-5D8364B80371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61" creationId="{900F987D-B28E-3030-C85F-9686A4F01D24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62" creationId="{23671CBA-0D9A-78D3-2C04-90FF11ADFB8C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63" creationId="{51AAE67B-2CD8-0AEF-7B1B-9BE21026128B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64" creationId="{1C978CFB-1B93-2364-2311-9C5F62F614CB}"/>
          </ac:spMkLst>
        </pc:spChg>
        <pc:spChg chg="del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65" creationId="{8CE238B9-828F-E661-C389-FB6E1D139CD1}"/>
          </ac:spMkLst>
        </pc:spChg>
        <pc:spChg chg="mod">
          <ac:chgData name="橋本 直子" userId="e9a29ba3-6a2b-4b8a-96ab-a7284db46b1a" providerId="ADAL" clId="{5B271740-8EF4-439D-8E75-E7BA982123DF}" dt="2022-09-15T04:59:15.618" v="1037" actId="20577"/>
          <ac:spMkLst>
            <pc:docMk/>
            <pc:sldMk cId="3495233793" sldId="260"/>
            <ac:spMk id="66" creationId="{0C0C2D7F-8E9F-C491-BC9F-45DCA13FDB36}"/>
          </ac:spMkLst>
        </pc:spChg>
        <pc:spChg chg="mod">
          <ac:chgData name="橋本 直子" userId="e9a29ba3-6a2b-4b8a-96ab-a7284db46b1a" providerId="ADAL" clId="{5B271740-8EF4-439D-8E75-E7BA982123DF}" dt="2022-09-15T05:00:20.448" v="1183" actId="113"/>
          <ac:spMkLst>
            <pc:docMk/>
            <pc:sldMk cId="3495233793" sldId="260"/>
            <ac:spMk id="69" creationId="{2BEB1C87-CBB6-83CF-56BB-F08370315839}"/>
          </ac:spMkLst>
        </pc:spChg>
        <pc:spChg chg="mod ord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70" creationId="{48A7EBAE-3983-ABFE-8EA3-160BC507158B}"/>
          </ac:spMkLst>
        </pc:spChg>
        <pc:spChg chg="del mod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71" creationId="{E708C961-D56C-B981-118B-97AECCEA235D}"/>
          </ac:spMkLst>
        </pc:spChg>
        <pc:spChg chg="mod ord">
          <ac:chgData name="橋本 直子" userId="e9a29ba3-6a2b-4b8a-96ab-a7284db46b1a" providerId="ADAL" clId="{5B271740-8EF4-439D-8E75-E7BA982123DF}" dt="2022-09-15T04:37:35.647" v="191" actId="164"/>
          <ac:spMkLst>
            <pc:docMk/>
            <pc:sldMk cId="3495233793" sldId="260"/>
            <ac:spMk id="72" creationId="{21544424-222B-9AED-DE5A-47EA10049ACF}"/>
          </ac:spMkLst>
        </pc:spChg>
        <pc:spChg chg="add del mod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75" creationId="{D6C06D86-E131-AED5-C839-EBA1BF5F5F82}"/>
          </ac:spMkLst>
        </pc:spChg>
        <pc:spChg chg="add del mod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76" creationId="{22CBFD3C-44B5-4707-3946-3E2F99B170CF}"/>
          </ac:spMkLst>
        </pc:spChg>
        <pc:spChg chg="add del mod">
          <ac:chgData name="橋本 直子" userId="e9a29ba3-6a2b-4b8a-96ab-a7284db46b1a" providerId="ADAL" clId="{5B271740-8EF4-439D-8E75-E7BA982123DF}" dt="2022-09-15T04:59:07.562" v="1028" actId="478"/>
          <ac:spMkLst>
            <pc:docMk/>
            <pc:sldMk cId="3495233793" sldId="260"/>
            <ac:spMk id="77" creationId="{93AF8464-6E0B-E899-65AC-35F7DBAAC090}"/>
          </ac:spMkLst>
        </pc:spChg>
        <pc:spChg chg="add mod">
          <ac:chgData name="橋本 直子" userId="e9a29ba3-6a2b-4b8a-96ab-a7284db46b1a" providerId="ADAL" clId="{5B271740-8EF4-439D-8E75-E7BA982123DF}" dt="2022-09-15T04:43:36.417" v="338" actId="1076"/>
          <ac:spMkLst>
            <pc:docMk/>
            <pc:sldMk cId="3495233793" sldId="260"/>
            <ac:spMk id="78" creationId="{F8F01074-326E-BF95-F772-4D4179B9ACDB}"/>
          </ac:spMkLst>
        </pc:spChg>
        <pc:spChg chg="add mod">
          <ac:chgData name="橋本 直子" userId="e9a29ba3-6a2b-4b8a-96ab-a7284db46b1a" providerId="ADAL" clId="{5B271740-8EF4-439D-8E75-E7BA982123DF}" dt="2022-09-15T05:03:23.422" v="1301" actId="1035"/>
          <ac:spMkLst>
            <pc:docMk/>
            <pc:sldMk cId="3495233793" sldId="260"/>
            <ac:spMk id="81" creationId="{FFF8E776-9E24-AD2A-C223-9FF4A6AA79A9}"/>
          </ac:spMkLst>
        </pc:spChg>
        <pc:spChg chg="add mod">
          <ac:chgData name="橋本 直子" userId="e9a29ba3-6a2b-4b8a-96ab-a7284db46b1a" providerId="ADAL" clId="{5B271740-8EF4-439D-8E75-E7BA982123DF}" dt="2022-09-15T05:03:23.422" v="1301" actId="1035"/>
          <ac:spMkLst>
            <pc:docMk/>
            <pc:sldMk cId="3495233793" sldId="260"/>
            <ac:spMk id="83" creationId="{9781B763-230F-9FA2-0882-8A295A5108AA}"/>
          </ac:spMkLst>
        </pc:spChg>
        <pc:spChg chg="add mod">
          <ac:chgData name="橋本 直子" userId="e9a29ba3-6a2b-4b8a-96ab-a7284db46b1a" providerId="ADAL" clId="{5B271740-8EF4-439D-8E75-E7BA982123DF}" dt="2022-09-15T05:03:54.931" v="1328" actId="1035"/>
          <ac:spMkLst>
            <pc:docMk/>
            <pc:sldMk cId="3495233793" sldId="260"/>
            <ac:spMk id="85" creationId="{0D5A818A-A155-4287-A13C-F6A05A8EFA6B}"/>
          </ac:spMkLst>
        </pc:spChg>
        <pc:spChg chg="add mod">
          <ac:chgData name="橋本 直子" userId="e9a29ba3-6a2b-4b8a-96ab-a7284db46b1a" providerId="ADAL" clId="{5B271740-8EF4-439D-8E75-E7BA982123DF}" dt="2022-09-15T05:03:54.931" v="1328" actId="1035"/>
          <ac:spMkLst>
            <pc:docMk/>
            <pc:sldMk cId="3495233793" sldId="260"/>
            <ac:spMk id="87" creationId="{6689D369-69DE-583F-0969-193DD2C537E7}"/>
          </ac:spMkLst>
        </pc:spChg>
        <pc:spChg chg="add mod">
          <ac:chgData name="橋本 直子" userId="e9a29ba3-6a2b-4b8a-96ab-a7284db46b1a" providerId="ADAL" clId="{5B271740-8EF4-439D-8E75-E7BA982123DF}" dt="2022-09-15T05:03:46.913" v="1324" actId="1035"/>
          <ac:spMkLst>
            <pc:docMk/>
            <pc:sldMk cId="3495233793" sldId="260"/>
            <ac:spMk id="89" creationId="{6FE01228-2798-2799-507E-7BEC42C1C1BC}"/>
          </ac:spMkLst>
        </pc:spChg>
        <pc:spChg chg="add mod">
          <ac:chgData name="橋本 直子" userId="e9a29ba3-6a2b-4b8a-96ab-a7284db46b1a" providerId="ADAL" clId="{5B271740-8EF4-439D-8E75-E7BA982123DF}" dt="2022-09-15T05:03:46.913" v="1324" actId="1035"/>
          <ac:spMkLst>
            <pc:docMk/>
            <pc:sldMk cId="3495233793" sldId="260"/>
            <ac:spMk id="91" creationId="{8C094669-212C-B046-F80E-A9F2DB6DE3E4}"/>
          </ac:spMkLst>
        </pc:spChg>
        <pc:spChg chg="add mod">
          <ac:chgData name="橋本 直子" userId="e9a29ba3-6a2b-4b8a-96ab-a7284db46b1a" providerId="ADAL" clId="{5B271740-8EF4-439D-8E75-E7BA982123DF}" dt="2022-09-15T05:04:19.020" v="1395" actId="1038"/>
          <ac:spMkLst>
            <pc:docMk/>
            <pc:sldMk cId="3495233793" sldId="260"/>
            <ac:spMk id="93" creationId="{6204A17E-F6F9-E2AD-BAEB-D7D640CA53B1}"/>
          </ac:spMkLst>
        </pc:spChg>
        <pc:spChg chg="add mod">
          <ac:chgData name="橋本 直子" userId="e9a29ba3-6a2b-4b8a-96ab-a7284db46b1a" providerId="ADAL" clId="{5B271740-8EF4-439D-8E75-E7BA982123DF}" dt="2022-09-15T05:04:19.020" v="1395" actId="1038"/>
          <ac:spMkLst>
            <pc:docMk/>
            <pc:sldMk cId="3495233793" sldId="260"/>
            <ac:spMk id="95" creationId="{A0331B83-8B78-B92B-AF1B-7CA4FCBC3417}"/>
          </ac:spMkLst>
        </pc:spChg>
        <pc:grpChg chg="del">
          <ac:chgData name="橋本 直子" userId="e9a29ba3-6a2b-4b8a-96ab-a7284db46b1a" providerId="ADAL" clId="{5B271740-8EF4-439D-8E75-E7BA982123DF}" dt="2022-09-15T04:45:33.705" v="388" actId="165"/>
          <ac:grpSpMkLst>
            <pc:docMk/>
            <pc:sldMk cId="3495233793" sldId="260"/>
            <ac:grpSpMk id="15" creationId="{CA59327C-00DB-77EF-BBF3-35A561E95855}"/>
          </ac:grpSpMkLst>
        </pc:grpChg>
        <pc:grpChg chg="del mod">
          <ac:chgData name="橋本 直子" userId="e9a29ba3-6a2b-4b8a-96ab-a7284db46b1a" providerId="ADAL" clId="{5B271740-8EF4-439D-8E75-E7BA982123DF}" dt="2022-09-15T04:29:40.684" v="2" actId="165"/>
          <ac:grpSpMkLst>
            <pc:docMk/>
            <pc:sldMk cId="3495233793" sldId="260"/>
            <ac:grpSpMk id="36" creationId="{3E04ECC3-272C-CEBB-88C1-2B0E9DAC582C}"/>
          </ac:grpSpMkLst>
        </pc:grpChg>
        <pc:grpChg chg="del">
          <ac:chgData name="橋本 直子" userId="e9a29ba3-6a2b-4b8a-96ab-a7284db46b1a" providerId="ADAL" clId="{5B271740-8EF4-439D-8E75-E7BA982123DF}" dt="2022-09-15T04:32:50.293" v="66" actId="165"/>
          <ac:grpSpMkLst>
            <pc:docMk/>
            <pc:sldMk cId="3495233793" sldId="260"/>
            <ac:grpSpMk id="46" creationId="{5D3B80E7-0A0E-38F8-8605-D81517637059}"/>
          </ac:grpSpMkLst>
        </pc:grpChg>
        <pc:grpChg chg="add del mod">
          <ac:chgData name="橋本 直子" userId="e9a29ba3-6a2b-4b8a-96ab-a7284db46b1a" providerId="ADAL" clId="{5B271740-8EF4-439D-8E75-E7BA982123DF}" dt="2022-09-15T04:59:07.562" v="1028" actId="478"/>
          <ac:grpSpMkLst>
            <pc:docMk/>
            <pc:sldMk cId="3495233793" sldId="260"/>
            <ac:grpSpMk id="74" creationId="{AE256CEB-22D8-6C18-929C-1482F186424A}"/>
          </ac:grpSpMkLst>
        </pc:grpChg>
        <pc:grpChg chg="add del mod">
          <ac:chgData name="橋本 直子" userId="e9a29ba3-6a2b-4b8a-96ab-a7284db46b1a" providerId="ADAL" clId="{5B271740-8EF4-439D-8E75-E7BA982123DF}" dt="2022-09-15T05:00:06.821" v="1180" actId="165"/>
          <ac:grpSpMkLst>
            <pc:docMk/>
            <pc:sldMk cId="3495233793" sldId="260"/>
            <ac:grpSpMk id="79" creationId="{127DE242-FC64-36EB-DC46-EC8A205CC06A}"/>
          </ac:grpSpMkLst>
        </pc:grpChg>
        <pc:picChg chg="mod">
          <ac:chgData name="橋本 直子" userId="e9a29ba3-6a2b-4b8a-96ab-a7284db46b1a" providerId="ADAL" clId="{5B271740-8EF4-439D-8E75-E7BA982123DF}" dt="2022-09-15T05:09:47.777" v="1466" actId="1038"/>
          <ac:picMkLst>
            <pc:docMk/>
            <pc:sldMk cId="3495233793" sldId="260"/>
            <ac:picMk id="3" creationId="{3FD3DBE6-AF82-0EDD-EEDD-BF0359CA43AF}"/>
          </ac:picMkLst>
        </pc:picChg>
        <pc:picChg chg="mod">
          <ac:chgData name="橋本 直子" userId="e9a29ba3-6a2b-4b8a-96ab-a7284db46b1a" providerId="ADAL" clId="{5B271740-8EF4-439D-8E75-E7BA982123DF}" dt="2022-09-15T04:37:35.647" v="191" actId="164"/>
          <ac:picMkLst>
            <pc:docMk/>
            <pc:sldMk cId="3495233793" sldId="260"/>
            <ac:picMk id="5" creationId="{4EB2B6AF-812F-6EDE-1425-BDD6CCBFCAE2}"/>
          </ac:picMkLst>
        </pc:picChg>
        <pc:picChg chg="mod topLvl">
          <ac:chgData name="橋本 直子" userId="e9a29ba3-6a2b-4b8a-96ab-a7284db46b1a" providerId="ADAL" clId="{5B271740-8EF4-439D-8E75-E7BA982123DF}" dt="2022-09-15T05:00:06.821" v="1180" actId="165"/>
          <ac:picMkLst>
            <pc:docMk/>
            <pc:sldMk cId="3495233793" sldId="260"/>
            <ac:picMk id="6" creationId="{FD0D260D-C82F-BFE2-E9F2-8ED3E3CEE72A}"/>
          </ac:picMkLst>
        </pc:picChg>
        <pc:picChg chg="mod topLvl">
          <ac:chgData name="橋本 直子" userId="e9a29ba3-6a2b-4b8a-96ab-a7284db46b1a" providerId="ADAL" clId="{5B271740-8EF4-439D-8E75-E7BA982123DF}" dt="2022-09-15T04:45:37.991" v="389" actId="1076"/>
          <ac:picMkLst>
            <pc:docMk/>
            <pc:sldMk cId="3495233793" sldId="260"/>
            <ac:picMk id="16" creationId="{375DEF91-2421-FFA4-9925-E53235708B4E}"/>
          </ac:picMkLst>
        </pc:picChg>
        <pc:picChg chg="del">
          <ac:chgData name="橋本 直子" userId="e9a29ba3-6a2b-4b8a-96ab-a7284db46b1a" providerId="ADAL" clId="{5B271740-8EF4-439D-8E75-E7BA982123DF}" dt="2022-09-15T04:59:07.562" v="1028" actId="478"/>
          <ac:picMkLst>
            <pc:docMk/>
            <pc:sldMk cId="3495233793" sldId="260"/>
            <ac:picMk id="25" creationId="{5D3D8D50-9735-13EE-5FE9-02575F8021F8}"/>
          </ac:picMkLst>
        </pc:picChg>
        <pc:picChg chg="mod">
          <ac:chgData name="橋本 直子" userId="e9a29ba3-6a2b-4b8a-96ab-a7284db46b1a" providerId="ADAL" clId="{5B271740-8EF4-439D-8E75-E7BA982123DF}" dt="2022-09-15T04:45:47.757" v="390" actId="1076"/>
          <ac:picMkLst>
            <pc:docMk/>
            <pc:sldMk cId="3495233793" sldId="260"/>
            <ac:picMk id="26" creationId="{7B8CDD3A-A2E1-2862-35DE-A3C5B24911C0}"/>
          </ac:picMkLst>
        </pc:picChg>
        <pc:picChg chg="del mod topLvl">
          <ac:chgData name="橋本 直子" userId="e9a29ba3-6a2b-4b8a-96ab-a7284db46b1a" providerId="ADAL" clId="{5B271740-8EF4-439D-8E75-E7BA982123DF}" dt="2022-09-15T04:30:30.702" v="3" actId="478"/>
          <ac:picMkLst>
            <pc:docMk/>
            <pc:sldMk cId="3495233793" sldId="260"/>
            <ac:picMk id="37" creationId="{6CE6414A-F737-844D-CE64-DB2CA89DA19A}"/>
          </ac:picMkLst>
        </pc:picChg>
        <pc:picChg chg="del mod topLvl">
          <ac:chgData name="橋本 直子" userId="e9a29ba3-6a2b-4b8a-96ab-a7284db46b1a" providerId="ADAL" clId="{5B271740-8EF4-439D-8E75-E7BA982123DF}" dt="2022-09-15T04:32:57.717" v="68" actId="478"/>
          <ac:picMkLst>
            <pc:docMk/>
            <pc:sldMk cId="3495233793" sldId="260"/>
            <ac:picMk id="47" creationId="{12515754-5304-01A3-C4B3-BC7B47AA0514}"/>
          </ac:picMkLst>
        </pc:picChg>
        <pc:picChg chg="del">
          <ac:chgData name="橋本 直子" userId="e9a29ba3-6a2b-4b8a-96ab-a7284db46b1a" providerId="ADAL" clId="{5B271740-8EF4-439D-8E75-E7BA982123DF}" dt="2022-09-15T04:59:07.562" v="1028" actId="478"/>
          <ac:picMkLst>
            <pc:docMk/>
            <pc:sldMk cId="3495233793" sldId="260"/>
            <ac:picMk id="57" creationId="{F8A95754-3BB7-D5EE-C396-F1AC86D7177A}"/>
          </ac:picMkLst>
        </pc:picChg>
        <pc:picChg chg="mod">
          <ac:chgData name="橋本 直子" userId="e9a29ba3-6a2b-4b8a-96ab-a7284db46b1a" providerId="ADAL" clId="{5B271740-8EF4-439D-8E75-E7BA982123DF}" dt="2022-09-15T05:02:50.826" v="1229" actId="1038"/>
          <ac:picMkLst>
            <pc:docMk/>
            <pc:sldMk cId="3495233793" sldId="260"/>
            <ac:picMk id="67" creationId="{70828B4D-10F2-4908-5B6D-E193F6D64198}"/>
          </ac:picMkLst>
        </pc:picChg>
        <pc:picChg chg="mod">
          <ac:chgData name="橋本 直子" userId="e9a29ba3-6a2b-4b8a-96ab-a7284db46b1a" providerId="ADAL" clId="{5B271740-8EF4-439D-8E75-E7BA982123DF}" dt="2022-09-15T04:59:53.011" v="1178" actId="1038"/>
          <ac:picMkLst>
            <pc:docMk/>
            <pc:sldMk cId="3495233793" sldId="260"/>
            <ac:picMk id="68" creationId="{27987C49-2E09-3DEA-F235-6059FEF46CFF}"/>
          </ac:picMkLst>
        </pc:picChg>
      </pc:sldChg>
      <pc:sldChg chg="addSp delSp modSp add mod">
        <pc:chgData name="橋本 直子" userId="e9a29ba3-6a2b-4b8a-96ab-a7284db46b1a" providerId="ADAL" clId="{5B271740-8EF4-439D-8E75-E7BA982123DF}" dt="2022-09-15T05:09:35.730" v="1426" actId="1035"/>
        <pc:sldMkLst>
          <pc:docMk/>
          <pc:sldMk cId="3351706987" sldId="261"/>
        </pc:sldMkLst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" creationId="{7B0BE460-3387-C86F-BC8B-564BB9EB9132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4" creationId="{BCD26290-54A5-4CFA-20CE-FB2E86F6E8B6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17" creationId="{EF175BEC-7BC9-2DC9-6FD2-40A369A02565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18" creationId="{CE417A98-5A53-C834-4045-CA39FF105DAD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19" creationId="{F146F42A-A645-D6FE-0B7E-F5CFB46926CB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0" creationId="{46A3D8F3-B0FE-8BFA-C40E-9B0C9B4E4A7D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1" creationId="{3F01FC84-F0B0-ABF2-1304-F908C660F3D3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2" creationId="{1A6680E3-6BB4-6B0A-DD6B-76DA18C9374F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3" creationId="{E6554225-A0E9-CBB2-6DF7-7027E3D80132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4" creationId="{8AB531D1-45B0-AEAF-5C20-F793FC09A2ED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7" creationId="{99F2ADD2-5268-526A-2278-7D85B04C7C40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8" creationId="{240956DD-EDBD-5AEE-AB9C-B530FFECB013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29" creationId="{9E88B782-28B7-A681-D0E0-1E6DA2EE9B3F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30" creationId="{5FB6C2FA-0880-892D-1F11-871614543CE0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31" creationId="{41DBE450-BA95-3098-4628-0479C300E5B6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32" creationId="{615CE363-2102-A482-05C3-18EE0B44A8CE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33" creationId="{35DCFD60-FE57-8ACE-4A2E-3FB282B39A44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34" creationId="{CA7AAF26-3D77-74B0-2361-54DFA0EA3F42}"/>
          </ac:spMkLst>
        </pc:spChg>
        <pc:spChg chg="mod">
          <ac:chgData name="橋本 直子" userId="e9a29ba3-6a2b-4b8a-96ab-a7284db46b1a" providerId="ADAL" clId="{5B271740-8EF4-439D-8E75-E7BA982123DF}" dt="2022-09-15T05:09:35.730" v="1426" actId="1035"/>
          <ac:spMkLst>
            <pc:docMk/>
            <pc:sldMk cId="3351706987" sldId="261"/>
            <ac:spMk id="35" creationId="{41218426-28B8-AB32-3284-72F4467DB560}"/>
          </ac:spMkLst>
        </pc:spChg>
        <pc:spChg chg="add mod">
          <ac:chgData name="橋本 直子" userId="e9a29ba3-6a2b-4b8a-96ab-a7284db46b1a" providerId="ADAL" clId="{5B271740-8EF4-439D-8E75-E7BA982123DF}" dt="2022-09-15T05:08:32.838" v="1400" actId="1076"/>
          <ac:spMkLst>
            <pc:docMk/>
            <pc:sldMk cId="3351706987" sldId="261"/>
            <ac:spMk id="36" creationId="{B92FAC1F-DB58-7879-B0A8-DAEFAB9C6BF6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44" creationId="{54685CED-1430-B307-3396-54B27F6EB814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45" creationId="{CA4FF340-C8E1-A608-2354-19EAA183A4A2}"/>
          </ac:spMkLst>
        </pc:spChg>
        <pc:spChg chg="add mod">
          <ac:chgData name="橋本 直子" userId="e9a29ba3-6a2b-4b8a-96ab-a7284db46b1a" providerId="ADAL" clId="{5B271740-8EF4-439D-8E75-E7BA982123DF}" dt="2022-09-15T04:58:17.692" v="983" actId="1035"/>
          <ac:spMkLst>
            <pc:docMk/>
            <pc:sldMk cId="3351706987" sldId="261"/>
            <ac:spMk id="46" creationId="{925E28F6-2671-F30F-58B3-30D40C23C6DF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48" creationId="{04022E3A-DB58-550D-FA78-861EF3BF1841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49" creationId="{4D7018A0-4251-E17B-0DC8-CFEAFF8ECF40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50" creationId="{480E8AB0-4425-9E17-F210-452A127B7071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51" creationId="{C59D6FCE-EB77-19C5-A8F5-BDD9D776C930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52" creationId="{6683F95C-EBF5-9AAF-F2F9-64278B1460C2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53" creationId="{34CBAA49-4FA2-3719-81A7-B848FF92F180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54" creationId="{13AE9F8F-BD1A-79DC-0752-3C6B250A191B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55" creationId="{D6C0A557-E168-094E-FA9D-B4B7E8378084}"/>
          </ac:spMkLst>
        </pc:spChg>
        <pc:spChg chg="mod">
          <ac:chgData name="橋本 直子" userId="e9a29ba3-6a2b-4b8a-96ab-a7284db46b1a" providerId="ADAL" clId="{5B271740-8EF4-439D-8E75-E7BA982123DF}" dt="2022-09-15T05:09:29.883" v="1408" actId="164"/>
          <ac:spMkLst>
            <pc:docMk/>
            <pc:sldMk cId="3351706987" sldId="261"/>
            <ac:spMk id="58" creationId="{5C652839-923F-4BEA-913D-F24311CC83D5}"/>
          </ac:spMkLst>
        </pc:spChg>
        <pc:spChg chg="mod">
          <ac:chgData name="橋本 直子" userId="e9a29ba3-6a2b-4b8a-96ab-a7284db46b1a" providerId="ADAL" clId="{5B271740-8EF4-439D-8E75-E7BA982123DF}" dt="2022-09-15T05:09:29.883" v="1408" actId="164"/>
          <ac:spMkLst>
            <pc:docMk/>
            <pc:sldMk cId="3351706987" sldId="261"/>
            <ac:spMk id="59" creationId="{F4E193F8-7C0C-24EB-D3B2-F76BAAB21763}"/>
          </ac:spMkLst>
        </pc:spChg>
        <pc:spChg chg="mod">
          <ac:chgData name="橋本 直子" userId="e9a29ba3-6a2b-4b8a-96ab-a7284db46b1a" providerId="ADAL" clId="{5B271740-8EF4-439D-8E75-E7BA982123DF}" dt="2022-09-15T05:09:18.903" v="1407" actId="113"/>
          <ac:spMkLst>
            <pc:docMk/>
            <pc:sldMk cId="3351706987" sldId="261"/>
            <ac:spMk id="60" creationId="{5DB1495D-131F-5668-4F5A-5D8364B80371}"/>
          </ac:spMkLst>
        </pc:spChg>
        <pc:spChg chg="mod">
          <ac:chgData name="橋本 直子" userId="e9a29ba3-6a2b-4b8a-96ab-a7284db46b1a" providerId="ADAL" clId="{5B271740-8EF4-439D-8E75-E7BA982123DF}" dt="2022-09-15T05:09:18.903" v="1407" actId="113"/>
          <ac:spMkLst>
            <pc:docMk/>
            <pc:sldMk cId="3351706987" sldId="261"/>
            <ac:spMk id="61" creationId="{900F987D-B28E-3030-C85F-9686A4F01D24}"/>
          </ac:spMkLst>
        </pc:spChg>
        <pc:spChg chg="mod">
          <ac:chgData name="橋本 直子" userId="e9a29ba3-6a2b-4b8a-96ab-a7284db46b1a" providerId="ADAL" clId="{5B271740-8EF4-439D-8E75-E7BA982123DF}" dt="2022-09-15T05:09:29.883" v="1408" actId="164"/>
          <ac:spMkLst>
            <pc:docMk/>
            <pc:sldMk cId="3351706987" sldId="261"/>
            <ac:spMk id="62" creationId="{23671CBA-0D9A-78D3-2C04-90FF11ADFB8C}"/>
          </ac:spMkLst>
        </pc:spChg>
        <pc:spChg chg="mod">
          <ac:chgData name="橋本 直子" userId="e9a29ba3-6a2b-4b8a-96ab-a7284db46b1a" providerId="ADAL" clId="{5B271740-8EF4-439D-8E75-E7BA982123DF}" dt="2022-09-15T05:09:29.883" v="1408" actId="164"/>
          <ac:spMkLst>
            <pc:docMk/>
            <pc:sldMk cId="3351706987" sldId="261"/>
            <ac:spMk id="63" creationId="{51AAE67B-2CD8-0AEF-7B1B-9BE21026128B}"/>
          </ac:spMkLst>
        </pc:spChg>
        <pc:spChg chg="mod">
          <ac:chgData name="橋本 直子" userId="e9a29ba3-6a2b-4b8a-96ab-a7284db46b1a" providerId="ADAL" clId="{5B271740-8EF4-439D-8E75-E7BA982123DF}" dt="2022-09-15T05:09:29.883" v="1408" actId="164"/>
          <ac:spMkLst>
            <pc:docMk/>
            <pc:sldMk cId="3351706987" sldId="261"/>
            <ac:spMk id="64" creationId="{1C978CFB-1B93-2364-2311-9C5F62F614CB}"/>
          </ac:spMkLst>
        </pc:spChg>
        <pc:spChg chg="mod">
          <ac:chgData name="橋本 直子" userId="e9a29ba3-6a2b-4b8a-96ab-a7284db46b1a" providerId="ADAL" clId="{5B271740-8EF4-439D-8E75-E7BA982123DF}" dt="2022-09-15T05:09:29.883" v="1408" actId="164"/>
          <ac:spMkLst>
            <pc:docMk/>
            <pc:sldMk cId="3351706987" sldId="261"/>
            <ac:spMk id="65" creationId="{8CE238B9-828F-E661-C389-FB6E1D139CD1}"/>
          </ac:spMkLst>
        </pc:spChg>
        <pc:spChg chg="mod">
          <ac:chgData name="橋本 直子" userId="e9a29ba3-6a2b-4b8a-96ab-a7284db46b1a" providerId="ADAL" clId="{5B271740-8EF4-439D-8E75-E7BA982123DF}" dt="2022-09-15T04:57:33.730" v="929" actId="20577"/>
          <ac:spMkLst>
            <pc:docMk/>
            <pc:sldMk cId="3351706987" sldId="261"/>
            <ac:spMk id="66" creationId="{0C0C2D7F-8E9F-C491-BC9F-45DCA13FDB36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69" creationId="{2BEB1C87-CBB6-83CF-56BB-F08370315839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70" creationId="{48A7EBAE-3983-ABFE-8EA3-160BC507158B}"/>
          </ac:spMkLst>
        </pc:spChg>
        <pc:spChg chg="mod">
          <ac:chgData name="橋本 直子" userId="e9a29ba3-6a2b-4b8a-96ab-a7284db46b1a" providerId="ADAL" clId="{5B271740-8EF4-439D-8E75-E7BA982123DF}" dt="2022-09-15T04:58:17.692" v="983" actId="1035"/>
          <ac:spMkLst>
            <pc:docMk/>
            <pc:sldMk cId="3351706987" sldId="261"/>
            <ac:spMk id="71" creationId="{E708C961-D56C-B981-118B-97AECCEA235D}"/>
          </ac:spMkLst>
        </pc:spChg>
        <pc:spChg chg="mod topLvl">
          <ac:chgData name="橋本 直子" userId="e9a29ba3-6a2b-4b8a-96ab-a7284db46b1a" providerId="ADAL" clId="{5B271740-8EF4-439D-8E75-E7BA982123DF}" dt="2022-09-15T05:09:12.063" v="1406" actId="164"/>
          <ac:spMkLst>
            <pc:docMk/>
            <pc:sldMk cId="3351706987" sldId="261"/>
            <ac:spMk id="72" creationId="{21544424-222B-9AED-DE5A-47EA10049ACF}"/>
          </ac:spMkLst>
        </pc:spChg>
        <pc:spChg chg="mod">
          <ac:chgData name="橋本 直子" userId="e9a29ba3-6a2b-4b8a-96ab-a7284db46b1a" providerId="ADAL" clId="{5B271740-8EF4-439D-8E75-E7BA982123DF}" dt="2022-09-15T04:57:09.092" v="863" actId="1035"/>
          <ac:spMkLst>
            <pc:docMk/>
            <pc:sldMk cId="3351706987" sldId="261"/>
            <ac:spMk id="75" creationId="{D6C06D86-E131-AED5-C839-EBA1BF5F5F82}"/>
          </ac:spMkLst>
        </pc:spChg>
        <pc:spChg chg="mod">
          <ac:chgData name="橋本 直子" userId="e9a29ba3-6a2b-4b8a-96ab-a7284db46b1a" providerId="ADAL" clId="{5B271740-8EF4-439D-8E75-E7BA982123DF}" dt="2022-09-15T04:57:09.092" v="863" actId="1035"/>
          <ac:spMkLst>
            <pc:docMk/>
            <pc:sldMk cId="3351706987" sldId="261"/>
            <ac:spMk id="76" creationId="{22CBFD3C-44B5-4707-3946-3E2F99B170CF}"/>
          </ac:spMkLst>
        </pc:spChg>
        <pc:spChg chg="mod">
          <ac:chgData name="橋本 直子" userId="e9a29ba3-6a2b-4b8a-96ab-a7284db46b1a" providerId="ADAL" clId="{5B271740-8EF4-439D-8E75-E7BA982123DF}" dt="2022-09-15T04:57:09.092" v="863" actId="1035"/>
          <ac:spMkLst>
            <pc:docMk/>
            <pc:sldMk cId="3351706987" sldId="261"/>
            <ac:spMk id="77" creationId="{93AF8464-6E0B-E899-65AC-35F7DBAAC090}"/>
          </ac:spMkLst>
        </pc:spChg>
        <pc:spChg chg="mod">
          <ac:chgData name="橋本 直子" userId="e9a29ba3-6a2b-4b8a-96ab-a7284db46b1a" providerId="ADAL" clId="{5B271740-8EF4-439D-8E75-E7BA982123DF}" dt="2022-09-15T04:57:19.884" v="914" actId="1035"/>
          <ac:spMkLst>
            <pc:docMk/>
            <pc:sldMk cId="3351706987" sldId="261"/>
            <ac:spMk id="78" creationId="{F8F01074-326E-BF95-F772-4D4179B9ACDB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81" creationId="{FFF8E776-9E24-AD2A-C223-9FF4A6AA79A9}"/>
          </ac:spMkLst>
        </pc:spChg>
        <pc:spChg chg="del">
          <ac:chgData name="橋本 直子" userId="e9a29ba3-6a2b-4b8a-96ab-a7284db46b1a" providerId="ADAL" clId="{5B271740-8EF4-439D-8E75-E7BA982123DF}" dt="2022-09-15T04:56:52.609" v="814" actId="478"/>
          <ac:spMkLst>
            <pc:docMk/>
            <pc:sldMk cId="3351706987" sldId="261"/>
            <ac:spMk id="83" creationId="{9781B763-230F-9FA2-0882-8A295A5108AA}"/>
          </ac:spMkLst>
        </pc:spChg>
        <pc:grpChg chg="add mod">
          <ac:chgData name="橋本 直子" userId="e9a29ba3-6a2b-4b8a-96ab-a7284db46b1a" providerId="ADAL" clId="{5B271740-8EF4-439D-8E75-E7BA982123DF}" dt="2022-09-15T05:09:12.063" v="1406" actId="164"/>
          <ac:grpSpMkLst>
            <pc:docMk/>
            <pc:sldMk cId="3351706987" sldId="261"/>
            <ac:grpSpMk id="47" creationId="{D947B38D-A302-E7EF-C370-28B6A28779A2}"/>
          </ac:grpSpMkLst>
        </pc:grpChg>
        <pc:grpChg chg="del mod">
          <ac:chgData name="橋本 直子" userId="e9a29ba3-6a2b-4b8a-96ab-a7284db46b1a" providerId="ADAL" clId="{5B271740-8EF4-439D-8E75-E7BA982123DF}" dt="2022-09-15T05:08:48.380" v="1403" actId="165"/>
          <ac:grpSpMkLst>
            <pc:docMk/>
            <pc:sldMk cId="3351706987" sldId="261"/>
            <ac:grpSpMk id="74" creationId="{AE256CEB-22D8-6C18-929C-1482F186424A}"/>
          </ac:grpSpMkLst>
        </pc:grpChg>
        <pc:grpChg chg="del">
          <ac:chgData name="橋本 直子" userId="e9a29ba3-6a2b-4b8a-96ab-a7284db46b1a" providerId="ADAL" clId="{5B271740-8EF4-439D-8E75-E7BA982123DF}" dt="2022-09-15T04:56:58.042" v="817" actId="478"/>
          <ac:grpSpMkLst>
            <pc:docMk/>
            <pc:sldMk cId="3351706987" sldId="261"/>
            <ac:grpSpMk id="79" creationId="{127DE242-FC64-36EB-DC46-EC8A205CC06A}"/>
          </ac:grpSpMkLst>
        </pc:grpChg>
        <pc:grpChg chg="add mod">
          <ac:chgData name="橋本 直子" userId="e9a29ba3-6a2b-4b8a-96ab-a7284db46b1a" providerId="ADAL" clId="{5B271740-8EF4-439D-8E75-E7BA982123DF}" dt="2022-09-15T05:09:29.883" v="1408" actId="164"/>
          <ac:grpSpMkLst>
            <pc:docMk/>
            <pc:sldMk cId="3351706987" sldId="261"/>
            <ac:grpSpMk id="80" creationId="{B4C2D40B-49C4-9862-1813-1C91FF1AC0FD}"/>
          </ac:grpSpMkLst>
        </pc:grpChg>
        <pc:picChg chg="del">
          <ac:chgData name="橋本 直子" userId="e9a29ba3-6a2b-4b8a-96ab-a7284db46b1a" providerId="ADAL" clId="{5B271740-8EF4-439D-8E75-E7BA982123DF}" dt="2022-09-15T04:56:52.609" v="814" actId="478"/>
          <ac:picMkLst>
            <pc:docMk/>
            <pc:sldMk cId="3351706987" sldId="261"/>
            <ac:picMk id="3" creationId="{3FD3DBE6-AF82-0EDD-EEDD-BF0359CA43AF}"/>
          </ac:picMkLst>
        </pc:picChg>
        <pc:picChg chg="mod topLvl">
          <ac:chgData name="橋本 直子" userId="e9a29ba3-6a2b-4b8a-96ab-a7284db46b1a" providerId="ADAL" clId="{5B271740-8EF4-439D-8E75-E7BA982123DF}" dt="2022-09-15T05:09:12.063" v="1406" actId="164"/>
          <ac:picMkLst>
            <pc:docMk/>
            <pc:sldMk cId="3351706987" sldId="261"/>
            <ac:picMk id="5" creationId="{4EB2B6AF-812F-6EDE-1425-BDD6CCBFCAE2}"/>
          </ac:picMkLst>
        </pc:picChg>
        <pc:picChg chg="mod">
          <ac:chgData name="橋本 直子" userId="e9a29ba3-6a2b-4b8a-96ab-a7284db46b1a" providerId="ADAL" clId="{5B271740-8EF4-439D-8E75-E7BA982123DF}" dt="2022-09-15T04:57:09.092" v="863" actId="1035"/>
          <ac:picMkLst>
            <pc:docMk/>
            <pc:sldMk cId="3351706987" sldId="261"/>
            <ac:picMk id="25" creationId="{5D3D8D50-9735-13EE-5FE9-02575F8021F8}"/>
          </ac:picMkLst>
        </pc:picChg>
        <pc:picChg chg="mod">
          <ac:chgData name="橋本 直子" userId="e9a29ba3-6a2b-4b8a-96ab-a7284db46b1a" providerId="ADAL" clId="{5B271740-8EF4-439D-8E75-E7BA982123DF}" dt="2022-09-15T05:09:29.883" v="1408" actId="164"/>
          <ac:picMkLst>
            <pc:docMk/>
            <pc:sldMk cId="3351706987" sldId="261"/>
            <ac:picMk id="57" creationId="{F8A95754-3BB7-D5EE-C396-F1AC86D7177A}"/>
          </ac:picMkLst>
        </pc:picChg>
        <pc:picChg chg="del">
          <ac:chgData name="橋本 直子" userId="e9a29ba3-6a2b-4b8a-96ab-a7284db46b1a" providerId="ADAL" clId="{5B271740-8EF4-439D-8E75-E7BA982123DF}" dt="2022-09-15T04:56:55.596" v="815" actId="478"/>
          <ac:picMkLst>
            <pc:docMk/>
            <pc:sldMk cId="3351706987" sldId="261"/>
            <ac:picMk id="67" creationId="{70828B4D-10F2-4908-5B6D-E193F6D64198}"/>
          </ac:picMkLst>
        </pc:picChg>
        <pc:picChg chg="del">
          <ac:chgData name="橋本 直子" userId="e9a29ba3-6a2b-4b8a-96ab-a7284db46b1a" providerId="ADAL" clId="{5B271740-8EF4-439D-8E75-E7BA982123DF}" dt="2022-09-15T04:56:56.235" v="816" actId="478"/>
          <ac:picMkLst>
            <pc:docMk/>
            <pc:sldMk cId="3351706987" sldId="261"/>
            <ac:picMk id="68" creationId="{27987C49-2E09-3DEA-F235-6059FEF46CF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CD4040-C2B8-4B42-BC77-389D3F5ABD8E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19213" y="685800"/>
            <a:ext cx="42195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6599DF-F20D-4383-B1EB-F18759C2895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071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757718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515435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2273153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3030870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3788588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4546305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5304023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6061740" algn="l" defTabSz="151543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6599DF-F20D-4383-B1EB-F18759C2895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9878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097399" y="3693231"/>
            <a:ext cx="12437190" cy="254838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194798" y="6736980"/>
            <a:ext cx="10242392" cy="303824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577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15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2731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0308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7885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5463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3040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0617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0608191" y="476104"/>
            <a:ext cx="3292197" cy="1014399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731600" y="476104"/>
            <a:ext cx="9632725" cy="1014399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155826" y="7639648"/>
            <a:ext cx="12437190" cy="2361245"/>
          </a:xfrm>
        </p:spPr>
        <p:txBody>
          <a:bodyPr anchor="t"/>
          <a:lstStyle>
            <a:lvl1pPr algn="l">
              <a:defRPr sz="66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55826" y="5038976"/>
            <a:ext cx="12437190" cy="2600672"/>
          </a:xfrm>
        </p:spPr>
        <p:txBody>
          <a:bodyPr anchor="b"/>
          <a:lstStyle>
            <a:lvl1pPr marL="0" indent="0">
              <a:buNone/>
              <a:defRPr sz="3300">
                <a:solidFill>
                  <a:schemeClr val="tx1">
                    <a:tint val="75000"/>
                  </a:schemeClr>
                </a:solidFill>
              </a:defRPr>
            </a:lvl1pPr>
            <a:lvl2pPr marL="757718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51543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273153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4pPr>
            <a:lvl5pPr marL="303087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5pPr>
            <a:lvl6pPr marL="3788588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6pPr>
            <a:lvl7pPr marL="454630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7pPr>
            <a:lvl8pPr marL="5304023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8pPr>
            <a:lvl9pPr marL="606174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731600" y="2774051"/>
            <a:ext cx="6462461" cy="7846051"/>
          </a:xfrm>
        </p:spPr>
        <p:txBody>
          <a:bodyPr/>
          <a:lstStyle>
            <a:lvl1pPr>
              <a:defRPr sz="4600"/>
            </a:lvl1pPr>
            <a:lvl2pPr>
              <a:defRPr sz="4000"/>
            </a:lvl2pPr>
            <a:lvl3pPr>
              <a:defRPr sz="33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437927" y="2774051"/>
            <a:ext cx="6462461" cy="7846051"/>
          </a:xfrm>
        </p:spPr>
        <p:txBody>
          <a:bodyPr/>
          <a:lstStyle>
            <a:lvl1pPr>
              <a:defRPr sz="4600"/>
            </a:lvl1pPr>
            <a:lvl2pPr>
              <a:defRPr sz="4000"/>
            </a:lvl2pPr>
            <a:lvl3pPr>
              <a:defRPr sz="33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31600" y="2661218"/>
            <a:ext cx="6465002" cy="1109069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57718" indent="0">
              <a:buNone/>
              <a:defRPr sz="3300" b="1"/>
            </a:lvl2pPr>
            <a:lvl3pPr marL="1515435" indent="0">
              <a:buNone/>
              <a:defRPr sz="3000" b="1"/>
            </a:lvl3pPr>
            <a:lvl4pPr marL="2273153" indent="0">
              <a:buNone/>
              <a:defRPr sz="2700" b="1"/>
            </a:lvl4pPr>
            <a:lvl5pPr marL="3030870" indent="0">
              <a:buNone/>
              <a:defRPr sz="2700" b="1"/>
            </a:lvl5pPr>
            <a:lvl6pPr marL="3788588" indent="0">
              <a:buNone/>
              <a:defRPr sz="2700" b="1"/>
            </a:lvl6pPr>
            <a:lvl7pPr marL="4546305" indent="0">
              <a:buNone/>
              <a:defRPr sz="2700" b="1"/>
            </a:lvl7pPr>
            <a:lvl8pPr marL="5304023" indent="0">
              <a:buNone/>
              <a:defRPr sz="2700" b="1"/>
            </a:lvl8pPr>
            <a:lvl9pPr marL="6061740" indent="0">
              <a:buNone/>
              <a:defRPr sz="2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31600" y="3770287"/>
            <a:ext cx="6465002" cy="6849814"/>
          </a:xfrm>
        </p:spPr>
        <p:txBody>
          <a:bodyPr/>
          <a:lstStyle>
            <a:lvl1pPr>
              <a:defRPr sz="4000"/>
            </a:lvl1pPr>
            <a:lvl2pPr>
              <a:defRPr sz="33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7432847" y="2661218"/>
            <a:ext cx="6467542" cy="1109069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57718" indent="0">
              <a:buNone/>
              <a:defRPr sz="3300" b="1"/>
            </a:lvl2pPr>
            <a:lvl3pPr marL="1515435" indent="0">
              <a:buNone/>
              <a:defRPr sz="3000" b="1"/>
            </a:lvl3pPr>
            <a:lvl4pPr marL="2273153" indent="0">
              <a:buNone/>
              <a:defRPr sz="2700" b="1"/>
            </a:lvl4pPr>
            <a:lvl5pPr marL="3030870" indent="0">
              <a:buNone/>
              <a:defRPr sz="2700" b="1"/>
            </a:lvl5pPr>
            <a:lvl6pPr marL="3788588" indent="0">
              <a:buNone/>
              <a:defRPr sz="2700" b="1"/>
            </a:lvl6pPr>
            <a:lvl7pPr marL="4546305" indent="0">
              <a:buNone/>
              <a:defRPr sz="2700" b="1"/>
            </a:lvl7pPr>
            <a:lvl8pPr marL="5304023" indent="0">
              <a:buNone/>
              <a:defRPr sz="2700" b="1"/>
            </a:lvl8pPr>
            <a:lvl9pPr marL="6061740" indent="0">
              <a:buNone/>
              <a:defRPr sz="2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7432847" y="3770287"/>
            <a:ext cx="6467542" cy="6849814"/>
          </a:xfrm>
        </p:spPr>
        <p:txBody>
          <a:bodyPr/>
          <a:lstStyle>
            <a:lvl1pPr>
              <a:defRPr sz="4000"/>
            </a:lvl1pPr>
            <a:lvl2pPr>
              <a:defRPr sz="33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31600" y="473350"/>
            <a:ext cx="4813823" cy="2014489"/>
          </a:xfrm>
        </p:spPr>
        <p:txBody>
          <a:bodyPr anchor="b"/>
          <a:lstStyle>
            <a:lvl1pPr algn="l">
              <a:defRPr sz="33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720701" y="473351"/>
            <a:ext cx="8179688" cy="10146751"/>
          </a:xfrm>
        </p:spPr>
        <p:txBody>
          <a:bodyPr/>
          <a:lstStyle>
            <a:lvl1pPr>
              <a:defRPr sz="5300"/>
            </a:lvl1pPr>
            <a:lvl2pPr>
              <a:defRPr sz="4600"/>
            </a:lvl2pPr>
            <a:lvl3pPr>
              <a:defRPr sz="4000"/>
            </a:lvl3pPr>
            <a:lvl4pPr>
              <a:defRPr sz="3300"/>
            </a:lvl4pPr>
            <a:lvl5pPr>
              <a:defRPr sz="3300"/>
            </a:lvl5pPr>
            <a:lvl6pPr>
              <a:defRPr sz="3300"/>
            </a:lvl6pPr>
            <a:lvl7pPr>
              <a:defRPr sz="3300"/>
            </a:lvl7pPr>
            <a:lvl8pPr>
              <a:defRPr sz="3300"/>
            </a:lvl8pPr>
            <a:lvl9pPr>
              <a:defRPr sz="33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731600" y="2487840"/>
            <a:ext cx="4813823" cy="8132262"/>
          </a:xfrm>
        </p:spPr>
        <p:txBody>
          <a:bodyPr/>
          <a:lstStyle>
            <a:lvl1pPr marL="0" indent="0">
              <a:buNone/>
              <a:defRPr sz="2300"/>
            </a:lvl1pPr>
            <a:lvl2pPr marL="757718" indent="0">
              <a:buNone/>
              <a:defRPr sz="2000"/>
            </a:lvl2pPr>
            <a:lvl3pPr marL="1515435" indent="0">
              <a:buNone/>
              <a:defRPr sz="1700"/>
            </a:lvl3pPr>
            <a:lvl4pPr marL="2273153" indent="0">
              <a:buNone/>
              <a:defRPr sz="1500"/>
            </a:lvl4pPr>
            <a:lvl5pPr marL="3030870" indent="0">
              <a:buNone/>
              <a:defRPr sz="1500"/>
            </a:lvl5pPr>
            <a:lvl6pPr marL="3788588" indent="0">
              <a:buNone/>
              <a:defRPr sz="1500"/>
            </a:lvl6pPr>
            <a:lvl7pPr marL="4546305" indent="0">
              <a:buNone/>
              <a:defRPr sz="1500"/>
            </a:lvl7pPr>
            <a:lvl8pPr marL="5304023" indent="0">
              <a:buNone/>
              <a:defRPr sz="1500"/>
            </a:lvl8pPr>
            <a:lvl9pPr marL="6061740" indent="0">
              <a:buNone/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867972" y="8322152"/>
            <a:ext cx="8779193" cy="982477"/>
          </a:xfrm>
        </p:spPr>
        <p:txBody>
          <a:bodyPr anchor="b"/>
          <a:lstStyle>
            <a:lvl1pPr algn="l">
              <a:defRPr sz="33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867972" y="1062285"/>
            <a:ext cx="8779193" cy="7133273"/>
          </a:xfrm>
        </p:spPr>
        <p:txBody>
          <a:bodyPr/>
          <a:lstStyle>
            <a:lvl1pPr marL="0" indent="0">
              <a:buNone/>
              <a:defRPr sz="5300"/>
            </a:lvl1pPr>
            <a:lvl2pPr marL="757718" indent="0">
              <a:buNone/>
              <a:defRPr sz="4600"/>
            </a:lvl2pPr>
            <a:lvl3pPr marL="1515435" indent="0">
              <a:buNone/>
              <a:defRPr sz="4000"/>
            </a:lvl3pPr>
            <a:lvl4pPr marL="2273153" indent="0">
              <a:buNone/>
              <a:defRPr sz="3300"/>
            </a:lvl4pPr>
            <a:lvl5pPr marL="3030870" indent="0">
              <a:buNone/>
              <a:defRPr sz="3300"/>
            </a:lvl5pPr>
            <a:lvl6pPr marL="3788588" indent="0">
              <a:buNone/>
              <a:defRPr sz="3300"/>
            </a:lvl6pPr>
            <a:lvl7pPr marL="4546305" indent="0">
              <a:buNone/>
              <a:defRPr sz="3300"/>
            </a:lvl7pPr>
            <a:lvl8pPr marL="5304023" indent="0">
              <a:buNone/>
              <a:defRPr sz="3300"/>
            </a:lvl8pPr>
            <a:lvl9pPr marL="6061740" indent="0">
              <a:buNone/>
              <a:defRPr sz="33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867972" y="9304628"/>
            <a:ext cx="8779193" cy="1395281"/>
          </a:xfrm>
        </p:spPr>
        <p:txBody>
          <a:bodyPr/>
          <a:lstStyle>
            <a:lvl1pPr marL="0" indent="0">
              <a:buNone/>
              <a:defRPr sz="2300"/>
            </a:lvl1pPr>
            <a:lvl2pPr marL="757718" indent="0">
              <a:buNone/>
              <a:defRPr sz="2000"/>
            </a:lvl2pPr>
            <a:lvl3pPr marL="1515435" indent="0">
              <a:buNone/>
              <a:defRPr sz="1700"/>
            </a:lvl3pPr>
            <a:lvl4pPr marL="2273153" indent="0">
              <a:buNone/>
              <a:defRPr sz="1500"/>
            </a:lvl4pPr>
            <a:lvl5pPr marL="3030870" indent="0">
              <a:buNone/>
              <a:defRPr sz="1500"/>
            </a:lvl5pPr>
            <a:lvl6pPr marL="3788588" indent="0">
              <a:buNone/>
              <a:defRPr sz="1500"/>
            </a:lvl6pPr>
            <a:lvl7pPr marL="4546305" indent="0">
              <a:buNone/>
              <a:defRPr sz="1500"/>
            </a:lvl7pPr>
            <a:lvl8pPr marL="5304023" indent="0">
              <a:buNone/>
              <a:defRPr sz="1500"/>
            </a:lvl8pPr>
            <a:lvl9pPr marL="6061740" indent="0">
              <a:buNone/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731600" y="476103"/>
            <a:ext cx="13168789" cy="1981465"/>
          </a:xfrm>
          <a:prstGeom prst="rect">
            <a:avLst/>
          </a:prstGeom>
        </p:spPr>
        <p:txBody>
          <a:bodyPr vert="horz" lIns="151544" tIns="75772" rIns="151544" bIns="75772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31600" y="2774051"/>
            <a:ext cx="13168789" cy="7846051"/>
          </a:xfrm>
          <a:prstGeom prst="rect">
            <a:avLst/>
          </a:prstGeom>
        </p:spPr>
        <p:txBody>
          <a:bodyPr vert="horz" lIns="151544" tIns="75772" rIns="151544" bIns="75772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731599" y="11019146"/>
            <a:ext cx="3414131" cy="632968"/>
          </a:xfrm>
          <a:prstGeom prst="rect">
            <a:avLst/>
          </a:prstGeom>
        </p:spPr>
        <p:txBody>
          <a:bodyPr vert="horz" lIns="151544" tIns="75772" rIns="151544" bIns="75772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999263" y="11019146"/>
            <a:ext cx="4633463" cy="632968"/>
          </a:xfrm>
          <a:prstGeom prst="rect">
            <a:avLst/>
          </a:prstGeom>
        </p:spPr>
        <p:txBody>
          <a:bodyPr vert="horz" lIns="151544" tIns="75772" rIns="151544" bIns="75772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0486258" y="11019146"/>
            <a:ext cx="3414131" cy="632968"/>
          </a:xfrm>
          <a:prstGeom prst="rect">
            <a:avLst/>
          </a:prstGeom>
        </p:spPr>
        <p:txBody>
          <a:bodyPr vert="horz" lIns="151544" tIns="75772" rIns="151544" bIns="75772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15435" rtl="0" eaLnBrk="1" latinLnBrk="0" hangingPunct="1">
        <a:spcBef>
          <a:spcPct val="0"/>
        </a:spcBef>
        <a:buNone/>
        <a:defRPr sz="7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68288" indent="-568288" algn="l" defTabSz="1515435" rtl="0" eaLnBrk="1" latinLnBrk="0" hangingPunct="1">
        <a:spcBef>
          <a:spcPct val="20000"/>
        </a:spcBef>
        <a:buFont typeface="Arial" pitchFamily="34" charset="0"/>
        <a:buChar char="•"/>
        <a:defRPr sz="5300" kern="1200">
          <a:solidFill>
            <a:schemeClr val="tx1"/>
          </a:solidFill>
          <a:latin typeface="+mn-lt"/>
          <a:ea typeface="+mn-ea"/>
          <a:cs typeface="+mn-cs"/>
        </a:defRPr>
      </a:lvl1pPr>
      <a:lvl2pPr marL="1231291" indent="-473573" algn="l" defTabSz="1515435" rtl="0" eaLnBrk="1" latinLnBrk="0" hangingPunct="1">
        <a:spcBef>
          <a:spcPct val="20000"/>
        </a:spcBef>
        <a:buFont typeface="Arial" pitchFamily="34" charset="0"/>
        <a:buChar char="–"/>
        <a:defRPr sz="4600" kern="1200">
          <a:solidFill>
            <a:schemeClr val="tx1"/>
          </a:solidFill>
          <a:latin typeface="+mn-lt"/>
          <a:ea typeface="+mn-ea"/>
          <a:cs typeface="+mn-cs"/>
        </a:defRPr>
      </a:lvl2pPr>
      <a:lvl3pPr marL="1894294" indent="-378859" algn="l" defTabSz="1515435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2652011" indent="-378859" algn="l" defTabSz="151543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4pPr>
      <a:lvl5pPr marL="3409729" indent="-378859" algn="l" defTabSz="1515435" rtl="0" eaLnBrk="1" latinLnBrk="0" hangingPunct="1">
        <a:spcBef>
          <a:spcPct val="20000"/>
        </a:spcBef>
        <a:buFont typeface="Arial" pitchFamily="34" charset="0"/>
        <a:buChar char="»"/>
        <a:defRPr sz="3300" kern="1200">
          <a:solidFill>
            <a:schemeClr val="tx1"/>
          </a:solidFill>
          <a:latin typeface="+mn-lt"/>
          <a:ea typeface="+mn-ea"/>
          <a:cs typeface="+mn-cs"/>
        </a:defRPr>
      </a:lvl5pPr>
      <a:lvl6pPr marL="4167447" indent="-378859" algn="l" defTabSz="151543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6pPr>
      <a:lvl7pPr marL="4925164" indent="-378859" algn="l" defTabSz="151543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7pPr>
      <a:lvl8pPr marL="5682882" indent="-378859" algn="l" defTabSz="151543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8pPr>
      <a:lvl9pPr marL="6440599" indent="-378859" algn="l" defTabSz="151543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57718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15435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273153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30870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788588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546305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304023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061740" algn="l" defTabSz="1515435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13" Type="http://schemas.openxmlformats.org/officeDocument/2006/relationships/image" Target="../media/image20.tiff"/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12" Type="http://schemas.openxmlformats.org/officeDocument/2006/relationships/image" Target="../media/image19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tiff"/><Relationship Id="rId11" Type="http://schemas.openxmlformats.org/officeDocument/2006/relationships/image" Target="../media/image18.tiff"/><Relationship Id="rId5" Type="http://schemas.openxmlformats.org/officeDocument/2006/relationships/image" Target="../media/image12.tiff"/><Relationship Id="rId15" Type="http://schemas.openxmlformats.org/officeDocument/2006/relationships/image" Target="../media/image22.png"/><Relationship Id="rId10" Type="http://schemas.openxmlformats.org/officeDocument/2006/relationships/image" Target="../media/image17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7" Type="http://schemas.openxmlformats.org/officeDocument/2006/relationships/image" Target="../media/image29.png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tiff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1.png"/><Relationship Id="rId3" Type="http://schemas.openxmlformats.org/officeDocument/2006/relationships/image" Target="../media/image31.tiff"/><Relationship Id="rId7" Type="http://schemas.openxmlformats.org/officeDocument/2006/relationships/image" Target="../media/image35.tiff"/><Relationship Id="rId12" Type="http://schemas.openxmlformats.org/officeDocument/2006/relationships/image" Target="../media/image40.png"/><Relationship Id="rId17" Type="http://schemas.openxmlformats.org/officeDocument/2006/relationships/image" Target="../media/image45.png"/><Relationship Id="rId2" Type="http://schemas.openxmlformats.org/officeDocument/2006/relationships/image" Target="../media/image30.tiff"/><Relationship Id="rId16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tiff"/><Relationship Id="rId11" Type="http://schemas.openxmlformats.org/officeDocument/2006/relationships/image" Target="../media/image39.png"/><Relationship Id="rId5" Type="http://schemas.openxmlformats.org/officeDocument/2006/relationships/image" Target="../media/image33.tiff"/><Relationship Id="rId15" Type="http://schemas.openxmlformats.org/officeDocument/2006/relationships/image" Target="../media/image43.png"/><Relationship Id="rId10" Type="http://schemas.openxmlformats.org/officeDocument/2006/relationships/image" Target="../media/image38.png"/><Relationship Id="rId4" Type="http://schemas.openxmlformats.org/officeDocument/2006/relationships/image" Target="../media/image32.tiff"/><Relationship Id="rId9" Type="http://schemas.openxmlformats.org/officeDocument/2006/relationships/image" Target="../media/image37.png"/><Relationship Id="rId14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CD26290-54A5-4CFA-20CE-FB2E86F6E8B6}"/>
              </a:ext>
            </a:extLst>
          </p:cNvPr>
          <p:cNvSpPr txBox="1"/>
          <p:nvPr/>
        </p:nvSpPr>
        <p:spPr>
          <a:xfrm>
            <a:off x="666461" y="650950"/>
            <a:ext cx="10230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.2c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375DEF91-2421-FFA4-9925-E53235708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72094" y="6158120"/>
            <a:ext cx="3636517" cy="1508555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F175BEC-7BC9-2DC9-6FD2-40A369A02565}"/>
              </a:ext>
            </a:extLst>
          </p:cNvPr>
          <p:cNvSpPr txBox="1"/>
          <p:nvPr/>
        </p:nvSpPr>
        <p:spPr>
          <a:xfrm rot="18000000">
            <a:off x="2209867" y="5626769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E417A98-5A53-C834-4045-CA39FF105DAD}"/>
              </a:ext>
            </a:extLst>
          </p:cNvPr>
          <p:cNvSpPr txBox="1"/>
          <p:nvPr/>
        </p:nvSpPr>
        <p:spPr>
          <a:xfrm rot="18000000">
            <a:off x="2606490" y="5626769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146F42A-A645-D6FE-0B7E-F5CFB46926CB}"/>
              </a:ext>
            </a:extLst>
          </p:cNvPr>
          <p:cNvSpPr txBox="1"/>
          <p:nvPr/>
        </p:nvSpPr>
        <p:spPr>
          <a:xfrm rot="18000000">
            <a:off x="2862850" y="5506464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6A3D8F3-B0FE-8BFA-C40E-9B0C9B4E4A7D}"/>
              </a:ext>
            </a:extLst>
          </p:cNvPr>
          <p:cNvSpPr txBox="1"/>
          <p:nvPr/>
        </p:nvSpPr>
        <p:spPr>
          <a:xfrm rot="18000000">
            <a:off x="3259473" y="5506464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F01FC84-F0B0-ABF2-1304-F908C660F3D3}"/>
              </a:ext>
            </a:extLst>
          </p:cNvPr>
          <p:cNvSpPr txBox="1"/>
          <p:nvPr/>
        </p:nvSpPr>
        <p:spPr>
          <a:xfrm rot="18000000">
            <a:off x="3690560" y="5521735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A6680E3-6BB4-6B0A-DD6B-76DA18C9374F}"/>
              </a:ext>
            </a:extLst>
          </p:cNvPr>
          <p:cNvSpPr txBox="1"/>
          <p:nvPr/>
        </p:nvSpPr>
        <p:spPr>
          <a:xfrm rot="18000000">
            <a:off x="4087182" y="5521735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7B8CDD3A-A2E1-2862-35DE-A3C5B24911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51277" y="-497716"/>
            <a:ext cx="3804356" cy="1904731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9F2ADD2-5268-526A-2278-7D85B04C7C40}"/>
              </a:ext>
            </a:extLst>
          </p:cNvPr>
          <p:cNvSpPr txBox="1"/>
          <p:nvPr/>
        </p:nvSpPr>
        <p:spPr>
          <a:xfrm rot="18000000">
            <a:off x="6901846" y="5567106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40956DD-EDBD-5AEE-AB9C-B530FFECB013}"/>
              </a:ext>
            </a:extLst>
          </p:cNvPr>
          <p:cNvSpPr txBox="1"/>
          <p:nvPr/>
        </p:nvSpPr>
        <p:spPr>
          <a:xfrm rot="18000000">
            <a:off x="7269441" y="5567106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E88B782-28B7-A681-D0E0-1E6DA2EE9B3F}"/>
              </a:ext>
            </a:extLst>
          </p:cNvPr>
          <p:cNvSpPr txBox="1"/>
          <p:nvPr/>
        </p:nvSpPr>
        <p:spPr>
          <a:xfrm rot="18000000">
            <a:off x="7525801" y="5461572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FB6C2FA-0880-892D-1F11-871614543CE0}"/>
              </a:ext>
            </a:extLst>
          </p:cNvPr>
          <p:cNvSpPr txBox="1"/>
          <p:nvPr/>
        </p:nvSpPr>
        <p:spPr>
          <a:xfrm rot="18000000">
            <a:off x="7922424" y="5461572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1DBE450-BA95-3098-4628-0479C300E5B6}"/>
              </a:ext>
            </a:extLst>
          </p:cNvPr>
          <p:cNvSpPr txBox="1"/>
          <p:nvPr/>
        </p:nvSpPr>
        <p:spPr>
          <a:xfrm rot="18000000">
            <a:off x="8353511" y="5474760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15CE363-2102-A482-05C3-18EE0B44A8CE}"/>
              </a:ext>
            </a:extLst>
          </p:cNvPr>
          <p:cNvSpPr txBox="1"/>
          <p:nvPr/>
        </p:nvSpPr>
        <p:spPr>
          <a:xfrm rot="18000000">
            <a:off x="8750133" y="5474760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619EDB-9825-56A0-5504-7E9FDA13FFB5}"/>
              </a:ext>
            </a:extLst>
          </p:cNvPr>
          <p:cNvSpPr txBox="1"/>
          <p:nvPr/>
        </p:nvSpPr>
        <p:spPr>
          <a:xfrm rot="18000000">
            <a:off x="15879643" y="8540443"/>
            <a:ext cx="647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34BC908-C8AF-0B29-E6A0-5581FE308879}"/>
              </a:ext>
            </a:extLst>
          </p:cNvPr>
          <p:cNvSpPr txBox="1"/>
          <p:nvPr/>
        </p:nvSpPr>
        <p:spPr>
          <a:xfrm rot="18000000">
            <a:off x="16276266" y="8540443"/>
            <a:ext cx="647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B0DBF33-CE00-FAD4-D5B9-A9195EE53827}"/>
              </a:ext>
            </a:extLst>
          </p:cNvPr>
          <p:cNvSpPr txBox="1"/>
          <p:nvPr/>
        </p:nvSpPr>
        <p:spPr>
          <a:xfrm rot="18000000">
            <a:off x="16551028" y="8420138"/>
            <a:ext cx="8915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4CB4505-9C45-1065-8F14-EB9FFD739908}"/>
              </a:ext>
            </a:extLst>
          </p:cNvPr>
          <p:cNvSpPr txBox="1"/>
          <p:nvPr/>
        </p:nvSpPr>
        <p:spPr>
          <a:xfrm rot="18000000">
            <a:off x="16947651" y="8420138"/>
            <a:ext cx="8915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986FED0-5620-4B80-805D-9F7B03DD3F76}"/>
              </a:ext>
            </a:extLst>
          </p:cNvPr>
          <p:cNvSpPr txBox="1"/>
          <p:nvPr/>
        </p:nvSpPr>
        <p:spPr>
          <a:xfrm rot="18000000">
            <a:off x="17359503" y="8435409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ACBA84F5-27E6-CE38-06C8-1D18E14D165E}"/>
              </a:ext>
            </a:extLst>
          </p:cNvPr>
          <p:cNvSpPr txBox="1"/>
          <p:nvPr/>
        </p:nvSpPr>
        <p:spPr>
          <a:xfrm rot="18000000">
            <a:off x="17756125" y="8435409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225">
            <a:extLst>
              <a:ext uri="{FF2B5EF4-FFF2-40B4-BE49-F238E27FC236}">
                <a16:creationId xmlns:a16="http://schemas.microsoft.com/office/drawing/2014/main" id="{0C0C2D7F-8E9F-C491-BC9F-45DCA13FDB36}"/>
              </a:ext>
            </a:extLst>
          </p:cNvPr>
          <p:cNvSpPr txBox="1"/>
          <p:nvPr/>
        </p:nvSpPr>
        <p:spPr>
          <a:xfrm>
            <a:off x="351450" y="10844433"/>
            <a:ext cx="140427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western blots:  Images of the membranes from the western blot analyses presented in Fig. 2c. Proteins were speared on 12.5%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DS-PAGE gels for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MVK and Actin, 10% SDS-PAGE gel for SREBP2.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FD3DBE6-AF82-0EDD-EEDD-BF0359CA43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8131" y="1407015"/>
            <a:ext cx="3482741" cy="230475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B0BE460-3387-C86F-BC8B-564BB9EB9132}"/>
              </a:ext>
            </a:extLst>
          </p:cNvPr>
          <p:cNvSpPr txBox="1"/>
          <p:nvPr/>
        </p:nvSpPr>
        <p:spPr>
          <a:xfrm>
            <a:off x="6025958" y="4859539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FD0D260D-C82F-BFE2-E9F2-8ED3E3CEE7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742595" y="6134357"/>
            <a:ext cx="3005170" cy="260834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0446546-539E-E155-0650-7B7FA34256D0}"/>
              </a:ext>
            </a:extLst>
          </p:cNvPr>
          <p:cNvSpPr txBox="1"/>
          <p:nvPr/>
        </p:nvSpPr>
        <p:spPr>
          <a:xfrm rot="18000000">
            <a:off x="11039836" y="5651956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6E3FC1A-A235-0160-EDCF-D01EEE17BA4D}"/>
              </a:ext>
            </a:extLst>
          </p:cNvPr>
          <p:cNvSpPr txBox="1"/>
          <p:nvPr/>
        </p:nvSpPr>
        <p:spPr>
          <a:xfrm rot="18000000">
            <a:off x="11430653" y="5651956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8149853-AAE6-C7A6-010B-275F945DC060}"/>
              </a:ext>
            </a:extLst>
          </p:cNvPr>
          <p:cNvSpPr txBox="1"/>
          <p:nvPr/>
        </p:nvSpPr>
        <p:spPr>
          <a:xfrm rot="18000000">
            <a:off x="11681207" y="5530486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0B9C8A9-EB02-CE34-747E-1C390D8246D0}"/>
              </a:ext>
            </a:extLst>
          </p:cNvPr>
          <p:cNvSpPr txBox="1"/>
          <p:nvPr/>
        </p:nvSpPr>
        <p:spPr>
          <a:xfrm rot="18000000">
            <a:off x="12072024" y="5530486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B3B144F-5088-40C1-79B3-868C32113D67}"/>
              </a:ext>
            </a:extLst>
          </p:cNvPr>
          <p:cNvSpPr txBox="1"/>
          <p:nvPr/>
        </p:nvSpPr>
        <p:spPr>
          <a:xfrm rot="18000000">
            <a:off x="12497305" y="5560332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3114C56-6E52-59FF-292C-D92661A6BB00}"/>
              </a:ext>
            </a:extLst>
          </p:cNvPr>
          <p:cNvSpPr txBox="1"/>
          <p:nvPr/>
        </p:nvSpPr>
        <p:spPr>
          <a:xfrm rot="18000000">
            <a:off x="12888123" y="5560332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195DE089-6421-D4C4-CFEB-9E1C8170E665}"/>
              </a:ext>
            </a:extLst>
          </p:cNvPr>
          <p:cNvSpPr/>
          <p:nvPr/>
        </p:nvSpPr>
        <p:spPr>
          <a:xfrm>
            <a:off x="10916765" y="6962760"/>
            <a:ext cx="212418" cy="144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b="1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19EB168-02D7-0A14-60CA-800073D1A9C9}"/>
              </a:ext>
            </a:extLst>
          </p:cNvPr>
          <p:cNvSpPr txBox="1"/>
          <p:nvPr/>
        </p:nvSpPr>
        <p:spPr>
          <a:xfrm>
            <a:off x="10332309" y="6853092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FB63411-1CEC-6AD5-9DF9-EA41C8FF4463}"/>
              </a:ext>
            </a:extLst>
          </p:cNvPr>
          <p:cNvSpPr txBox="1"/>
          <p:nvPr/>
        </p:nvSpPr>
        <p:spPr>
          <a:xfrm>
            <a:off x="10384047" y="4859539"/>
            <a:ext cx="10021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REBP2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BEB1C87-CBB6-83CF-56BB-F08370315839}"/>
              </a:ext>
            </a:extLst>
          </p:cNvPr>
          <p:cNvSpPr txBox="1"/>
          <p:nvPr/>
        </p:nvSpPr>
        <p:spPr>
          <a:xfrm>
            <a:off x="944812" y="4859539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PMVK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267ED0F6-B4D4-FC37-EAF7-D5EB6D9D23EE}"/>
              </a:ext>
            </a:extLst>
          </p:cNvPr>
          <p:cNvSpPr txBox="1"/>
          <p:nvPr/>
        </p:nvSpPr>
        <p:spPr>
          <a:xfrm>
            <a:off x="43186" y="39738"/>
            <a:ext cx="546816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western blots</a:t>
            </a:r>
            <a:endParaRPr kumimoji="1" lang="ja-JP" altLang="en-US"/>
          </a:p>
        </p:txBody>
      </p:sp>
      <p:pic>
        <p:nvPicPr>
          <p:cNvPr id="67" name="図 66">
            <a:extLst>
              <a:ext uri="{FF2B5EF4-FFF2-40B4-BE49-F238E27FC236}">
                <a16:creationId xmlns:a16="http://schemas.microsoft.com/office/drawing/2014/main" id="{70828B4D-10F2-4908-5B6D-E193F6D6419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62029" y="6098676"/>
            <a:ext cx="3636000" cy="3216467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27987C49-2E09-3DEA-F235-6059FEF46CF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61675" y="6102435"/>
            <a:ext cx="3780000" cy="3422843"/>
          </a:xfrm>
          <a:prstGeom prst="rect">
            <a:avLst/>
          </a:prstGeom>
        </p:spPr>
      </p:pic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8F01074-326E-BF95-F772-4D4179B9ACDB}"/>
              </a:ext>
            </a:extLst>
          </p:cNvPr>
          <p:cNvSpPr txBox="1"/>
          <p:nvPr/>
        </p:nvSpPr>
        <p:spPr>
          <a:xfrm>
            <a:off x="340146" y="11358168"/>
            <a:ext cx="62485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iangles indicate specific bands and asterisks indicate non-specific bands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E6554225-A0E9-CBB2-6DF7-7027E3D80132}"/>
              </a:ext>
            </a:extLst>
          </p:cNvPr>
          <p:cNvSpPr/>
          <p:nvPr/>
        </p:nvSpPr>
        <p:spPr>
          <a:xfrm>
            <a:off x="5937289" y="7603652"/>
            <a:ext cx="212418" cy="144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AB531D1-45B0-AEAF-5C20-F793FC09A2ED}"/>
              </a:ext>
            </a:extLst>
          </p:cNvPr>
          <p:cNvSpPr txBox="1"/>
          <p:nvPr/>
        </p:nvSpPr>
        <p:spPr>
          <a:xfrm>
            <a:off x="5396483" y="7525150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35DCFD60-FE57-8ACE-4A2E-3FB282B39A44}"/>
              </a:ext>
            </a:extLst>
          </p:cNvPr>
          <p:cNvSpPr/>
          <p:nvPr/>
        </p:nvSpPr>
        <p:spPr>
          <a:xfrm>
            <a:off x="5937289" y="7080175"/>
            <a:ext cx="212418" cy="144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A7AAF26-3D77-74B0-2361-54DFA0EA3F42}"/>
              </a:ext>
            </a:extLst>
          </p:cNvPr>
          <p:cNvSpPr txBox="1"/>
          <p:nvPr/>
        </p:nvSpPr>
        <p:spPr>
          <a:xfrm>
            <a:off x="5396483" y="6970507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FF8E776-9E24-AD2A-C223-9FF4A6AA79A9}"/>
              </a:ext>
            </a:extLst>
          </p:cNvPr>
          <p:cNvSpPr txBox="1"/>
          <p:nvPr/>
        </p:nvSpPr>
        <p:spPr>
          <a:xfrm>
            <a:off x="9218849" y="8006010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MVK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9781B763-230F-9FA2-0882-8A295A5108AA}"/>
              </a:ext>
            </a:extLst>
          </p:cNvPr>
          <p:cNvSpPr txBox="1"/>
          <p:nvPr/>
        </p:nvSpPr>
        <p:spPr>
          <a:xfrm>
            <a:off x="9198105" y="7105265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右矢印 22">
            <a:extLst>
              <a:ext uri="{FF2B5EF4-FFF2-40B4-BE49-F238E27FC236}">
                <a16:creationId xmlns:a16="http://schemas.microsoft.com/office/drawing/2014/main" id="{0D5A818A-A155-4287-A13C-F6A05A8EFA6B}"/>
              </a:ext>
            </a:extLst>
          </p:cNvPr>
          <p:cNvSpPr/>
          <p:nvPr/>
        </p:nvSpPr>
        <p:spPr>
          <a:xfrm>
            <a:off x="1438865" y="7515956"/>
            <a:ext cx="212418" cy="144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6689D369-69DE-583F-0969-193DD2C537E7}"/>
              </a:ext>
            </a:extLst>
          </p:cNvPr>
          <p:cNvSpPr txBox="1"/>
          <p:nvPr/>
        </p:nvSpPr>
        <p:spPr>
          <a:xfrm>
            <a:off x="898059" y="7437454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右矢印 32">
            <a:extLst>
              <a:ext uri="{FF2B5EF4-FFF2-40B4-BE49-F238E27FC236}">
                <a16:creationId xmlns:a16="http://schemas.microsoft.com/office/drawing/2014/main" id="{6FE01228-2798-2799-507E-7BEC42C1C1BC}"/>
              </a:ext>
            </a:extLst>
          </p:cNvPr>
          <p:cNvSpPr/>
          <p:nvPr/>
        </p:nvSpPr>
        <p:spPr>
          <a:xfrm>
            <a:off x="1438865" y="7030579"/>
            <a:ext cx="212418" cy="144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C094669-212C-B046-F80E-A9F2DB6DE3E4}"/>
              </a:ext>
            </a:extLst>
          </p:cNvPr>
          <p:cNvSpPr txBox="1"/>
          <p:nvPr/>
        </p:nvSpPr>
        <p:spPr>
          <a:xfrm>
            <a:off x="898059" y="6920911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204A17E-F6F9-E2AD-BAEB-D7D640CA53B1}"/>
              </a:ext>
            </a:extLst>
          </p:cNvPr>
          <p:cNvSpPr txBox="1"/>
          <p:nvPr/>
        </p:nvSpPr>
        <p:spPr>
          <a:xfrm>
            <a:off x="4493311" y="7933242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MVK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A0331B83-8B78-B92B-AF1B-7CA4FCBC3417}"/>
              </a:ext>
            </a:extLst>
          </p:cNvPr>
          <p:cNvSpPr txBox="1"/>
          <p:nvPr/>
        </p:nvSpPr>
        <p:spPr>
          <a:xfrm>
            <a:off x="4493311" y="7032497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2337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375DEF91-2421-FFA4-9925-E53235708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72094" y="6158120"/>
            <a:ext cx="3636517" cy="1508555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7B8CDD3A-A2E1-2862-35DE-A3C5B24911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51277" y="-497716"/>
            <a:ext cx="3804356" cy="1904731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1218426-28B8-AB32-3284-72F4467DB560}"/>
              </a:ext>
            </a:extLst>
          </p:cNvPr>
          <p:cNvSpPr txBox="1"/>
          <p:nvPr/>
        </p:nvSpPr>
        <p:spPr>
          <a:xfrm>
            <a:off x="663850" y="799066"/>
            <a:ext cx="10406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kumimoji="1"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.2d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619EDB-9825-56A0-5504-7E9FDA13FFB5}"/>
              </a:ext>
            </a:extLst>
          </p:cNvPr>
          <p:cNvSpPr txBox="1"/>
          <p:nvPr/>
        </p:nvSpPr>
        <p:spPr>
          <a:xfrm rot="18000000">
            <a:off x="15879643" y="8540443"/>
            <a:ext cx="647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34BC908-C8AF-0B29-E6A0-5581FE308879}"/>
              </a:ext>
            </a:extLst>
          </p:cNvPr>
          <p:cNvSpPr txBox="1"/>
          <p:nvPr/>
        </p:nvSpPr>
        <p:spPr>
          <a:xfrm rot="18000000">
            <a:off x="16276266" y="8540443"/>
            <a:ext cx="647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 TF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B0DBF33-CE00-FAD4-D5B9-A9195EE53827}"/>
              </a:ext>
            </a:extLst>
          </p:cNvPr>
          <p:cNvSpPr txBox="1"/>
          <p:nvPr/>
        </p:nvSpPr>
        <p:spPr>
          <a:xfrm rot="18000000">
            <a:off x="16551028" y="8420138"/>
            <a:ext cx="8915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4CB4505-9C45-1065-8F14-EB9FFD739908}"/>
              </a:ext>
            </a:extLst>
          </p:cNvPr>
          <p:cNvSpPr txBox="1"/>
          <p:nvPr/>
        </p:nvSpPr>
        <p:spPr>
          <a:xfrm rot="18000000">
            <a:off x="16947651" y="8420138"/>
            <a:ext cx="8915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986FED0-5620-4B80-805D-9F7B03DD3F76}"/>
              </a:ext>
            </a:extLst>
          </p:cNvPr>
          <p:cNvSpPr txBox="1"/>
          <p:nvPr/>
        </p:nvSpPr>
        <p:spPr>
          <a:xfrm rot="18000000">
            <a:off x="17359503" y="8435409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ACBA84F5-27E6-CE38-06C8-1D18E14D165E}"/>
              </a:ext>
            </a:extLst>
          </p:cNvPr>
          <p:cNvSpPr txBox="1"/>
          <p:nvPr/>
        </p:nvSpPr>
        <p:spPr>
          <a:xfrm rot="18000000">
            <a:off x="17756125" y="8435409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DB1495D-131F-5668-4F5A-5D8364B80371}"/>
              </a:ext>
            </a:extLst>
          </p:cNvPr>
          <p:cNvSpPr txBox="1"/>
          <p:nvPr/>
        </p:nvSpPr>
        <p:spPr>
          <a:xfrm rot="18000000">
            <a:off x="11732030" y="1584241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00F987D-B28E-3030-C85F-9686A4F01D24}"/>
              </a:ext>
            </a:extLst>
          </p:cNvPr>
          <p:cNvSpPr txBox="1"/>
          <p:nvPr/>
        </p:nvSpPr>
        <p:spPr>
          <a:xfrm rot="18000000">
            <a:off x="12122847" y="1584241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t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B4C2D40B-49C4-9862-1813-1C91FF1AC0FD}"/>
              </a:ext>
            </a:extLst>
          </p:cNvPr>
          <p:cNvGrpSpPr/>
          <p:nvPr/>
        </p:nvGrpSpPr>
        <p:grpSpPr>
          <a:xfrm>
            <a:off x="10390398" y="1312414"/>
            <a:ext cx="3406316" cy="3613688"/>
            <a:chOff x="10390398" y="1312414"/>
            <a:chExt cx="3406316" cy="3613688"/>
          </a:xfrm>
        </p:grpSpPr>
        <p:pic>
          <p:nvPicPr>
            <p:cNvPr id="57" name="図 56">
              <a:extLst>
                <a:ext uri="{FF2B5EF4-FFF2-40B4-BE49-F238E27FC236}">
                  <a16:creationId xmlns:a16="http://schemas.microsoft.com/office/drawing/2014/main" id="{F8A95754-3BB7-D5EE-C396-F1AC86D7177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688925" y="2218014"/>
              <a:ext cx="3107789" cy="2708088"/>
            </a:xfrm>
            <a:prstGeom prst="rect">
              <a:avLst/>
            </a:prstGeom>
          </p:spPr>
        </p:pic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5C652839-923F-4BEA-913D-F24311CC83D5}"/>
                </a:ext>
              </a:extLst>
            </p:cNvPr>
            <p:cNvSpPr txBox="1"/>
            <p:nvPr/>
          </p:nvSpPr>
          <p:spPr>
            <a:xfrm rot="18000000">
              <a:off x="11090659" y="1704546"/>
              <a:ext cx="670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 T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F4E193F8-7C0C-24EB-D3B2-F76BAAB21763}"/>
                </a:ext>
              </a:extLst>
            </p:cNvPr>
            <p:cNvSpPr txBox="1"/>
            <p:nvPr/>
          </p:nvSpPr>
          <p:spPr>
            <a:xfrm rot="18000000">
              <a:off x="11481476" y="1704546"/>
              <a:ext cx="670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 TF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23671CBA-0D9A-78D3-2C04-90FF11ADFB8C}"/>
                </a:ext>
              </a:extLst>
            </p:cNvPr>
            <p:cNvSpPr txBox="1"/>
            <p:nvPr/>
          </p:nvSpPr>
          <p:spPr>
            <a:xfrm rot="18000000">
              <a:off x="12548128" y="1599512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874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51AAE67B-2CD8-0AEF-7B1B-9BE21026128B}"/>
                </a:ext>
              </a:extLst>
            </p:cNvPr>
            <p:cNvSpPr txBox="1"/>
            <p:nvPr/>
          </p:nvSpPr>
          <p:spPr>
            <a:xfrm rot="18000000">
              <a:off x="12938946" y="1599512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874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右矢印 63">
              <a:extLst>
                <a:ext uri="{FF2B5EF4-FFF2-40B4-BE49-F238E27FC236}">
                  <a16:creationId xmlns:a16="http://schemas.microsoft.com/office/drawing/2014/main" id="{1C978CFB-1B93-2364-2311-9C5F62F614CB}"/>
                </a:ext>
              </a:extLst>
            </p:cNvPr>
            <p:cNvSpPr/>
            <p:nvPr/>
          </p:nvSpPr>
          <p:spPr>
            <a:xfrm>
              <a:off x="10910958" y="3169253"/>
              <a:ext cx="212418" cy="144000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8CE238B9-828F-E661-C389-FB6E1D139CD1}"/>
                </a:ext>
              </a:extLst>
            </p:cNvPr>
            <p:cNvSpPr txBox="1"/>
            <p:nvPr/>
          </p:nvSpPr>
          <p:spPr>
            <a:xfrm>
              <a:off x="10390398" y="3059585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55kd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6" name="TextBox 225">
            <a:extLst>
              <a:ext uri="{FF2B5EF4-FFF2-40B4-BE49-F238E27FC236}">
                <a16:creationId xmlns:a16="http://schemas.microsoft.com/office/drawing/2014/main" id="{0C0C2D7F-8E9F-C491-BC9F-45DCA13FDB36}"/>
              </a:ext>
            </a:extLst>
          </p:cNvPr>
          <p:cNvSpPr txBox="1"/>
          <p:nvPr/>
        </p:nvSpPr>
        <p:spPr>
          <a:xfrm>
            <a:off x="351450" y="6527268"/>
            <a:ext cx="140427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western blots:  Images of the membranes from the western blot analyses presented in Fig. 2d. Proteins were speared on 12.5%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DS-PAGE gels for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MVK and Actin, 10% SDS-PAGE gel for SREBP2.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5D3D8D50-9735-13EE-5FE9-02575F8021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25798" y="1656467"/>
            <a:ext cx="2969594" cy="2456331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708C961-D56C-B981-118B-97AECCEA235D}"/>
              </a:ext>
            </a:extLst>
          </p:cNvPr>
          <p:cNvSpPr txBox="1"/>
          <p:nvPr/>
        </p:nvSpPr>
        <p:spPr>
          <a:xfrm>
            <a:off x="11096373" y="860979"/>
            <a:ext cx="10021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REBP2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267ED0F6-B4D4-FC37-EAF7-D5EB6D9D23EE}"/>
              </a:ext>
            </a:extLst>
          </p:cNvPr>
          <p:cNvSpPr txBox="1"/>
          <p:nvPr/>
        </p:nvSpPr>
        <p:spPr>
          <a:xfrm>
            <a:off x="43186" y="39738"/>
            <a:ext cx="546816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western blots</a:t>
            </a:r>
            <a:endParaRPr kumimoji="1" lang="ja-JP" altLang="en-US"/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D947B38D-A302-E7EF-C370-28B6A28779A2}"/>
              </a:ext>
            </a:extLst>
          </p:cNvPr>
          <p:cNvGrpSpPr/>
          <p:nvPr/>
        </p:nvGrpSpPr>
        <p:grpSpPr>
          <a:xfrm>
            <a:off x="5285631" y="1172773"/>
            <a:ext cx="4705881" cy="4550357"/>
            <a:chOff x="5285631" y="1172773"/>
            <a:chExt cx="4705881" cy="4550357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4EB2B6AF-812F-6EDE-1425-BDD6CCBFCA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62249" y="2123130"/>
              <a:ext cx="3815396" cy="3600000"/>
            </a:xfrm>
            <a:prstGeom prst="rect">
              <a:avLst/>
            </a:prstGeom>
          </p:spPr>
        </p:pic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04022E3A-DB58-550D-FA78-861EF3BF1841}"/>
                </a:ext>
              </a:extLst>
            </p:cNvPr>
            <p:cNvSpPr txBox="1"/>
            <p:nvPr/>
          </p:nvSpPr>
          <p:spPr>
            <a:xfrm rot="18000000">
              <a:off x="6726364" y="1614640"/>
              <a:ext cx="670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 T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4D7018A0-4251-E17B-0DC8-CFEAFF8ECF40}"/>
                </a:ext>
              </a:extLst>
            </p:cNvPr>
            <p:cNvSpPr txBox="1"/>
            <p:nvPr/>
          </p:nvSpPr>
          <p:spPr>
            <a:xfrm rot="18000000">
              <a:off x="7093959" y="1614640"/>
              <a:ext cx="670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 TF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480E8AB0-4425-9E17-F210-452A127B7071}"/>
                </a:ext>
              </a:extLst>
            </p:cNvPr>
            <p:cNvSpPr txBox="1"/>
            <p:nvPr/>
          </p:nvSpPr>
          <p:spPr>
            <a:xfrm rot="18000000">
              <a:off x="7350319" y="1494335"/>
              <a:ext cx="9509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nt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C59D6FCE-EB77-19C5-A8F5-BDD9D776C930}"/>
                </a:ext>
              </a:extLst>
            </p:cNvPr>
            <p:cNvSpPr txBox="1"/>
            <p:nvPr/>
          </p:nvSpPr>
          <p:spPr>
            <a:xfrm rot="18000000">
              <a:off x="7746942" y="1494335"/>
              <a:ext cx="9509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nt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6683F95C-EBF5-9AAF-F2F9-64278B1460C2}"/>
                </a:ext>
              </a:extLst>
            </p:cNvPr>
            <p:cNvSpPr txBox="1"/>
            <p:nvPr/>
          </p:nvSpPr>
          <p:spPr>
            <a:xfrm rot="18000000">
              <a:off x="8178029" y="1509606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874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4CBAA49-4FA2-3719-81A7-B848FF92F180}"/>
                </a:ext>
              </a:extLst>
            </p:cNvPr>
            <p:cNvSpPr txBox="1"/>
            <p:nvPr/>
          </p:nvSpPr>
          <p:spPr>
            <a:xfrm rot="18000000">
              <a:off x="8574651" y="1509606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874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右矢印 43">
              <a:extLst>
                <a:ext uri="{FF2B5EF4-FFF2-40B4-BE49-F238E27FC236}">
                  <a16:creationId xmlns:a16="http://schemas.microsoft.com/office/drawing/2014/main" id="{54685CED-1430-B307-3396-54B27F6EB814}"/>
                </a:ext>
              </a:extLst>
            </p:cNvPr>
            <p:cNvSpPr/>
            <p:nvPr/>
          </p:nvSpPr>
          <p:spPr>
            <a:xfrm>
              <a:off x="5842235" y="3983656"/>
              <a:ext cx="212418" cy="144000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CA4FF340-C8E1-A608-2354-19EAA183A4A2}"/>
                </a:ext>
              </a:extLst>
            </p:cNvPr>
            <p:cNvSpPr txBox="1"/>
            <p:nvPr/>
          </p:nvSpPr>
          <p:spPr>
            <a:xfrm>
              <a:off x="5285631" y="3901768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右矢印 53">
              <a:extLst>
                <a:ext uri="{FF2B5EF4-FFF2-40B4-BE49-F238E27FC236}">
                  <a16:creationId xmlns:a16="http://schemas.microsoft.com/office/drawing/2014/main" id="{13AE9F8F-BD1A-79DC-0752-3C6B250A191B}"/>
                </a:ext>
              </a:extLst>
            </p:cNvPr>
            <p:cNvSpPr/>
            <p:nvPr/>
          </p:nvSpPr>
          <p:spPr>
            <a:xfrm>
              <a:off x="5842235" y="3407592"/>
              <a:ext cx="212418" cy="144000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D6C0A557-E168-094E-FA9D-B4B7E8378084}"/>
                </a:ext>
              </a:extLst>
            </p:cNvPr>
            <p:cNvSpPr txBox="1"/>
            <p:nvPr/>
          </p:nvSpPr>
          <p:spPr>
            <a:xfrm>
              <a:off x="5292888" y="3325704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21544424-222B-9AED-DE5A-47EA10049ACF}"/>
                </a:ext>
              </a:extLst>
            </p:cNvPr>
            <p:cNvSpPr txBox="1"/>
            <p:nvPr/>
          </p:nvSpPr>
          <p:spPr>
            <a:xfrm>
              <a:off x="9215337" y="4305672"/>
              <a:ext cx="7761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MVK</a:t>
              </a:r>
              <a:endParaRPr kumimoji="1" lang="ja-JP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48A7EBAE-3983-ABFE-8EA3-160BC507158B}"/>
                </a:ext>
              </a:extLst>
            </p:cNvPr>
            <p:cNvSpPr txBox="1"/>
            <p:nvPr/>
          </p:nvSpPr>
          <p:spPr>
            <a:xfrm>
              <a:off x="9215337" y="3366935"/>
              <a:ext cx="6976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6C06D86-E131-AED5-C839-EBA1BF5F5F82}"/>
              </a:ext>
            </a:extLst>
          </p:cNvPr>
          <p:cNvSpPr txBox="1"/>
          <p:nvPr/>
        </p:nvSpPr>
        <p:spPr>
          <a:xfrm>
            <a:off x="1177979" y="2884632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MVK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22CBFD3C-44B5-4707-3946-3E2F99B170CF}"/>
              </a:ext>
            </a:extLst>
          </p:cNvPr>
          <p:cNvSpPr txBox="1"/>
          <p:nvPr/>
        </p:nvSpPr>
        <p:spPr>
          <a:xfrm>
            <a:off x="977122" y="3280127"/>
            <a:ext cx="9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REBP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3AF8464-6E0B-E899-65AC-35F7DBAAC090}"/>
              </a:ext>
            </a:extLst>
          </p:cNvPr>
          <p:cNvSpPr txBox="1"/>
          <p:nvPr/>
        </p:nvSpPr>
        <p:spPr>
          <a:xfrm>
            <a:off x="1253470" y="3708035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8F01074-326E-BF95-F772-4D4179B9ACDB}"/>
              </a:ext>
            </a:extLst>
          </p:cNvPr>
          <p:cNvSpPr txBox="1"/>
          <p:nvPr/>
        </p:nvSpPr>
        <p:spPr>
          <a:xfrm>
            <a:off x="340146" y="7041003"/>
            <a:ext cx="62485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iangles indicate specific bands and asterisks indicate non-specific bands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92FAC1F-DB58-7879-B0A8-DAEFAB9C6BF6}"/>
              </a:ext>
            </a:extLst>
          </p:cNvPr>
          <p:cNvSpPr txBox="1"/>
          <p:nvPr/>
        </p:nvSpPr>
        <p:spPr>
          <a:xfrm>
            <a:off x="5708019" y="860979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PMVK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25E28F6-2671-F30F-58B3-30D40C23C6DF}"/>
              </a:ext>
            </a:extLst>
          </p:cNvPr>
          <p:cNvSpPr txBox="1"/>
          <p:nvPr/>
        </p:nvSpPr>
        <p:spPr>
          <a:xfrm>
            <a:off x="6588213" y="860979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7069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9210" y="255762"/>
            <a:ext cx="1162051" cy="522356"/>
          </a:xfrm>
          <a:prstGeom prst="rect">
            <a:avLst/>
          </a:prstGeom>
          <a:noFill/>
        </p:spPr>
        <p:txBody>
          <a:bodyPr wrap="none" lIns="151544" tIns="75772" rIns="151544" bIns="75772" rtlCol="0">
            <a:spAutoFit/>
          </a:bodyPr>
          <a:lstStyle/>
          <a:p>
            <a:r>
              <a:rPr lang="en-US" altLang="zh-CN" sz="2400" dirty="0">
                <a:latin typeface="Arial"/>
                <a:cs typeface="Arial"/>
              </a:rPr>
              <a:t>Fig.3a</a:t>
            </a:r>
            <a:endParaRPr lang="zh-CN" altLang="en-US" sz="2400" dirty="0">
              <a:latin typeface="Arial"/>
              <a:cs typeface="Arial"/>
            </a:endParaRPr>
          </a:p>
        </p:txBody>
      </p:sp>
      <p:pic>
        <p:nvPicPr>
          <p:cNvPr id="1027" name="Picture 3" descr="C:\Users\user\Desktop\WB original\Exp2021_39 original image for figure\20210605_1220_14 ppt imageJcMycコピー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00" t="18215" r="15958" b="10665"/>
          <a:stretch/>
        </p:blipFill>
        <p:spPr bwMode="auto">
          <a:xfrm>
            <a:off x="4067019" y="683314"/>
            <a:ext cx="3229150" cy="25345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直接连接符 6"/>
          <p:cNvCxnSpPr/>
          <p:nvPr/>
        </p:nvCxnSpPr>
        <p:spPr>
          <a:xfrm flipV="1">
            <a:off x="4883187" y="465508"/>
            <a:ext cx="844768" cy="928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5862508" y="465508"/>
            <a:ext cx="84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767769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14654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h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261539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h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08424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h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755309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002194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249079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h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495961" y="4930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 rot="18146926">
            <a:off x="4525342" y="348504"/>
            <a:ext cx="5357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0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60765" y="217718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000" err="1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c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951121" y="223929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" name="右箭头 21"/>
          <p:cNvSpPr/>
          <p:nvPr/>
        </p:nvSpPr>
        <p:spPr>
          <a:xfrm>
            <a:off x="3954975" y="1506264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pic>
        <p:nvPicPr>
          <p:cNvPr id="1028" name="Picture 4" descr="C:\Users\user\Desktop\WB original\Exp2021_39 original image for figure\20210604_1705_4 ppt imageJp53コピー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19" t="12685" r="23560" b="9154"/>
          <a:stretch/>
        </p:blipFill>
        <p:spPr bwMode="auto">
          <a:xfrm>
            <a:off x="7748042" y="661400"/>
            <a:ext cx="3229200" cy="25564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user\Desktop\WB original\Exp2021_39 original image for figure\20210605_1834_14 actin_pptコピー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27" t="16728" r="18963" b="11134"/>
          <a:stretch/>
        </p:blipFill>
        <p:spPr bwMode="auto">
          <a:xfrm>
            <a:off x="11359602" y="709063"/>
            <a:ext cx="3229200" cy="2374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8" name="直接连接符 27"/>
          <p:cNvCxnSpPr/>
          <p:nvPr/>
        </p:nvCxnSpPr>
        <p:spPr>
          <a:xfrm flipV="1">
            <a:off x="8520930" y="467960"/>
            <a:ext cx="844768" cy="928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9500251" y="467960"/>
            <a:ext cx="84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840551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8652397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h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89928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h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6167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h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939305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639937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88682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h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0133704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 rot="18146926">
            <a:off x="8163085" y="350956"/>
            <a:ext cx="5357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0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598508" y="220170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000" err="1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c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9588864" y="226381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cxnSp>
        <p:nvCxnSpPr>
          <p:cNvPr id="41" name="直接连接符 40"/>
          <p:cNvCxnSpPr/>
          <p:nvPr/>
        </p:nvCxnSpPr>
        <p:spPr>
          <a:xfrm flipV="1">
            <a:off x="12075710" y="467960"/>
            <a:ext cx="844768" cy="928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13055031" y="467960"/>
            <a:ext cx="84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1196029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2207177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h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245406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h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2700947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h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294783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3194717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3441602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h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3688484" y="4955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h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 rot="18146926">
            <a:off x="11717865" y="350956"/>
            <a:ext cx="5357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0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2153288" y="220170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000" err="1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c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3143644" y="226381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363865" y="-11534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c-Myc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129814" y="-1153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p53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603439" y="-15716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actin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57" name="右箭头 56"/>
          <p:cNvSpPr/>
          <p:nvPr/>
        </p:nvSpPr>
        <p:spPr>
          <a:xfrm>
            <a:off x="7656840" y="1701438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206728" y="159894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59" name="右箭头 58"/>
          <p:cNvSpPr/>
          <p:nvPr/>
        </p:nvSpPr>
        <p:spPr>
          <a:xfrm>
            <a:off x="11261653" y="1658728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0811541" y="155623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59210" y="3529171"/>
            <a:ext cx="1162051" cy="522356"/>
          </a:xfrm>
          <a:prstGeom prst="rect">
            <a:avLst/>
          </a:prstGeom>
          <a:noFill/>
        </p:spPr>
        <p:txBody>
          <a:bodyPr wrap="none" lIns="151544" tIns="75772" rIns="151544" bIns="75772" rtlCol="0">
            <a:spAutoFit/>
          </a:bodyPr>
          <a:lstStyle/>
          <a:p>
            <a:r>
              <a:rPr lang="en-US" altLang="zh-CN" sz="2400" dirty="0">
                <a:latin typeface="Arial"/>
                <a:cs typeface="Arial"/>
              </a:rPr>
              <a:t>Fig.3d</a:t>
            </a:r>
            <a:endParaRPr lang="zh-CN" altLang="en-US" sz="2400" dirty="0">
              <a:latin typeface="Arial"/>
              <a:cs typeface="Arial"/>
            </a:endParaRPr>
          </a:p>
        </p:txBody>
      </p:sp>
      <p:pic>
        <p:nvPicPr>
          <p:cNvPr id="1031" name="Picture 7" descr="C:\Users\user\Desktop\WB original\Fig.3 D 28\c-myc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82" t="10106" r="25778" b="28711"/>
          <a:stretch/>
        </p:blipFill>
        <p:spPr bwMode="auto">
          <a:xfrm>
            <a:off x="4241594" y="3936880"/>
            <a:ext cx="2880000" cy="22748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user\Desktop\WB original\Fig.3 D 28\p53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02" t="21368" r="24906" b="10425"/>
          <a:stretch/>
        </p:blipFill>
        <p:spPr bwMode="auto">
          <a:xfrm>
            <a:off x="7557907" y="3696008"/>
            <a:ext cx="2880000" cy="24806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user\Desktop\WB original\Fig.3 D 28\actin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11" t="18035" r="23943" b="11885"/>
          <a:stretch/>
        </p:blipFill>
        <p:spPr bwMode="auto">
          <a:xfrm>
            <a:off x="10814120" y="3663706"/>
            <a:ext cx="2880000" cy="24532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TextBox 93"/>
          <p:cNvSpPr txBox="1"/>
          <p:nvPr/>
        </p:nvSpPr>
        <p:spPr>
          <a:xfrm rot="18667629">
            <a:off x="11290411" y="3955056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 rot="18577321">
            <a:off x="11609014" y="3948441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96" name="TextBox 95"/>
          <p:cNvSpPr txBox="1"/>
          <p:nvPr/>
        </p:nvSpPr>
        <p:spPr>
          <a:xfrm rot="18788539">
            <a:off x="11885827" y="3950313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 rot="18698231">
            <a:off x="12172170" y="3944311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98" name="TextBox 97"/>
          <p:cNvSpPr txBox="1"/>
          <p:nvPr/>
        </p:nvSpPr>
        <p:spPr>
          <a:xfrm rot="18788539">
            <a:off x="12389883" y="3950313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 rot="18698231">
            <a:off x="12676226" y="3944311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cxnSp>
        <p:nvCxnSpPr>
          <p:cNvPr id="100" name="直接连接符 99"/>
          <p:cNvCxnSpPr/>
          <p:nvPr/>
        </p:nvCxnSpPr>
        <p:spPr>
          <a:xfrm>
            <a:off x="11603495" y="3807722"/>
            <a:ext cx="48809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>
            <a:off x="12257388" y="3807722"/>
            <a:ext cx="489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直接连接符 101"/>
          <p:cNvCxnSpPr/>
          <p:nvPr/>
        </p:nvCxnSpPr>
        <p:spPr>
          <a:xfrm>
            <a:off x="12867472" y="3807722"/>
            <a:ext cx="489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11479703" y="3591698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Unedited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2186257" y="3576721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p53 KO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2690028" y="3448843"/>
            <a:ext cx="83388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>
                <a:latin typeface="Arial"/>
                <a:cs typeface="Arial"/>
              </a:rPr>
              <a:t>p53/c-Myc</a:t>
            </a:r>
          </a:p>
          <a:p>
            <a:pPr algn="ctr"/>
            <a:r>
              <a:rPr lang="en-US" altLang="zh-CN" sz="1100">
                <a:latin typeface="Arial"/>
                <a:cs typeface="Arial"/>
              </a:rPr>
              <a:t>DKO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2100520" y="3287886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actin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07" name="TextBox 106"/>
          <p:cNvSpPr txBox="1"/>
          <p:nvPr/>
        </p:nvSpPr>
        <p:spPr>
          <a:xfrm rot="18667629">
            <a:off x="8045018" y="3947268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08" name="TextBox 107"/>
          <p:cNvSpPr txBox="1"/>
          <p:nvPr/>
        </p:nvSpPr>
        <p:spPr>
          <a:xfrm rot="18577321">
            <a:off x="8363621" y="3940653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09" name="TextBox 108"/>
          <p:cNvSpPr txBox="1"/>
          <p:nvPr/>
        </p:nvSpPr>
        <p:spPr>
          <a:xfrm rot="18788539">
            <a:off x="8640434" y="3942525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10" name="TextBox 109"/>
          <p:cNvSpPr txBox="1"/>
          <p:nvPr/>
        </p:nvSpPr>
        <p:spPr>
          <a:xfrm rot="18698231">
            <a:off x="8926777" y="3936523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11" name="TextBox 110"/>
          <p:cNvSpPr txBox="1"/>
          <p:nvPr/>
        </p:nvSpPr>
        <p:spPr>
          <a:xfrm rot="18788539">
            <a:off x="9144490" y="3942525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12" name="TextBox 111"/>
          <p:cNvSpPr txBox="1"/>
          <p:nvPr/>
        </p:nvSpPr>
        <p:spPr>
          <a:xfrm rot="18698231">
            <a:off x="9430833" y="3936523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cxnSp>
        <p:nvCxnSpPr>
          <p:cNvPr id="113" name="直接连接符 112"/>
          <p:cNvCxnSpPr/>
          <p:nvPr/>
        </p:nvCxnSpPr>
        <p:spPr>
          <a:xfrm>
            <a:off x="8358102" y="3799934"/>
            <a:ext cx="48809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直接连接符 113"/>
          <p:cNvCxnSpPr/>
          <p:nvPr/>
        </p:nvCxnSpPr>
        <p:spPr>
          <a:xfrm>
            <a:off x="9011995" y="3799934"/>
            <a:ext cx="489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直接连接符 114"/>
          <p:cNvCxnSpPr/>
          <p:nvPr/>
        </p:nvCxnSpPr>
        <p:spPr>
          <a:xfrm>
            <a:off x="9622079" y="3799934"/>
            <a:ext cx="489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8234310" y="3583910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Unedited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8940864" y="3568933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p53 KO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9444635" y="3441055"/>
            <a:ext cx="83388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>
                <a:latin typeface="Arial"/>
                <a:cs typeface="Arial"/>
              </a:rPr>
              <a:t>p53/c-Myc</a:t>
            </a:r>
          </a:p>
          <a:p>
            <a:pPr algn="ctr"/>
            <a:r>
              <a:rPr lang="en-US" altLang="zh-CN" sz="1100">
                <a:latin typeface="Arial"/>
                <a:cs typeface="Arial"/>
              </a:rPr>
              <a:t>DKO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8901896" y="669991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p53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20" name="TextBox 119"/>
          <p:cNvSpPr txBox="1"/>
          <p:nvPr/>
        </p:nvSpPr>
        <p:spPr>
          <a:xfrm rot="18667629">
            <a:off x="4737683" y="3947268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21" name="TextBox 120"/>
          <p:cNvSpPr txBox="1"/>
          <p:nvPr/>
        </p:nvSpPr>
        <p:spPr>
          <a:xfrm rot="18577321">
            <a:off x="5056286" y="3940653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 rot="18788539">
            <a:off x="5333099" y="3942525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23" name="TextBox 122"/>
          <p:cNvSpPr txBox="1"/>
          <p:nvPr/>
        </p:nvSpPr>
        <p:spPr>
          <a:xfrm rot="18698231">
            <a:off x="5619442" y="3936523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 rot="18788539">
            <a:off x="5837155" y="3942525"/>
            <a:ext cx="740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cont miR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25" name="TextBox 124"/>
          <p:cNvSpPr txBox="1"/>
          <p:nvPr/>
        </p:nvSpPr>
        <p:spPr>
          <a:xfrm rot="18698231">
            <a:off x="6123498" y="3936523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miR-874</a:t>
            </a:r>
            <a:endParaRPr lang="zh-CN" altLang="en-US" sz="1100">
              <a:latin typeface="Arial"/>
              <a:cs typeface="Arial"/>
            </a:endParaRPr>
          </a:p>
        </p:txBody>
      </p:sp>
      <p:cxnSp>
        <p:nvCxnSpPr>
          <p:cNvPr id="126" name="直接连接符 125"/>
          <p:cNvCxnSpPr/>
          <p:nvPr/>
        </p:nvCxnSpPr>
        <p:spPr>
          <a:xfrm>
            <a:off x="5050767" y="3799934"/>
            <a:ext cx="48809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直接连接符 126"/>
          <p:cNvCxnSpPr/>
          <p:nvPr/>
        </p:nvCxnSpPr>
        <p:spPr>
          <a:xfrm>
            <a:off x="5704660" y="3799934"/>
            <a:ext cx="489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直接连接符 127"/>
          <p:cNvCxnSpPr/>
          <p:nvPr/>
        </p:nvCxnSpPr>
        <p:spPr>
          <a:xfrm>
            <a:off x="6314744" y="3799934"/>
            <a:ext cx="489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4926975" y="3583910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/>
                <a:cs typeface="Arial"/>
              </a:rPr>
              <a:t>Unedited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633529" y="3568933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/>
                <a:cs typeface="Arial"/>
              </a:rPr>
              <a:t>p53 KO</a:t>
            </a:r>
            <a:endParaRPr lang="zh-CN" altLang="en-US" sz="1100" dirty="0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6137300" y="3441055"/>
            <a:ext cx="83388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>
                <a:latin typeface="Arial"/>
                <a:cs typeface="Arial"/>
              </a:rPr>
              <a:t>p53/c-Myc</a:t>
            </a:r>
          </a:p>
          <a:p>
            <a:pPr algn="ctr"/>
            <a:r>
              <a:rPr lang="en-US" altLang="zh-CN" sz="1100">
                <a:latin typeface="Arial"/>
                <a:cs typeface="Arial"/>
              </a:rPr>
              <a:t>DKO</a:t>
            </a:r>
            <a:endParaRPr lang="zh-CN" altLang="en-US" sz="1100">
              <a:latin typeface="Arial"/>
              <a:cs typeface="Arial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547792" y="3280098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c-Myc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33" name="右箭头 132"/>
          <p:cNvSpPr/>
          <p:nvPr/>
        </p:nvSpPr>
        <p:spPr>
          <a:xfrm>
            <a:off x="4140065" y="4818322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3689953" y="471582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35" name="右箭头 134"/>
          <p:cNvSpPr/>
          <p:nvPr/>
        </p:nvSpPr>
        <p:spPr>
          <a:xfrm>
            <a:off x="7484542" y="4527873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7034430" y="4425377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37" name="右箭头 136"/>
          <p:cNvSpPr/>
          <p:nvPr/>
        </p:nvSpPr>
        <p:spPr>
          <a:xfrm>
            <a:off x="10755903" y="4632806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0305791" y="453031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59210" y="6572573"/>
            <a:ext cx="1162051" cy="522356"/>
          </a:xfrm>
          <a:prstGeom prst="rect">
            <a:avLst/>
          </a:prstGeom>
          <a:noFill/>
        </p:spPr>
        <p:txBody>
          <a:bodyPr wrap="none" lIns="151544" tIns="75772" rIns="151544" bIns="75772" rtlCol="0">
            <a:spAutoFit/>
          </a:bodyPr>
          <a:lstStyle/>
          <a:p>
            <a:r>
              <a:rPr lang="en-US" altLang="zh-CN" sz="2400" dirty="0">
                <a:latin typeface="Arial"/>
                <a:cs typeface="Arial"/>
              </a:rPr>
              <a:t>Fig.5d</a:t>
            </a:r>
            <a:endParaRPr lang="zh-CN" altLang="en-US" sz="2400" dirty="0">
              <a:latin typeface="Arial"/>
              <a:cs typeface="Arial"/>
            </a:endParaRPr>
          </a:p>
        </p:txBody>
      </p:sp>
      <p:pic>
        <p:nvPicPr>
          <p:cNvPr id="1035" name="Picture 11" descr="C:\Users\user\Desktop\WB original\Exp2021_56_original picture_for figure\20210716_1340_5 cMyc for PS.ti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20" t="24881" r="22092" b="19907"/>
          <a:stretch/>
        </p:blipFill>
        <p:spPr bwMode="auto">
          <a:xfrm>
            <a:off x="4315309" y="7096521"/>
            <a:ext cx="2880000" cy="20749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2" name="右箭头 141"/>
          <p:cNvSpPr/>
          <p:nvPr/>
        </p:nvSpPr>
        <p:spPr>
          <a:xfrm>
            <a:off x="4178783" y="7914608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728671" y="781211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44" name="文本框 16">
            <a:extLst>
              <a:ext uri="{FF2B5EF4-FFF2-40B4-BE49-F238E27FC236}">
                <a16:creationId xmlns:a16="http://schemas.microsoft.com/office/drawing/2014/main" id="{2B8C1E62-8820-4F17-BA3E-1ED3ECE2054B}"/>
              </a:ext>
            </a:extLst>
          </p:cNvPr>
          <p:cNvSpPr txBox="1"/>
          <p:nvPr/>
        </p:nvSpPr>
        <p:spPr>
          <a:xfrm>
            <a:off x="4990567" y="7178403"/>
            <a:ext cx="525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17">
            <a:extLst>
              <a:ext uri="{FF2B5EF4-FFF2-40B4-BE49-F238E27FC236}">
                <a16:creationId xmlns:a16="http://schemas.microsoft.com/office/drawing/2014/main" id="{0F7B9B80-8F5F-4036-A2B5-2E3131257E8D}"/>
              </a:ext>
            </a:extLst>
          </p:cNvPr>
          <p:cNvSpPr txBox="1"/>
          <p:nvPr/>
        </p:nvSpPr>
        <p:spPr>
          <a:xfrm>
            <a:off x="5426158" y="7178843"/>
            <a:ext cx="822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8">
            <a:extLst>
              <a:ext uri="{FF2B5EF4-FFF2-40B4-BE49-F238E27FC236}">
                <a16:creationId xmlns:a16="http://schemas.microsoft.com/office/drawing/2014/main" id="{61D4B624-7164-45C4-9431-36DA75C05ED2}"/>
              </a:ext>
            </a:extLst>
          </p:cNvPr>
          <p:cNvSpPr txBox="1"/>
          <p:nvPr/>
        </p:nvSpPr>
        <p:spPr>
          <a:xfrm>
            <a:off x="5909249" y="7024514"/>
            <a:ext cx="758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874</a:t>
            </a:r>
          </a:p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GGPP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接连接符 146"/>
          <p:cNvCxnSpPr/>
          <p:nvPr/>
        </p:nvCxnSpPr>
        <p:spPr>
          <a:xfrm>
            <a:off x="4965900" y="7370160"/>
            <a:ext cx="4625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直接连接符 147"/>
          <p:cNvCxnSpPr/>
          <p:nvPr/>
        </p:nvCxnSpPr>
        <p:spPr>
          <a:xfrm>
            <a:off x="5523109" y="7370160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直接连接符 148"/>
          <p:cNvCxnSpPr/>
          <p:nvPr/>
        </p:nvCxnSpPr>
        <p:spPr>
          <a:xfrm>
            <a:off x="6082164" y="7370160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5371778" y="6699919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c-Myc</a:t>
            </a:r>
            <a:endParaRPr lang="zh-CN" altLang="en-US" sz="1600">
              <a:latin typeface="Arial"/>
              <a:cs typeface="Arial"/>
            </a:endParaRPr>
          </a:p>
        </p:txBody>
      </p:sp>
      <p:pic>
        <p:nvPicPr>
          <p:cNvPr id="1036" name="Picture 12" descr="C:\Users\user\Desktop\WB original\Exp2021_56_original picture_for figure\20210706_1335_6 p53 pptコピー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31" t="33828" r="26253" b="5931"/>
          <a:stretch/>
        </p:blipFill>
        <p:spPr bwMode="auto">
          <a:xfrm>
            <a:off x="7640994" y="6959979"/>
            <a:ext cx="2880000" cy="2169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3" name="右箭头 152"/>
          <p:cNvSpPr/>
          <p:nvPr/>
        </p:nvSpPr>
        <p:spPr>
          <a:xfrm>
            <a:off x="7592463" y="7876261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7152557" y="7776108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9007527" y="322957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p53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56" name="文本框 16">
            <a:extLst>
              <a:ext uri="{FF2B5EF4-FFF2-40B4-BE49-F238E27FC236}">
                <a16:creationId xmlns:a16="http://schemas.microsoft.com/office/drawing/2014/main" id="{2B8C1E62-8820-4F17-BA3E-1ED3ECE2054B}"/>
              </a:ext>
            </a:extLst>
          </p:cNvPr>
          <p:cNvSpPr txBox="1"/>
          <p:nvPr/>
        </p:nvSpPr>
        <p:spPr>
          <a:xfrm>
            <a:off x="8300843" y="7137893"/>
            <a:ext cx="525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7">
            <a:extLst>
              <a:ext uri="{FF2B5EF4-FFF2-40B4-BE49-F238E27FC236}">
                <a16:creationId xmlns:a16="http://schemas.microsoft.com/office/drawing/2014/main" id="{0F7B9B80-8F5F-4036-A2B5-2E3131257E8D}"/>
              </a:ext>
            </a:extLst>
          </p:cNvPr>
          <p:cNvSpPr txBox="1"/>
          <p:nvPr/>
        </p:nvSpPr>
        <p:spPr>
          <a:xfrm>
            <a:off x="8736434" y="7138333"/>
            <a:ext cx="822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8">
            <a:extLst>
              <a:ext uri="{FF2B5EF4-FFF2-40B4-BE49-F238E27FC236}">
                <a16:creationId xmlns:a16="http://schemas.microsoft.com/office/drawing/2014/main" id="{61D4B624-7164-45C4-9431-36DA75C05ED2}"/>
              </a:ext>
            </a:extLst>
          </p:cNvPr>
          <p:cNvSpPr txBox="1"/>
          <p:nvPr/>
        </p:nvSpPr>
        <p:spPr>
          <a:xfrm>
            <a:off x="9219525" y="6984004"/>
            <a:ext cx="758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874</a:t>
            </a:r>
          </a:p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GGPP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直接连接符 158"/>
          <p:cNvCxnSpPr/>
          <p:nvPr/>
        </p:nvCxnSpPr>
        <p:spPr>
          <a:xfrm>
            <a:off x="8276176" y="7329650"/>
            <a:ext cx="4625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直接连接符 159"/>
          <p:cNvCxnSpPr/>
          <p:nvPr/>
        </p:nvCxnSpPr>
        <p:spPr>
          <a:xfrm>
            <a:off x="8833385" y="7329650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直接连接符 160"/>
          <p:cNvCxnSpPr/>
          <p:nvPr/>
        </p:nvCxnSpPr>
        <p:spPr>
          <a:xfrm>
            <a:off x="9392440" y="7329650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38" name="Picture 14" descr="C:\Users\user\Desktop\WB original\Exp2021_56_original picture_for figure\20210717_1444_4 SREBF2 for PS ppt.tif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29" t="10298" r="24631" b="13700"/>
          <a:stretch/>
        </p:blipFill>
        <p:spPr bwMode="auto">
          <a:xfrm>
            <a:off x="11276754" y="6808314"/>
            <a:ext cx="2880000" cy="27563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4" name="TextBox 163"/>
          <p:cNvSpPr txBox="1"/>
          <p:nvPr/>
        </p:nvSpPr>
        <p:spPr>
          <a:xfrm>
            <a:off x="12528387" y="6664474"/>
            <a:ext cx="9909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SREBP2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65" name="文本框 16">
            <a:extLst>
              <a:ext uri="{FF2B5EF4-FFF2-40B4-BE49-F238E27FC236}">
                <a16:creationId xmlns:a16="http://schemas.microsoft.com/office/drawing/2014/main" id="{2B8C1E62-8820-4F17-BA3E-1ED3ECE2054B}"/>
              </a:ext>
            </a:extLst>
          </p:cNvPr>
          <p:cNvSpPr txBox="1"/>
          <p:nvPr/>
        </p:nvSpPr>
        <p:spPr>
          <a:xfrm>
            <a:off x="11927334" y="7102448"/>
            <a:ext cx="525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7">
            <a:extLst>
              <a:ext uri="{FF2B5EF4-FFF2-40B4-BE49-F238E27FC236}">
                <a16:creationId xmlns:a16="http://schemas.microsoft.com/office/drawing/2014/main" id="{0F7B9B80-8F5F-4036-A2B5-2E3131257E8D}"/>
              </a:ext>
            </a:extLst>
          </p:cNvPr>
          <p:cNvSpPr txBox="1"/>
          <p:nvPr/>
        </p:nvSpPr>
        <p:spPr>
          <a:xfrm>
            <a:off x="12362925" y="7102888"/>
            <a:ext cx="822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8">
            <a:extLst>
              <a:ext uri="{FF2B5EF4-FFF2-40B4-BE49-F238E27FC236}">
                <a16:creationId xmlns:a16="http://schemas.microsoft.com/office/drawing/2014/main" id="{61D4B624-7164-45C4-9431-36DA75C05ED2}"/>
              </a:ext>
            </a:extLst>
          </p:cNvPr>
          <p:cNvSpPr txBox="1"/>
          <p:nvPr/>
        </p:nvSpPr>
        <p:spPr>
          <a:xfrm>
            <a:off x="12846016" y="6948559"/>
            <a:ext cx="758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874</a:t>
            </a:r>
          </a:p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GGPP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直接连接符 167"/>
          <p:cNvCxnSpPr/>
          <p:nvPr/>
        </p:nvCxnSpPr>
        <p:spPr>
          <a:xfrm>
            <a:off x="11902667" y="7294205"/>
            <a:ext cx="4625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直接连接符 168"/>
          <p:cNvCxnSpPr/>
          <p:nvPr/>
        </p:nvCxnSpPr>
        <p:spPr>
          <a:xfrm>
            <a:off x="12459876" y="7294205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直接连接符 169"/>
          <p:cNvCxnSpPr/>
          <p:nvPr/>
        </p:nvCxnSpPr>
        <p:spPr>
          <a:xfrm>
            <a:off x="13018931" y="7294205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39" name="Picture 15" descr="C:\Users\user\Desktop\WB original\Exp2021_56_original picture_for figure\20210716_1429_30 PMVK ppt and PS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22" t="22234" r="26561" b="33776"/>
          <a:stretch/>
        </p:blipFill>
        <p:spPr bwMode="auto">
          <a:xfrm>
            <a:off x="4025614" y="9663098"/>
            <a:ext cx="3387018" cy="18287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3" name="文本框 16">
            <a:extLst>
              <a:ext uri="{FF2B5EF4-FFF2-40B4-BE49-F238E27FC236}">
                <a16:creationId xmlns:a16="http://schemas.microsoft.com/office/drawing/2014/main" id="{2B8C1E62-8820-4F17-BA3E-1ED3ECE2054B}"/>
              </a:ext>
            </a:extLst>
          </p:cNvPr>
          <p:cNvSpPr txBox="1"/>
          <p:nvPr/>
        </p:nvSpPr>
        <p:spPr>
          <a:xfrm>
            <a:off x="4881445" y="9591230"/>
            <a:ext cx="525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">
            <a:extLst>
              <a:ext uri="{FF2B5EF4-FFF2-40B4-BE49-F238E27FC236}">
                <a16:creationId xmlns:a16="http://schemas.microsoft.com/office/drawing/2014/main" id="{0F7B9B80-8F5F-4036-A2B5-2E3131257E8D}"/>
              </a:ext>
            </a:extLst>
          </p:cNvPr>
          <p:cNvSpPr txBox="1"/>
          <p:nvPr/>
        </p:nvSpPr>
        <p:spPr>
          <a:xfrm>
            <a:off x="5340945" y="9591670"/>
            <a:ext cx="822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8">
            <a:extLst>
              <a:ext uri="{FF2B5EF4-FFF2-40B4-BE49-F238E27FC236}">
                <a16:creationId xmlns:a16="http://schemas.microsoft.com/office/drawing/2014/main" id="{61D4B624-7164-45C4-9431-36DA75C05ED2}"/>
              </a:ext>
            </a:extLst>
          </p:cNvPr>
          <p:cNvSpPr txBox="1"/>
          <p:nvPr/>
        </p:nvSpPr>
        <p:spPr>
          <a:xfrm>
            <a:off x="5909249" y="9437341"/>
            <a:ext cx="758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874</a:t>
            </a:r>
          </a:p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GGPP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直接连接符 175"/>
          <p:cNvCxnSpPr/>
          <p:nvPr/>
        </p:nvCxnSpPr>
        <p:spPr>
          <a:xfrm>
            <a:off x="4856778" y="9782987"/>
            <a:ext cx="4625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直接连接符 176"/>
          <p:cNvCxnSpPr/>
          <p:nvPr/>
        </p:nvCxnSpPr>
        <p:spPr>
          <a:xfrm>
            <a:off x="5437896" y="9782987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直接连接符 177"/>
          <p:cNvCxnSpPr/>
          <p:nvPr/>
        </p:nvCxnSpPr>
        <p:spPr>
          <a:xfrm>
            <a:off x="6082164" y="9782987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/>
          <p:cNvSpPr txBox="1"/>
          <p:nvPr/>
        </p:nvSpPr>
        <p:spPr>
          <a:xfrm>
            <a:off x="5262656" y="9112746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PMVK</a:t>
            </a:r>
            <a:endParaRPr lang="zh-CN" altLang="en-US" sz="1600">
              <a:latin typeface="Arial"/>
              <a:cs typeface="Arial"/>
            </a:endParaRPr>
          </a:p>
        </p:txBody>
      </p:sp>
      <p:pic>
        <p:nvPicPr>
          <p:cNvPr id="1040" name="Picture 16" descr="C:\Users\user\Desktop\WB original\Exp2021_56_original picture_for figure\20210710_1940_16 actin for PS.tif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42" t="15113" r="30729" b="17632"/>
          <a:stretch/>
        </p:blipFill>
        <p:spPr bwMode="auto">
          <a:xfrm>
            <a:off x="7943514" y="9112746"/>
            <a:ext cx="2972880" cy="26224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1" name="文本框 16">
            <a:extLst>
              <a:ext uri="{FF2B5EF4-FFF2-40B4-BE49-F238E27FC236}">
                <a16:creationId xmlns:a16="http://schemas.microsoft.com/office/drawing/2014/main" id="{2B8C1E62-8820-4F17-BA3E-1ED3ECE2054B}"/>
              </a:ext>
            </a:extLst>
          </p:cNvPr>
          <p:cNvSpPr txBox="1"/>
          <p:nvPr/>
        </p:nvSpPr>
        <p:spPr>
          <a:xfrm>
            <a:off x="8667566" y="9194627"/>
            <a:ext cx="525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7">
            <a:extLst>
              <a:ext uri="{FF2B5EF4-FFF2-40B4-BE49-F238E27FC236}">
                <a16:creationId xmlns:a16="http://schemas.microsoft.com/office/drawing/2014/main" id="{0F7B9B80-8F5F-4036-A2B5-2E3131257E8D}"/>
              </a:ext>
            </a:extLst>
          </p:cNvPr>
          <p:cNvSpPr txBox="1"/>
          <p:nvPr/>
        </p:nvSpPr>
        <p:spPr>
          <a:xfrm>
            <a:off x="9116122" y="9195067"/>
            <a:ext cx="822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874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本框 18">
            <a:extLst>
              <a:ext uri="{FF2B5EF4-FFF2-40B4-BE49-F238E27FC236}">
                <a16:creationId xmlns:a16="http://schemas.microsoft.com/office/drawing/2014/main" id="{61D4B624-7164-45C4-9431-36DA75C05ED2}"/>
              </a:ext>
            </a:extLst>
          </p:cNvPr>
          <p:cNvSpPr txBox="1"/>
          <p:nvPr/>
        </p:nvSpPr>
        <p:spPr>
          <a:xfrm>
            <a:off x="9639825" y="9040738"/>
            <a:ext cx="758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874</a:t>
            </a:r>
          </a:p>
          <a:p>
            <a:pPr algn="ct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GGPP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直接连接符 183"/>
          <p:cNvCxnSpPr/>
          <p:nvPr/>
        </p:nvCxnSpPr>
        <p:spPr>
          <a:xfrm>
            <a:off x="8642899" y="9386384"/>
            <a:ext cx="4625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5" name="直接连接符 184"/>
          <p:cNvCxnSpPr/>
          <p:nvPr/>
        </p:nvCxnSpPr>
        <p:spPr>
          <a:xfrm>
            <a:off x="9213073" y="9386384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6" name="直接连接符 185"/>
          <p:cNvCxnSpPr/>
          <p:nvPr/>
        </p:nvCxnSpPr>
        <p:spPr>
          <a:xfrm>
            <a:off x="9812740" y="9386384"/>
            <a:ext cx="46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TextBox 186"/>
          <p:cNvSpPr txBox="1"/>
          <p:nvPr/>
        </p:nvSpPr>
        <p:spPr>
          <a:xfrm>
            <a:off x="9217736" y="8774192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actin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88" name="右箭头 187"/>
          <p:cNvSpPr/>
          <p:nvPr/>
        </p:nvSpPr>
        <p:spPr>
          <a:xfrm>
            <a:off x="3883040" y="9885483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89" name="右箭头 188"/>
          <p:cNvSpPr/>
          <p:nvPr/>
        </p:nvSpPr>
        <p:spPr>
          <a:xfrm>
            <a:off x="7819646" y="9996887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7369534" y="9894391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62" name="TextBox 142">
            <a:extLst>
              <a:ext uri="{FF2B5EF4-FFF2-40B4-BE49-F238E27FC236}">
                <a16:creationId xmlns:a16="http://schemas.microsoft.com/office/drawing/2014/main" id="{500F04F7-50E2-54A7-FE7B-69374DAF6A0A}"/>
              </a:ext>
            </a:extLst>
          </p:cNvPr>
          <p:cNvSpPr txBox="1"/>
          <p:nvPr/>
        </p:nvSpPr>
        <p:spPr>
          <a:xfrm>
            <a:off x="3397853" y="9782987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3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63" name="右箭头 141">
            <a:extLst>
              <a:ext uri="{FF2B5EF4-FFF2-40B4-BE49-F238E27FC236}">
                <a16:creationId xmlns:a16="http://schemas.microsoft.com/office/drawing/2014/main" id="{B4AA04ED-CA5F-3121-624B-E2E9F588357E}"/>
              </a:ext>
            </a:extLst>
          </p:cNvPr>
          <p:cNvSpPr/>
          <p:nvPr/>
        </p:nvSpPr>
        <p:spPr>
          <a:xfrm>
            <a:off x="11165615" y="7982734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72" name="TextBox 142">
            <a:extLst>
              <a:ext uri="{FF2B5EF4-FFF2-40B4-BE49-F238E27FC236}">
                <a16:creationId xmlns:a16="http://schemas.microsoft.com/office/drawing/2014/main" id="{6E79E872-BDD8-ABB6-0194-32C61969FBEE}"/>
              </a:ext>
            </a:extLst>
          </p:cNvPr>
          <p:cNvSpPr txBox="1"/>
          <p:nvPr/>
        </p:nvSpPr>
        <p:spPr>
          <a:xfrm>
            <a:off x="10715503" y="7880238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3EB7E34-C891-B391-4A3E-EEA61D932587}"/>
              </a:ext>
            </a:extLst>
          </p:cNvPr>
          <p:cNvSpPr txBox="1"/>
          <p:nvPr/>
        </p:nvSpPr>
        <p:spPr>
          <a:xfrm>
            <a:off x="3759522" y="360246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3B5E596A-3DA8-0145-9B49-DF62EE696F32}"/>
              </a:ext>
            </a:extLst>
          </p:cNvPr>
          <p:cNvSpPr txBox="1"/>
          <p:nvPr/>
        </p:nvSpPr>
        <p:spPr>
          <a:xfrm>
            <a:off x="11179977" y="36528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5433782E-60BE-CB70-6DE4-686D6DCB2B5E}"/>
              </a:ext>
            </a:extLst>
          </p:cNvPr>
          <p:cNvSpPr txBox="1"/>
          <p:nvPr/>
        </p:nvSpPr>
        <p:spPr>
          <a:xfrm>
            <a:off x="7394794" y="337530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F5F952AA-D936-B90D-24CB-A935D054E916}"/>
              </a:ext>
            </a:extLst>
          </p:cNvPr>
          <p:cNvSpPr txBox="1"/>
          <p:nvPr/>
        </p:nvSpPr>
        <p:spPr>
          <a:xfrm>
            <a:off x="10533711" y="3430021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id="{2F47CB4A-047B-204A-6782-69AAF6F4AEC9}"/>
              </a:ext>
            </a:extLst>
          </p:cNvPr>
          <p:cNvSpPr txBox="1"/>
          <p:nvPr/>
        </p:nvSpPr>
        <p:spPr>
          <a:xfrm>
            <a:off x="7296221" y="3469283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3D7D5BD8-325F-408F-5C74-892BD1CD49AD}"/>
              </a:ext>
            </a:extLst>
          </p:cNvPr>
          <p:cNvSpPr txBox="1"/>
          <p:nvPr/>
        </p:nvSpPr>
        <p:spPr>
          <a:xfrm>
            <a:off x="3670449" y="3666954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03FD2315-2C7C-AF8F-C520-32FF23519235}"/>
              </a:ext>
            </a:extLst>
          </p:cNvPr>
          <p:cNvSpPr txBox="1"/>
          <p:nvPr/>
        </p:nvSpPr>
        <p:spPr>
          <a:xfrm>
            <a:off x="7396605" y="6790293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8A121EC7-481D-7828-5287-9C277F741E3E}"/>
              </a:ext>
            </a:extLst>
          </p:cNvPr>
          <p:cNvSpPr txBox="1"/>
          <p:nvPr/>
        </p:nvSpPr>
        <p:spPr>
          <a:xfrm>
            <a:off x="4015047" y="6884584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B87555C7-E9DE-D3F9-B38A-119A2AEC71DF}"/>
              </a:ext>
            </a:extLst>
          </p:cNvPr>
          <p:cNvSpPr txBox="1"/>
          <p:nvPr/>
        </p:nvSpPr>
        <p:spPr>
          <a:xfrm>
            <a:off x="3639023" y="9526458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id="{BBFFD228-E20E-216C-AB28-A270FD9467A5}"/>
              </a:ext>
            </a:extLst>
          </p:cNvPr>
          <p:cNvSpPr txBox="1"/>
          <p:nvPr/>
        </p:nvSpPr>
        <p:spPr>
          <a:xfrm>
            <a:off x="7473132" y="9191560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D5B593D2-7B4E-3BDD-9E0E-8C7F4C5FA2CB}"/>
              </a:ext>
            </a:extLst>
          </p:cNvPr>
          <p:cNvSpPr txBox="1"/>
          <p:nvPr/>
        </p:nvSpPr>
        <p:spPr>
          <a:xfrm>
            <a:off x="10808246" y="6616952"/>
            <a:ext cx="4956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0%</a:t>
            </a:r>
            <a:endParaRPr lang="zh-CN" alt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3504863" y="1403768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CB569B2-46AD-7C9B-6D58-42538A98131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50145" y="4051527"/>
            <a:ext cx="2567588" cy="194587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100070A-F0DA-FDF7-1BB3-ABA2B895D32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814" y="7274335"/>
            <a:ext cx="3492500" cy="27432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FF5A9733-0FBA-AB29-8DD1-D57DD2A0B1C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55230" y="1598942"/>
            <a:ext cx="3459916" cy="1354340"/>
          </a:xfrm>
          <a:prstGeom prst="rect">
            <a:avLst/>
          </a:prstGeom>
        </p:spPr>
      </p:pic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597D6364-54CB-983C-168D-B906B9C74AAB}"/>
              </a:ext>
            </a:extLst>
          </p:cNvPr>
          <p:cNvSpPr txBox="1"/>
          <p:nvPr/>
        </p:nvSpPr>
        <p:spPr>
          <a:xfrm>
            <a:off x="81214" y="11510970"/>
            <a:ext cx="786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mages of the whole membranes from the western blot analyses presented in Fig.3a, 3d and 5d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1332991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C:\Users\user\Desktop\WB original\Fig.6 B\☆Exp2021_59_original image\20210707_1415_20 PMVK_pptコピー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92" t="23170" r="14299" b="34625"/>
          <a:stretch/>
        </p:blipFill>
        <p:spPr bwMode="auto">
          <a:xfrm>
            <a:off x="5091906" y="1495206"/>
            <a:ext cx="4672360" cy="17810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user\Desktop\WB original\Fig.6 B\☆Exp2021_59_original image\20210707_1359_18_cMyc_PSコピー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26" t="26256" r="14066" b="29695"/>
          <a:stretch/>
        </p:blipFill>
        <p:spPr bwMode="auto">
          <a:xfrm>
            <a:off x="9984410" y="1408044"/>
            <a:ext cx="4676400" cy="19177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12960512" y="12608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3509475" y="12608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12111587" y="1291633"/>
            <a:ext cx="160641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2585214" y="1036313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PMVK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10853794" y="1601344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11366913" y="1601344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11890610" y="1601344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12433774" y="1601344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12929018" y="1601344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13476378" y="1601344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10802380" y="115313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noTF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1248800" y="1082345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_cont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0419850" y="1407890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GGPP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0946202" y="133479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1459321" y="133479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002422" y="133479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3021426" y="133479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2531793" y="139635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561573" y="139635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941508" y="12608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2479695" y="12608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982229" y="635114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c-Myc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128464" y="12415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677427" y="12415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7279539" y="1272321"/>
            <a:ext cx="160641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7753166" y="1017001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PMVK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6021746" y="158203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6534865" y="158203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7058562" y="158203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7601726" y="158203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8096970" y="158203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8644330" y="158203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 rot="16200000">
            <a:off x="5970332" y="1133822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noTF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6416752" y="106303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_cont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587802" y="1388578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GGPP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114154" y="131548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627273" y="131548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170374" y="131548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8189378" y="131548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699745" y="137704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8729525" y="137704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109460" y="12415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647647" y="12415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150181" y="615802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PMVK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58" name="右箭头 57"/>
          <p:cNvSpPr/>
          <p:nvPr/>
        </p:nvSpPr>
        <p:spPr>
          <a:xfrm>
            <a:off x="9918918" y="2446490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9468806" y="234399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60" name="右箭头 59"/>
          <p:cNvSpPr/>
          <p:nvPr/>
        </p:nvSpPr>
        <p:spPr>
          <a:xfrm>
            <a:off x="5099363" y="1775848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pic>
        <p:nvPicPr>
          <p:cNvPr id="2053" name="Picture 5" descr="C:\Users\user\Desktop\WB original\Fig.6 B\☆Exp2021_59_original image\20210708_1153_3 p53_pptコピー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67" t="19401" r="12794" b="43255"/>
          <a:stretch/>
        </p:blipFill>
        <p:spPr bwMode="auto">
          <a:xfrm>
            <a:off x="965707" y="4460231"/>
            <a:ext cx="4676400" cy="15896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2" name="TextBox 61"/>
          <p:cNvSpPr txBox="1"/>
          <p:nvPr/>
        </p:nvSpPr>
        <p:spPr>
          <a:xfrm>
            <a:off x="3949562" y="41498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498525" y="41498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64" name="直接连接符 63"/>
          <p:cNvCxnSpPr/>
          <p:nvPr/>
        </p:nvCxnSpPr>
        <p:spPr>
          <a:xfrm>
            <a:off x="3100637" y="4180646"/>
            <a:ext cx="160641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3574264" y="3925326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PMVK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66" name="直接连接符 65"/>
          <p:cNvCxnSpPr/>
          <p:nvPr/>
        </p:nvCxnSpPr>
        <p:spPr>
          <a:xfrm>
            <a:off x="1913004" y="4490357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2417060" y="4490357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2921116" y="4490357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3422824" y="4490357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3918068" y="4490357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4465428" y="4490357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 rot="16200000">
            <a:off x="1861590" y="404214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noTF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 rot="16200000">
            <a:off x="2298947" y="3971358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_cont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1408900" y="4296903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GGPP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005412" y="422381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509468" y="422381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032928" y="422381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010476" y="422381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520843" y="428536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550623" y="428536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972014" y="41498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468745" y="41498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953976" y="364013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/>
                <a:cs typeface="Arial"/>
              </a:rPr>
              <a:t>p53</a:t>
            </a:r>
            <a:endParaRPr lang="zh-CN" altLang="en-US" sz="1600" dirty="0">
              <a:latin typeface="Arial"/>
              <a:cs typeface="Arial"/>
            </a:endParaRPr>
          </a:p>
        </p:txBody>
      </p:sp>
      <p:sp>
        <p:nvSpPr>
          <p:cNvPr id="84" name="右箭头 83"/>
          <p:cNvSpPr/>
          <p:nvPr/>
        </p:nvSpPr>
        <p:spPr>
          <a:xfrm>
            <a:off x="892342" y="5450572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42230" y="534807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pic>
        <p:nvPicPr>
          <p:cNvPr id="2054" name="Picture 6" descr="C:\Users\user\Desktop\WB original\Fig.6 B\☆Exp2021_59_original image\20210722_1420_20 for p21新サンプル_PSコピーこれを使用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8" t="22952" r="24317" b="40723"/>
          <a:stretch/>
        </p:blipFill>
        <p:spPr bwMode="auto">
          <a:xfrm>
            <a:off x="7490562" y="4438515"/>
            <a:ext cx="4676400" cy="1641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7" name="右箭头 86"/>
          <p:cNvSpPr/>
          <p:nvPr/>
        </p:nvSpPr>
        <p:spPr>
          <a:xfrm>
            <a:off x="7256910" y="5025120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806798" y="492262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2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10507608" y="41127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1056571" y="41127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113" name="直接连接符 112"/>
          <p:cNvCxnSpPr/>
          <p:nvPr/>
        </p:nvCxnSpPr>
        <p:spPr>
          <a:xfrm>
            <a:off x="9446910" y="4143502"/>
            <a:ext cx="18181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10132310" y="3888182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PMVK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115" name="直接连接符 114"/>
          <p:cNvCxnSpPr/>
          <p:nvPr/>
        </p:nvCxnSpPr>
        <p:spPr>
          <a:xfrm>
            <a:off x="8183018" y="4453213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直接连接符 115"/>
          <p:cNvCxnSpPr/>
          <p:nvPr/>
        </p:nvCxnSpPr>
        <p:spPr>
          <a:xfrm>
            <a:off x="8759034" y="4453213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直接连接符 116"/>
          <p:cNvCxnSpPr/>
          <p:nvPr/>
        </p:nvCxnSpPr>
        <p:spPr>
          <a:xfrm>
            <a:off x="9335098" y="4453213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直接连接符 117"/>
          <p:cNvCxnSpPr/>
          <p:nvPr/>
        </p:nvCxnSpPr>
        <p:spPr>
          <a:xfrm>
            <a:off x="9911210" y="4453213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直接连接符 118"/>
          <p:cNvCxnSpPr/>
          <p:nvPr/>
        </p:nvCxnSpPr>
        <p:spPr>
          <a:xfrm>
            <a:off x="10476114" y="4453213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直接连接符 119"/>
          <p:cNvCxnSpPr/>
          <p:nvPr/>
        </p:nvCxnSpPr>
        <p:spPr>
          <a:xfrm>
            <a:off x="11023474" y="4453213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 rot="16200000">
            <a:off x="8131604" y="400500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noTF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 rot="16200000">
            <a:off x="8640921" y="3934214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_cont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678914" y="4259759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GGPP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8275426" y="418666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8851442" y="418666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9446910" y="418666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0568522" y="418666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0009229" y="424822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1108669" y="424822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9385996" y="41127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9957131" y="41127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9423112" y="346767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p21</a:t>
            </a:r>
            <a:endParaRPr lang="zh-CN" altLang="en-US" sz="1600">
              <a:latin typeface="Arial"/>
              <a:cs typeface="Arial"/>
            </a:endParaRPr>
          </a:p>
        </p:txBody>
      </p:sp>
      <p:pic>
        <p:nvPicPr>
          <p:cNvPr id="2055" name="Picture 7" descr="C:\Users\user\Desktop\WB original\Fig.6 B\☆Exp2021_59_original image\20210709_1023_13 actin定量&amp;ppt cmycのreblot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93" t="40326" r="16385" b="19614"/>
          <a:stretch/>
        </p:blipFill>
        <p:spPr bwMode="auto">
          <a:xfrm>
            <a:off x="965707" y="6895423"/>
            <a:ext cx="4676400" cy="17634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1" name="TextBox 200"/>
          <p:cNvSpPr txBox="1"/>
          <p:nvPr/>
        </p:nvSpPr>
        <p:spPr>
          <a:xfrm>
            <a:off x="3949372" y="686671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4498335" y="686671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2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203" name="直接连接符 202"/>
          <p:cNvCxnSpPr/>
          <p:nvPr/>
        </p:nvCxnSpPr>
        <p:spPr>
          <a:xfrm>
            <a:off x="2888674" y="6897491"/>
            <a:ext cx="18181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203"/>
          <p:cNvSpPr txBox="1"/>
          <p:nvPr/>
        </p:nvSpPr>
        <p:spPr>
          <a:xfrm>
            <a:off x="3574074" y="6642171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PMVK</a:t>
            </a:r>
            <a:endParaRPr lang="zh-CN" altLang="en-US" sz="1200">
              <a:latin typeface="Arial"/>
              <a:cs typeface="Arial"/>
            </a:endParaRPr>
          </a:p>
        </p:txBody>
      </p:sp>
      <p:cxnSp>
        <p:nvCxnSpPr>
          <p:cNvPr id="205" name="直接连接符 204"/>
          <p:cNvCxnSpPr/>
          <p:nvPr/>
        </p:nvCxnSpPr>
        <p:spPr>
          <a:xfrm>
            <a:off x="1788799" y="720720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6" name="直接连接符 205"/>
          <p:cNvCxnSpPr/>
          <p:nvPr/>
        </p:nvCxnSpPr>
        <p:spPr>
          <a:xfrm>
            <a:off x="2364815" y="720720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7" name="直接连接符 206"/>
          <p:cNvCxnSpPr/>
          <p:nvPr/>
        </p:nvCxnSpPr>
        <p:spPr>
          <a:xfrm>
            <a:off x="2868919" y="720720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8" name="直接连接符 207"/>
          <p:cNvCxnSpPr/>
          <p:nvPr/>
        </p:nvCxnSpPr>
        <p:spPr>
          <a:xfrm>
            <a:off x="3372927" y="720720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9" name="直接连接符 208"/>
          <p:cNvCxnSpPr/>
          <p:nvPr/>
        </p:nvCxnSpPr>
        <p:spPr>
          <a:xfrm>
            <a:off x="3917878" y="720720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0" name="直接连接符 209"/>
          <p:cNvCxnSpPr/>
          <p:nvPr/>
        </p:nvCxnSpPr>
        <p:spPr>
          <a:xfrm>
            <a:off x="4465238" y="7207202"/>
            <a:ext cx="43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TextBox 210"/>
          <p:cNvSpPr txBox="1"/>
          <p:nvPr/>
        </p:nvSpPr>
        <p:spPr>
          <a:xfrm rot="16200000">
            <a:off x="1737385" y="6758992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noTF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12" name="TextBox 211"/>
          <p:cNvSpPr txBox="1"/>
          <p:nvPr/>
        </p:nvSpPr>
        <p:spPr>
          <a:xfrm rot="16200000">
            <a:off x="2246702" y="668820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si_cont</a:t>
            </a:r>
          </a:p>
        </p:txBody>
      </p:sp>
      <p:sp>
        <p:nvSpPr>
          <p:cNvPr id="213" name="TextBox 212"/>
          <p:cNvSpPr txBox="1"/>
          <p:nvPr/>
        </p:nvSpPr>
        <p:spPr>
          <a:xfrm>
            <a:off x="1320226" y="7013748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GGPP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1881207" y="694065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2457223" y="694065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2980731" y="694065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4010286" y="694065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-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3470946" y="700221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4550433" y="700221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+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2919817" y="686671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3418848" y="686671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/>
                <a:cs typeface="Arial"/>
              </a:rPr>
              <a:t>#1</a:t>
            </a:r>
            <a:endParaRPr lang="zh-CN" altLang="en-US" sz="1200">
              <a:latin typeface="Arial"/>
              <a:cs typeface="Arial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2711253" y="6365676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cs typeface="Arial"/>
              </a:rPr>
              <a:t>actin</a:t>
            </a:r>
            <a:endParaRPr lang="zh-CN" altLang="en-US" sz="1600">
              <a:latin typeface="Arial"/>
              <a:cs typeface="Arial"/>
            </a:endParaRPr>
          </a:p>
        </p:txBody>
      </p:sp>
      <p:sp>
        <p:nvSpPr>
          <p:cNvPr id="223" name="右箭头 222"/>
          <p:cNvSpPr/>
          <p:nvPr/>
        </p:nvSpPr>
        <p:spPr>
          <a:xfrm>
            <a:off x="709250" y="8135122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259138" y="803262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33" name="TextBox 87">
            <a:extLst>
              <a:ext uri="{FF2B5EF4-FFF2-40B4-BE49-F238E27FC236}">
                <a16:creationId xmlns:a16="http://schemas.microsoft.com/office/drawing/2014/main" id="{EE6EED06-2DEA-83C6-659F-3A426E356EB0}"/>
              </a:ext>
            </a:extLst>
          </p:cNvPr>
          <p:cNvSpPr txBox="1"/>
          <p:nvPr/>
        </p:nvSpPr>
        <p:spPr>
          <a:xfrm>
            <a:off x="4622494" y="167335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3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9760E015-724A-D499-431E-988B81523B64}"/>
              </a:ext>
            </a:extLst>
          </p:cNvPr>
          <p:cNvSpPr txBox="1"/>
          <p:nvPr/>
        </p:nvSpPr>
        <p:spPr>
          <a:xfrm>
            <a:off x="4906054" y="117481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3CECE850-5F80-69F7-0303-7899A18F58FD}"/>
              </a:ext>
            </a:extLst>
          </p:cNvPr>
          <p:cNvSpPr txBox="1"/>
          <p:nvPr/>
        </p:nvSpPr>
        <p:spPr>
          <a:xfrm>
            <a:off x="7060007" y="406992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D30ADC18-A8E6-1E9B-3AE6-E9B22A85933E}"/>
              </a:ext>
            </a:extLst>
          </p:cNvPr>
          <p:cNvSpPr txBox="1"/>
          <p:nvPr/>
        </p:nvSpPr>
        <p:spPr>
          <a:xfrm>
            <a:off x="470726" y="4085311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605C097E-0B58-EF87-B7B3-E40EE7094C16}"/>
              </a:ext>
            </a:extLst>
          </p:cNvPr>
          <p:cNvSpPr txBox="1"/>
          <p:nvPr/>
        </p:nvSpPr>
        <p:spPr>
          <a:xfrm>
            <a:off x="9726804" y="1106967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0C039466-98E2-8711-77C0-1B30C3A3F1BB}"/>
              </a:ext>
            </a:extLst>
          </p:cNvPr>
          <p:cNvSpPr txBox="1"/>
          <p:nvPr/>
        </p:nvSpPr>
        <p:spPr>
          <a:xfrm>
            <a:off x="470375" y="667716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2D8FCC17-6533-DE25-22C6-6A6708BC5D7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9041" y="576983"/>
            <a:ext cx="3937000" cy="29083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5234" y="327770"/>
            <a:ext cx="1162051" cy="522356"/>
          </a:xfrm>
          <a:prstGeom prst="rect">
            <a:avLst/>
          </a:prstGeom>
          <a:solidFill>
            <a:schemeClr val="bg1"/>
          </a:solidFill>
        </p:spPr>
        <p:txBody>
          <a:bodyPr wrap="none" lIns="151544" tIns="75772" rIns="151544" bIns="75772" rtlCol="0">
            <a:spAutoFit/>
          </a:bodyPr>
          <a:lstStyle/>
          <a:p>
            <a:r>
              <a:rPr lang="en-US" altLang="zh-CN" sz="2400" dirty="0">
                <a:latin typeface="Arial"/>
                <a:cs typeface="Arial"/>
              </a:rPr>
              <a:t>Fig.6b</a:t>
            </a:r>
            <a:endParaRPr lang="zh-CN" altLang="en-US" sz="2400" dirty="0">
              <a:latin typeface="Arial"/>
              <a:cs typeface="Arial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A577D607-7408-8882-D1B6-63D0CA4D0F21}"/>
              </a:ext>
            </a:extLst>
          </p:cNvPr>
          <p:cNvSpPr txBox="1"/>
          <p:nvPr/>
        </p:nvSpPr>
        <p:spPr>
          <a:xfrm>
            <a:off x="381135" y="11469265"/>
            <a:ext cx="69076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mages of the whole membranes from the western blot analyses presented in Fig.6b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9254706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964" y="111746"/>
            <a:ext cx="10743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/>
                <a:cs typeface="Arial"/>
              </a:rPr>
              <a:t>Fig.S3</a:t>
            </a:r>
            <a:endParaRPr lang="zh-CN" altLang="en-US" sz="240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78219" y="873523"/>
            <a:ext cx="1239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"/>
                <a:cs typeface="Arial"/>
              </a:rPr>
              <a:t>Experiment 1</a:t>
            </a:r>
            <a:endParaRPr lang="zh-CN" altLang="en-US" sz="1400">
              <a:latin typeface="Arial"/>
              <a:cs typeface="Arial"/>
            </a:endParaRPr>
          </a:p>
        </p:txBody>
      </p:sp>
      <p:pic>
        <p:nvPicPr>
          <p:cNvPr id="3075" name="Picture 3" descr="C:\Users\user\Desktop\WB original\2020.10 original image for figure\20210701_1339_5ppt c-myc0701 採用コピー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66" t="14484" r="16228" b="22250"/>
          <a:stretch/>
        </p:blipFill>
        <p:spPr bwMode="auto">
          <a:xfrm>
            <a:off x="3643906" y="881238"/>
            <a:ext cx="2880000" cy="1786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" name="直接连接符 7"/>
          <p:cNvCxnSpPr/>
          <p:nvPr/>
        </p:nvCxnSpPr>
        <p:spPr>
          <a:xfrm flipV="1">
            <a:off x="4393152" y="573222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5204072" y="566680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286064" y="5492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483150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01074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892734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91239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300090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501622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698184" y="54927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939670" y="418468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01627" y="371435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222179" y="371435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898379" y="549273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768136" y="111746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c-Myc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pic>
        <p:nvPicPr>
          <p:cNvPr id="3077" name="Picture 5" descr="C:\Users\user\Desktop\WB original\2020.10 original image for figure\20210623_1441_20 ppt p53 コピー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27" t="14146" r="15031" b="12996"/>
          <a:stretch/>
        </p:blipFill>
        <p:spPr bwMode="auto">
          <a:xfrm>
            <a:off x="7254598" y="795494"/>
            <a:ext cx="2880000" cy="20408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7" name="直接连接符 26"/>
          <p:cNvCxnSpPr/>
          <p:nvPr/>
        </p:nvCxnSpPr>
        <p:spPr>
          <a:xfrm flipV="1">
            <a:off x="8038819" y="501214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8849739" y="494672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7892058" y="4772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8128817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8324106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538401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736906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945757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147289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343851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7585337" y="346460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047294" y="299427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867846" y="299427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9544046" y="477265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413803" y="3973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p53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pic>
        <p:nvPicPr>
          <p:cNvPr id="3078" name="Picture 6" descr="C:\Users\user\Desktop\WB original\2020.10 original image for figure\20210701_1950_4 ppt actin0701 採用コピー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50" t="15154" r="12454" b="10875"/>
          <a:stretch/>
        </p:blipFill>
        <p:spPr bwMode="auto">
          <a:xfrm>
            <a:off x="10763396" y="664408"/>
            <a:ext cx="2880000" cy="21519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右箭头 42"/>
          <p:cNvSpPr/>
          <p:nvPr/>
        </p:nvSpPr>
        <p:spPr>
          <a:xfrm>
            <a:off x="3547042" y="1465473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096930" y="1362977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45" name="右箭头 44"/>
          <p:cNvSpPr/>
          <p:nvPr/>
        </p:nvSpPr>
        <p:spPr>
          <a:xfrm>
            <a:off x="7181232" y="1438378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731120" y="133588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47" name="右箭头 46"/>
          <p:cNvSpPr/>
          <p:nvPr/>
        </p:nvSpPr>
        <p:spPr>
          <a:xfrm>
            <a:off x="10615293" y="1501477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0165181" y="1398981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cxnSp>
        <p:nvCxnSpPr>
          <p:cNvPr id="49" name="直接连接符 48"/>
          <p:cNvCxnSpPr/>
          <p:nvPr/>
        </p:nvCxnSpPr>
        <p:spPr>
          <a:xfrm flipV="1">
            <a:off x="11530503" y="501214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>
            <a:off x="12341423" y="494672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11383742" y="4772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1620501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1852498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2047676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2228590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2453254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2669278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2885302" y="4772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11077021" y="346460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1538978" y="299427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2359530" y="299427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3107738" y="477265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1905487" y="39738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actin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59530" y="3332361"/>
            <a:ext cx="1239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"/>
                <a:cs typeface="Arial"/>
              </a:rPr>
              <a:t>Experiment 2</a:t>
            </a:r>
            <a:endParaRPr lang="zh-CN" altLang="en-US" sz="1400">
              <a:latin typeface="Arial"/>
              <a:cs typeface="Arial"/>
            </a:endParaRPr>
          </a:p>
        </p:txBody>
      </p:sp>
      <p:pic>
        <p:nvPicPr>
          <p:cNvPr id="3080" name="Picture 8" descr="C:\Users\user\Desktop\WB original\time course 2月\☆Exp2021_13 original image for figure\20210605_1200_6 ppt c-myc コピー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47" t="18180" r="16830" b="8048"/>
          <a:stretch/>
        </p:blipFill>
        <p:spPr bwMode="auto">
          <a:xfrm>
            <a:off x="3694582" y="3419342"/>
            <a:ext cx="2880000" cy="2165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9" name="直接连接符 68"/>
          <p:cNvCxnSpPr/>
          <p:nvPr/>
        </p:nvCxnSpPr>
        <p:spPr>
          <a:xfrm flipV="1">
            <a:off x="4457667" y="3325447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5284639" y="3318905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4294623" y="33014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532374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748398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964422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171806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5380657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612494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803826" y="33014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79" name="TextBox 78"/>
          <p:cNvSpPr txBox="1"/>
          <p:nvPr/>
        </p:nvSpPr>
        <p:spPr>
          <a:xfrm rot="16200000">
            <a:off x="3948229" y="3170693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466142" y="3123660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302746" y="3123660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6050954" y="330149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816779" y="2881190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c-Myc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84" name="右箭头 83"/>
          <p:cNvSpPr/>
          <p:nvPr/>
        </p:nvSpPr>
        <p:spPr>
          <a:xfrm>
            <a:off x="3547042" y="4136217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096930" y="4033721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pic>
        <p:nvPicPr>
          <p:cNvPr id="3081" name="Picture 9" descr="C:\Users\user\Desktop\WB original\time course 2月\☆Exp2021_13 original image for figure\20210604_1633_13 ppt p53 コピー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43" t="9387" r="20249" b="15425"/>
          <a:stretch/>
        </p:blipFill>
        <p:spPr bwMode="auto">
          <a:xfrm>
            <a:off x="7254598" y="3352106"/>
            <a:ext cx="2880000" cy="21289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7" name="直接连接符 86"/>
          <p:cNvCxnSpPr/>
          <p:nvPr/>
        </p:nvCxnSpPr>
        <p:spPr>
          <a:xfrm flipV="1">
            <a:off x="8060522" y="3298568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>
            <a:off x="8887494" y="3292026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7926368" y="32746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8135229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351253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8567277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8774661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8983512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9188202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404226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7585337" y="3143814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8068997" y="3096781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8905601" y="3096781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9653809" y="327461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8419634" y="285431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p53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pic>
        <p:nvPicPr>
          <p:cNvPr id="3082" name="Picture 10" descr="C:\Users\user\Desktop\WB original\time course 2月\☆Exp2021_13 original image for figure\20210605_1856_27 ppt actin コピー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4" t="9947" r="22732" b="18079"/>
          <a:stretch/>
        </p:blipFill>
        <p:spPr bwMode="auto">
          <a:xfrm>
            <a:off x="10772698" y="3352106"/>
            <a:ext cx="2880000" cy="2148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" name="右箭头 102"/>
          <p:cNvSpPr/>
          <p:nvPr/>
        </p:nvSpPr>
        <p:spPr>
          <a:xfrm>
            <a:off x="7195774" y="4124738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6745662" y="402224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cxnSp>
        <p:nvCxnSpPr>
          <p:cNvPr id="105" name="直接连接符 104"/>
          <p:cNvCxnSpPr/>
          <p:nvPr/>
        </p:nvCxnSpPr>
        <p:spPr>
          <a:xfrm flipV="1">
            <a:off x="11541164" y="3298568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/>
          <p:cNvCxnSpPr/>
          <p:nvPr/>
        </p:nvCxnSpPr>
        <p:spPr>
          <a:xfrm>
            <a:off x="12405260" y="3292026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11359450" y="32746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1584581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1827891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12045220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12261244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2477268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2693292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2909316" y="32746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5" name="TextBox 114"/>
          <p:cNvSpPr txBox="1"/>
          <p:nvPr/>
        </p:nvSpPr>
        <p:spPr>
          <a:xfrm rot="16200000">
            <a:off x="11003778" y="3143814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1549639" y="3096781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2423367" y="3096781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3072250" y="327461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1969025" y="2811831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actin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20" name="右箭头 119"/>
          <p:cNvSpPr/>
          <p:nvPr/>
        </p:nvSpPr>
        <p:spPr>
          <a:xfrm>
            <a:off x="10586953" y="4187123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0136841" y="4084627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25012" y="5996657"/>
            <a:ext cx="1239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"/>
                <a:cs typeface="Arial"/>
              </a:rPr>
              <a:t>Experiment 3</a:t>
            </a:r>
            <a:endParaRPr lang="zh-CN" altLang="en-US" sz="1400">
              <a:latin typeface="Arial"/>
              <a:cs typeface="Arial"/>
            </a:endParaRPr>
          </a:p>
        </p:txBody>
      </p:sp>
      <p:pic>
        <p:nvPicPr>
          <p:cNvPr id="3085" name="Picture 1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94" t="22947" r="16781" b="25131"/>
          <a:stretch/>
        </p:blipFill>
        <p:spPr bwMode="auto">
          <a:xfrm>
            <a:off x="3620407" y="6275636"/>
            <a:ext cx="3004413" cy="22831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26" name="直接连接符 125"/>
          <p:cNvCxnSpPr/>
          <p:nvPr/>
        </p:nvCxnSpPr>
        <p:spPr>
          <a:xfrm flipV="1">
            <a:off x="4385659" y="6172627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接连接符 126"/>
          <p:cNvCxnSpPr/>
          <p:nvPr/>
        </p:nvCxnSpPr>
        <p:spPr>
          <a:xfrm>
            <a:off x="5212631" y="6166085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4222615" y="61486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4435674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4651698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867722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083746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299770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5515794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5731818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3876221" y="6017873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394134" y="5970840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5230738" y="5970840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978946" y="614867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4744771" y="5728370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c-Myc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pic>
        <p:nvPicPr>
          <p:cNvPr id="3087" name="Picture 15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94" t="25399" r="18968" b="23645"/>
          <a:stretch/>
        </p:blipFill>
        <p:spPr bwMode="auto">
          <a:xfrm>
            <a:off x="7254598" y="6402594"/>
            <a:ext cx="2880000" cy="22189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43" name="直接连接符 142"/>
          <p:cNvCxnSpPr/>
          <p:nvPr/>
        </p:nvCxnSpPr>
        <p:spPr>
          <a:xfrm flipV="1">
            <a:off x="7993232" y="6172627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接连接符 143"/>
          <p:cNvCxnSpPr/>
          <p:nvPr/>
        </p:nvCxnSpPr>
        <p:spPr>
          <a:xfrm>
            <a:off x="8929050" y="6166085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7829097" y="61486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8060766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8324106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8540130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8756154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8972178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9188202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9404226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7482703" y="6017873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8000616" y="5970840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8947157" y="5970840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9585428" y="614867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8351253" y="572837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p53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pic>
        <p:nvPicPr>
          <p:cNvPr id="3089" name="Picture 17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08" t="26135" r="15224" b="23441"/>
          <a:stretch/>
        </p:blipFill>
        <p:spPr bwMode="auto">
          <a:xfrm>
            <a:off x="10801781" y="6402594"/>
            <a:ext cx="2880000" cy="22352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61" name="直接连接符 160"/>
          <p:cNvCxnSpPr/>
          <p:nvPr/>
        </p:nvCxnSpPr>
        <p:spPr>
          <a:xfrm flipV="1">
            <a:off x="11548640" y="6172627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接连接符 161"/>
          <p:cNvCxnSpPr/>
          <p:nvPr/>
        </p:nvCxnSpPr>
        <p:spPr>
          <a:xfrm>
            <a:off x="12484458" y="6166085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/>
          <p:cNvSpPr txBox="1"/>
          <p:nvPr/>
        </p:nvSpPr>
        <p:spPr>
          <a:xfrm>
            <a:off x="11384505" y="61486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1616174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11852498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2068522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12311562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12527586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2743610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12959634" y="614867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1" name="TextBox 170"/>
          <p:cNvSpPr txBox="1"/>
          <p:nvPr/>
        </p:nvSpPr>
        <p:spPr>
          <a:xfrm rot="16200000">
            <a:off x="11038111" y="6017873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11556024" y="5970840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12502565" y="5970840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13140836" y="614867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11906661" y="5728370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actin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76" name="右箭头 175"/>
          <p:cNvSpPr/>
          <p:nvPr/>
        </p:nvSpPr>
        <p:spPr>
          <a:xfrm>
            <a:off x="3517510" y="7030030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3067398" y="692753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78" name="右箭头 177"/>
          <p:cNvSpPr/>
          <p:nvPr/>
        </p:nvSpPr>
        <p:spPr>
          <a:xfrm>
            <a:off x="7100070" y="6994026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6649958" y="689153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80" name="右箭头 179"/>
          <p:cNvSpPr/>
          <p:nvPr/>
        </p:nvSpPr>
        <p:spPr>
          <a:xfrm>
            <a:off x="10647841" y="7230380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10197729" y="712788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336418" y="8588945"/>
            <a:ext cx="1239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"/>
                <a:cs typeface="Arial"/>
              </a:rPr>
              <a:t>Experiment 4</a:t>
            </a:r>
            <a:endParaRPr lang="zh-CN" altLang="en-US" sz="1400">
              <a:latin typeface="Arial"/>
              <a:cs typeface="Arial"/>
            </a:endParaRPr>
          </a:p>
        </p:txBody>
      </p:sp>
      <p:pic>
        <p:nvPicPr>
          <p:cNvPr id="3091" name="Picture 19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8" t="25601" r="21641" b="23926"/>
          <a:stretch/>
        </p:blipFill>
        <p:spPr bwMode="auto">
          <a:xfrm>
            <a:off x="3590875" y="9256762"/>
            <a:ext cx="2880000" cy="21904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85" name="直接连接符 184"/>
          <p:cNvCxnSpPr/>
          <p:nvPr/>
        </p:nvCxnSpPr>
        <p:spPr>
          <a:xfrm flipV="1">
            <a:off x="4354314" y="9059208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直接连接符 185"/>
          <p:cNvCxnSpPr/>
          <p:nvPr/>
        </p:nvCxnSpPr>
        <p:spPr>
          <a:xfrm>
            <a:off x="5227762" y="9052666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/>
          <p:cNvSpPr txBox="1"/>
          <p:nvPr/>
        </p:nvSpPr>
        <p:spPr>
          <a:xfrm>
            <a:off x="4191270" y="90352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4404329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4620353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4836377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5052401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5299770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5515794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5731818" y="90352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5" name="TextBox 194"/>
          <p:cNvSpPr txBox="1"/>
          <p:nvPr/>
        </p:nvSpPr>
        <p:spPr>
          <a:xfrm rot="16200000">
            <a:off x="3844876" y="8904454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4362789" y="8857421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5245869" y="8857421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5947601" y="903525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4713426" y="8614951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c-Myc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00" name="右箭头 199"/>
          <p:cNvSpPr/>
          <p:nvPr/>
        </p:nvSpPr>
        <p:spPr>
          <a:xfrm>
            <a:off x="3444144" y="9964199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2994032" y="9861703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pic>
        <p:nvPicPr>
          <p:cNvPr id="3093" name="Picture 21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33" t="20074" r="19512" b="28188"/>
          <a:stretch/>
        </p:blipFill>
        <p:spPr bwMode="auto">
          <a:xfrm>
            <a:off x="7127276" y="8985099"/>
            <a:ext cx="3007321" cy="23159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19" name="直接连接符 218"/>
          <p:cNvCxnSpPr/>
          <p:nvPr/>
        </p:nvCxnSpPr>
        <p:spPr>
          <a:xfrm flipV="1">
            <a:off x="7914051" y="9124955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接连接符 219"/>
          <p:cNvCxnSpPr/>
          <p:nvPr/>
        </p:nvCxnSpPr>
        <p:spPr>
          <a:xfrm>
            <a:off x="8857042" y="9118413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TextBox 220"/>
          <p:cNvSpPr txBox="1"/>
          <p:nvPr/>
        </p:nvSpPr>
        <p:spPr>
          <a:xfrm>
            <a:off x="7782352" y="91010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8036074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8252098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8468122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8708838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8924862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9147289" y="9093311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9404226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29" name="TextBox 228"/>
          <p:cNvSpPr txBox="1"/>
          <p:nvPr/>
        </p:nvSpPr>
        <p:spPr>
          <a:xfrm rot="16200000">
            <a:off x="7441321" y="8970201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7922526" y="8923168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8875149" y="8923168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9651354" y="9101006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8264489" y="868069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p53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pic>
        <p:nvPicPr>
          <p:cNvPr id="3095" name="Picture 23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36" t="18877" r="20469" b="24130"/>
          <a:stretch/>
        </p:blipFill>
        <p:spPr bwMode="auto">
          <a:xfrm>
            <a:off x="10775399" y="8962273"/>
            <a:ext cx="2880000" cy="2439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51" name="直接连接符 250"/>
          <p:cNvCxnSpPr/>
          <p:nvPr/>
        </p:nvCxnSpPr>
        <p:spPr>
          <a:xfrm flipV="1">
            <a:off x="11533660" y="9124955"/>
            <a:ext cx="690914" cy="65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直接连接符 251"/>
          <p:cNvCxnSpPr/>
          <p:nvPr/>
        </p:nvCxnSpPr>
        <p:spPr>
          <a:xfrm>
            <a:off x="12385434" y="9118413"/>
            <a:ext cx="69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TextBox 252"/>
          <p:cNvSpPr txBox="1"/>
          <p:nvPr/>
        </p:nvSpPr>
        <p:spPr>
          <a:xfrm>
            <a:off x="11369525" y="91010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11601194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11805182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12021206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12237230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12428562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2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12644586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36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12860610" y="910100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48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61" name="TextBox 260"/>
          <p:cNvSpPr txBox="1"/>
          <p:nvPr/>
        </p:nvSpPr>
        <p:spPr>
          <a:xfrm rot="16200000">
            <a:off x="11023131" y="8970201"/>
            <a:ext cx="58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>
                <a:solidFill>
                  <a:prstClr val="black"/>
                </a:solidFill>
                <a:latin typeface="Arial"/>
                <a:ea typeface="Arial Unicode MS" panose="020B0604020202020204" pitchFamily="34" charset="-122"/>
                <a:cs typeface="Arial"/>
              </a:rPr>
              <a:t>no TF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11541044" y="8923168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cont miR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12403541" y="8923168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Arial Unicode MS" panose="020B0604020202020204" pitchFamily="34" charset="-122"/>
                <a:cs typeface="Arial"/>
              </a:rPr>
              <a:t>miR-874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13125856" y="9101006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/>
                <a:cs typeface="Arial"/>
              </a:rPr>
              <a:t>(h)</a:t>
            </a:r>
            <a:endParaRPr lang="zh-CN" altLang="en-US" sz="1000">
              <a:latin typeface="Arial"/>
              <a:cs typeface="Arial"/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11891681" y="8680698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"/>
                <a:ea typeface="Arial Unicode MS" panose="020B0604020202020204" pitchFamily="34" charset="-122"/>
                <a:cs typeface="Arial"/>
              </a:rPr>
              <a:t>actin</a:t>
            </a:r>
            <a:endParaRPr lang="zh-CN" altLang="en-US" sz="1600">
              <a:latin typeface="Arial"/>
              <a:ea typeface="Arial Unicode MS" panose="020B0604020202020204" pitchFamily="34" charset="-122"/>
              <a:cs typeface="Arial"/>
            </a:endParaRPr>
          </a:p>
        </p:txBody>
      </p:sp>
      <p:sp>
        <p:nvSpPr>
          <p:cNvPr id="266" name="右箭头 265"/>
          <p:cNvSpPr/>
          <p:nvPr/>
        </p:nvSpPr>
        <p:spPr>
          <a:xfrm>
            <a:off x="10615293" y="10066695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267" name="TextBox 266"/>
          <p:cNvSpPr txBox="1"/>
          <p:nvPr/>
        </p:nvSpPr>
        <p:spPr>
          <a:xfrm>
            <a:off x="10165181" y="9964199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5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268" name="右箭头 267"/>
          <p:cNvSpPr/>
          <p:nvPr/>
        </p:nvSpPr>
        <p:spPr>
          <a:xfrm>
            <a:off x="6984252" y="9724814"/>
            <a:ext cx="146731" cy="72008"/>
          </a:xfrm>
          <a:prstGeom prst="rightArrow">
            <a:avLst/>
          </a:prstGeom>
          <a:ln w="31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/>
              <a:cs typeface="Arial"/>
            </a:endParaRPr>
          </a:p>
        </p:txBody>
      </p:sp>
      <p:sp>
        <p:nvSpPr>
          <p:cNvPr id="269" name="TextBox 268"/>
          <p:cNvSpPr txBox="1"/>
          <p:nvPr/>
        </p:nvSpPr>
        <p:spPr>
          <a:xfrm>
            <a:off x="6534140" y="9622318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/>
                <a:cs typeface="Arial"/>
              </a:rPr>
              <a:t>60 </a:t>
            </a:r>
            <a:r>
              <a:rPr lang="en-US" altLang="zh-CN" sz="1200" dirty="0" err="1">
                <a:latin typeface="Arial"/>
                <a:cs typeface="Arial"/>
              </a:rPr>
              <a:t>kd</a:t>
            </a:r>
            <a:endParaRPr lang="zh-CN" altLang="en-US" sz="1200" dirty="0">
              <a:latin typeface="Arial"/>
              <a:cs typeface="Arial"/>
            </a:endParaRPr>
          </a:p>
        </p:txBody>
      </p:sp>
      <p:sp>
        <p:nvSpPr>
          <p:cNvPr id="234" name="文本框 233">
            <a:extLst>
              <a:ext uri="{FF2B5EF4-FFF2-40B4-BE49-F238E27FC236}">
                <a16:creationId xmlns:a16="http://schemas.microsoft.com/office/drawing/2014/main" id="{C616C447-E41F-A871-9C6B-E897C74CDF8C}"/>
              </a:ext>
            </a:extLst>
          </p:cNvPr>
          <p:cNvSpPr txBox="1"/>
          <p:nvPr/>
        </p:nvSpPr>
        <p:spPr>
          <a:xfrm>
            <a:off x="3403761" y="58689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35" name="文本框 234">
            <a:extLst>
              <a:ext uri="{FF2B5EF4-FFF2-40B4-BE49-F238E27FC236}">
                <a16:creationId xmlns:a16="http://schemas.microsoft.com/office/drawing/2014/main" id="{A372D234-06C8-B0BD-9C36-AE4DE01DAF33}"/>
              </a:ext>
            </a:extLst>
          </p:cNvPr>
          <p:cNvSpPr txBox="1"/>
          <p:nvPr/>
        </p:nvSpPr>
        <p:spPr>
          <a:xfrm>
            <a:off x="6983388" y="553134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36" name="文本框 235">
            <a:extLst>
              <a:ext uri="{FF2B5EF4-FFF2-40B4-BE49-F238E27FC236}">
                <a16:creationId xmlns:a16="http://schemas.microsoft.com/office/drawing/2014/main" id="{BFD5ECE3-FE55-CB25-D942-1C5F0A95027A}"/>
              </a:ext>
            </a:extLst>
          </p:cNvPr>
          <p:cNvSpPr txBox="1"/>
          <p:nvPr/>
        </p:nvSpPr>
        <p:spPr>
          <a:xfrm>
            <a:off x="10591723" y="418913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37" name="文本框 236">
            <a:extLst>
              <a:ext uri="{FF2B5EF4-FFF2-40B4-BE49-F238E27FC236}">
                <a16:creationId xmlns:a16="http://schemas.microsoft.com/office/drawing/2014/main" id="{C9970054-7345-2FC2-8E8F-7C3D6422046A}"/>
              </a:ext>
            </a:extLst>
          </p:cNvPr>
          <p:cNvSpPr txBox="1"/>
          <p:nvPr/>
        </p:nvSpPr>
        <p:spPr>
          <a:xfrm>
            <a:off x="7047196" y="3109419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38" name="文本框 237">
            <a:extLst>
              <a:ext uri="{FF2B5EF4-FFF2-40B4-BE49-F238E27FC236}">
                <a16:creationId xmlns:a16="http://schemas.microsoft.com/office/drawing/2014/main" id="{4986C29A-7FD7-69C3-3E7D-F59D8649DBF7}"/>
              </a:ext>
            </a:extLst>
          </p:cNvPr>
          <p:cNvSpPr txBox="1"/>
          <p:nvPr/>
        </p:nvSpPr>
        <p:spPr>
          <a:xfrm>
            <a:off x="3461315" y="3171570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39" name="文本框 238">
            <a:extLst>
              <a:ext uri="{FF2B5EF4-FFF2-40B4-BE49-F238E27FC236}">
                <a16:creationId xmlns:a16="http://schemas.microsoft.com/office/drawing/2014/main" id="{8BB7F7D9-0534-4801-DB43-8B6A08C2FE1F}"/>
              </a:ext>
            </a:extLst>
          </p:cNvPr>
          <p:cNvSpPr txBox="1"/>
          <p:nvPr/>
        </p:nvSpPr>
        <p:spPr>
          <a:xfrm>
            <a:off x="3302378" y="6094817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40" name="文本框 239">
            <a:extLst>
              <a:ext uri="{FF2B5EF4-FFF2-40B4-BE49-F238E27FC236}">
                <a16:creationId xmlns:a16="http://schemas.microsoft.com/office/drawing/2014/main" id="{DB7AE4AD-3C5F-3A61-C179-62D7DF37F166}"/>
              </a:ext>
            </a:extLst>
          </p:cNvPr>
          <p:cNvSpPr txBox="1"/>
          <p:nvPr/>
        </p:nvSpPr>
        <p:spPr>
          <a:xfrm>
            <a:off x="10324886" y="3075015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42" name="文本框 241">
            <a:extLst>
              <a:ext uri="{FF2B5EF4-FFF2-40B4-BE49-F238E27FC236}">
                <a16:creationId xmlns:a16="http://schemas.microsoft.com/office/drawing/2014/main" id="{C6254740-87C6-9192-850F-C53A4C9CEC28}"/>
              </a:ext>
            </a:extLst>
          </p:cNvPr>
          <p:cNvSpPr txBox="1"/>
          <p:nvPr/>
        </p:nvSpPr>
        <p:spPr>
          <a:xfrm>
            <a:off x="10341690" y="9035259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43" name="文本框 242">
            <a:extLst>
              <a:ext uri="{FF2B5EF4-FFF2-40B4-BE49-F238E27FC236}">
                <a16:creationId xmlns:a16="http://schemas.microsoft.com/office/drawing/2014/main" id="{BEFEF772-7233-4C83-E486-BC9C281343B3}"/>
              </a:ext>
            </a:extLst>
          </p:cNvPr>
          <p:cNvSpPr txBox="1"/>
          <p:nvPr/>
        </p:nvSpPr>
        <p:spPr>
          <a:xfrm>
            <a:off x="6852366" y="8834332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44" name="文本框 243">
            <a:extLst>
              <a:ext uri="{FF2B5EF4-FFF2-40B4-BE49-F238E27FC236}">
                <a16:creationId xmlns:a16="http://schemas.microsoft.com/office/drawing/2014/main" id="{C02D12B5-604D-3849-E60E-6BCA6049C1B0}"/>
              </a:ext>
            </a:extLst>
          </p:cNvPr>
          <p:cNvSpPr txBox="1"/>
          <p:nvPr/>
        </p:nvSpPr>
        <p:spPr>
          <a:xfrm>
            <a:off x="3238919" y="9135286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45" name="文本框 244">
            <a:extLst>
              <a:ext uri="{FF2B5EF4-FFF2-40B4-BE49-F238E27FC236}">
                <a16:creationId xmlns:a16="http://schemas.microsoft.com/office/drawing/2014/main" id="{41C4952E-E031-1438-8316-3DDC3C0247FE}"/>
              </a:ext>
            </a:extLst>
          </p:cNvPr>
          <p:cNvSpPr txBox="1"/>
          <p:nvPr/>
        </p:nvSpPr>
        <p:spPr>
          <a:xfrm>
            <a:off x="10502986" y="6196233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id="{809E1F0A-0A36-35F9-F52E-BEC8267194A4}"/>
              </a:ext>
            </a:extLst>
          </p:cNvPr>
          <p:cNvSpPr txBox="1"/>
          <p:nvPr/>
        </p:nvSpPr>
        <p:spPr>
          <a:xfrm>
            <a:off x="6985017" y="6166085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.5%</a:t>
            </a:r>
            <a:endParaRPr lang="zh-CN" altLang="en-US" sz="1400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CA10A429-A8E9-3026-9707-3AB39B8BB75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0097" y="1181300"/>
            <a:ext cx="2889716" cy="135052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DAB2668-1B00-E8BA-CBB9-CD9FDC5003F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8829" y="3697044"/>
            <a:ext cx="2890701" cy="131124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FBC341D-2CF9-5108-8AFE-2C0DDEC669F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90101" y="6394899"/>
            <a:ext cx="2888369" cy="1745269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7FBD556-F57E-5452-EE3F-962DB77572E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78219" y="9063384"/>
            <a:ext cx="2821185" cy="188079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F0CF6DB-91EE-3D30-A001-1063415DD3B1}"/>
              </a:ext>
            </a:extLst>
          </p:cNvPr>
          <p:cNvSpPr txBox="1"/>
          <p:nvPr/>
        </p:nvSpPr>
        <p:spPr>
          <a:xfrm>
            <a:off x="381135" y="11469265"/>
            <a:ext cx="8040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mages of the whole membranes from the western blot analyses presented in Supplementary Fig.3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565909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66E9E4B4E872DC419F5CB27CF98426D6" ma:contentTypeVersion="6" ma:contentTypeDescription="新しいドキュメントを作成します。" ma:contentTypeScope="" ma:versionID="a22ac42b01670f39419ff86ce1bba0c6">
  <xsd:schema xmlns:xsd="http://www.w3.org/2001/XMLSchema" xmlns:xs="http://www.w3.org/2001/XMLSchema" xmlns:p="http://schemas.microsoft.com/office/2006/metadata/properties" xmlns:ns2="350602a1-cffa-4ec6-923b-538e8b71deb7" targetNamespace="http://schemas.microsoft.com/office/2006/metadata/properties" ma:root="true" ma:fieldsID="b9fd47c39f31dc49ef20ea567551fb05" ns2:_="">
    <xsd:import namespace="350602a1-cffa-4ec6-923b-538e8b71deb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0602a1-cffa-4ec6-923b-538e8b71deb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69A0191-55F1-4E95-8EF1-667A3CF9576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50602a1-cffa-4ec6-923b-538e8b71deb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A78C9E4-1020-4501-9004-15570FA5CA9A}">
  <ds:schemaRefs>
    <ds:schemaRef ds:uri="http://purl.org/dc/elements/1.1/"/>
    <ds:schemaRef ds:uri="http://schemas.openxmlformats.org/package/2006/metadata/core-properties"/>
    <ds:schemaRef ds:uri="http://purl.org/dc/dcmitype/"/>
    <ds:schemaRef ds:uri="http://schemas.microsoft.com/office/2006/metadata/properties"/>
    <ds:schemaRef ds:uri="http://www.w3.org/XML/1998/namespace"/>
    <ds:schemaRef ds:uri="350602a1-cffa-4ec6-923b-538e8b71deb7"/>
    <ds:schemaRef ds:uri="http://schemas.microsoft.com/office/2006/documentManagement/types"/>
    <ds:schemaRef ds:uri="http://schemas.microsoft.com/office/infopath/2007/PartnerControl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7EECA37C-086B-4AA8-956E-5CC656DF2FD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58</TotalTime>
  <Words>826</Words>
  <Application>Microsoft Office PowerPoint</Application>
  <PresentationFormat>ユーザー設定</PresentationFormat>
  <Paragraphs>471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主题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橋本 直子</cp:lastModifiedBy>
  <cp:revision>29</cp:revision>
  <dcterms:created xsi:type="dcterms:W3CDTF">2022-05-08T14:21:52Z</dcterms:created>
  <dcterms:modified xsi:type="dcterms:W3CDTF">2022-09-15T06:34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6E9E4B4E872DC419F5CB27CF98426D6</vt:lpwstr>
  </property>
</Properties>
</file>